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9144000" cy="82296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82" d="100"/>
          <a:sy n="182" d="100"/>
        </p:scale>
        <p:origin x="438" y="780"/>
      </p:cViewPr>
      <p:guideLst>
        <p:guide orient="horz" pos="2592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Book1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0827319349309001"/>
          <c:y val="0.19404814064051401"/>
          <c:w val="0.68618447376228597"/>
          <c:h val="0.56867804677276002"/>
        </c:manualLayout>
      </c:layout>
      <c:scatterChart>
        <c:scatterStyle val="lineMarker"/>
        <c:varyColors val="0"/>
        <c:ser>
          <c:idx val="0"/>
          <c:order val="0"/>
          <c:tx>
            <c:v>Mus81–Mms4</c:v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D$52:$G$5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5501173689518101</c:v>
                  </c:pt>
                  <c:pt idx="2">
                    <c:v>0.50767443635989296</c:v>
                  </c:pt>
                  <c:pt idx="3">
                    <c:v>0.42500980380849201</c:v>
                  </c:pt>
                </c:numCache>
              </c:numRef>
            </c:plus>
            <c:minus>
              <c:numRef>
                <c:f>Sheet1!$D$52:$G$5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5501173689518101</c:v>
                  </c:pt>
                  <c:pt idx="2">
                    <c:v>0.50767443635989296</c:v>
                  </c:pt>
                  <c:pt idx="3">
                    <c:v>0.42500980380849201</c:v>
                  </c:pt>
                </c:numCache>
              </c:numRef>
            </c:minus>
          </c:errBars>
          <c:xVal>
            <c:numRef>
              <c:f>Sheet1!$D$51:$G$51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</c:numCache>
            </c:numRef>
          </c:xVal>
          <c:yVal>
            <c:numRef>
              <c:f>Sheet1!$D$49:$G$49</c:f>
              <c:numCache>
                <c:formatCode>General</c:formatCode>
                <c:ptCount val="4"/>
                <c:pt idx="0">
                  <c:v>0</c:v>
                </c:pt>
                <c:pt idx="1">
                  <c:v>0.68333333333333302</c:v>
                </c:pt>
                <c:pt idx="2">
                  <c:v>2.4333333333333331</c:v>
                </c:pt>
                <c:pt idx="3">
                  <c:v>4.0766666666666671</c:v>
                </c:pt>
              </c:numCache>
            </c:numRef>
          </c:yVal>
          <c:smooth val="0"/>
        </c:ser>
        <c:ser>
          <c:idx val="2"/>
          <c:order val="1"/>
          <c:tx>
            <c:v>Mus81Δ120N–Mms4</c:v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52:$K$5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3459184413217099</c:v>
                  </c:pt>
                  <c:pt idx="2">
                    <c:v>0.6</c:v>
                  </c:pt>
                  <c:pt idx="3">
                    <c:v>0.7</c:v>
                  </c:pt>
                </c:numCache>
              </c:numRef>
            </c:plus>
            <c:minus>
              <c:numRef>
                <c:f>Sheet1!$H$52:$K$5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3459184413217099</c:v>
                  </c:pt>
                  <c:pt idx="2">
                    <c:v>0.6</c:v>
                  </c:pt>
                  <c:pt idx="3">
                    <c:v>0.7</c:v>
                  </c:pt>
                </c:numCache>
              </c:numRef>
            </c:minus>
          </c:errBars>
          <c:xVal>
            <c:numRef>
              <c:f>Sheet1!$D$51:$G$51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</c:numCache>
            </c:numRef>
          </c:xVal>
          <c:yVal>
            <c:numRef>
              <c:f>Sheet1!$H$49:$K$49</c:f>
              <c:numCache>
                <c:formatCode>General</c:formatCode>
                <c:ptCount val="4"/>
                <c:pt idx="0">
                  <c:v>0</c:v>
                </c:pt>
                <c:pt idx="1">
                  <c:v>1.093333333333333</c:v>
                </c:pt>
                <c:pt idx="2">
                  <c:v>2.9933333333333341</c:v>
                </c:pt>
                <c:pt idx="3">
                  <c:v>4.196666666666666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2361088"/>
        <c:axId val="92363008"/>
      </c:scatterChart>
      <c:valAx>
        <c:axId val="92361088"/>
        <c:scaling>
          <c:orientation val="minMax"/>
          <c:max val="5"/>
        </c:scaling>
        <c:delete val="0"/>
        <c:axPos val="b"/>
        <c:title>
          <c:tx>
            <c:rich>
              <a:bodyPr/>
              <a:lstStyle/>
              <a:p>
                <a:pPr>
                  <a:defRPr sz="11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100" b="0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mount </a:t>
                </a:r>
                <a:r>
                  <a:rPr lang="en-US" sz="1100" b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l-GR" sz="1100" b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sz="1100" b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)</a:t>
                </a:r>
                <a:endParaRPr lang="en-US" sz="11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40328462824931199"/>
              <c:y val="0.8803208562674009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92363008"/>
        <c:crosses val="autoZero"/>
        <c:crossBetween val="midCat"/>
        <c:majorUnit val="1"/>
      </c:valAx>
      <c:valAx>
        <c:axId val="92363008"/>
        <c:scaling>
          <c:orientation val="minMax"/>
          <c:max val="6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100" b="0"/>
                </a:pPr>
                <a:r>
                  <a:rPr lang="en-US" sz="1100" b="0"/>
                  <a:t>Substrate cleaved (fmol)</a:t>
                </a:r>
              </a:p>
            </c:rich>
          </c:tx>
          <c:layout>
            <c:manualLayout>
              <c:xMode val="edge"/>
              <c:yMode val="edge"/>
              <c:x val="0"/>
              <c:y val="0.18097115226493601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92361088"/>
        <c:crosses val="autoZero"/>
        <c:crossBetween val="midCat"/>
        <c:majorUnit val="1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6713492312195"/>
          <c:y val="0.20388490868968701"/>
          <c:w val="0.38097805537498902"/>
          <c:h val="0.54577852743868105"/>
        </c:manualLayout>
      </c:layout>
      <c:scatterChart>
        <c:scatterStyle val="lineMarker"/>
        <c:varyColors val="0"/>
        <c:ser>
          <c:idx val="2"/>
          <c:order val="0"/>
          <c:tx>
            <c:v>Mus81–Mms4Δ40N + Slx1–Slx4</c:v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K$62:$P$62</c:f>
                <c:numCache>
                  <c:formatCode>General</c:formatCode>
                  <c:ptCount val="6"/>
                </c:numCache>
              </c:numRef>
            </c:plus>
            <c:minus>
              <c:numRef>
                <c:f>Sheet2!$K$62:$P$62</c:f>
                <c:numCache>
                  <c:formatCode>General</c:formatCode>
                  <c:ptCount val="6"/>
                </c:numCache>
              </c:numRef>
            </c:minus>
          </c:errBars>
          <c:xVal>
            <c:numRef>
              <c:f>Sheet1!$D$58:$G$58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</c:numCache>
            </c:numRef>
          </c:xVal>
          <c:yVal>
            <c:numRef>
              <c:f>Sheet1!$H$57:$K$57</c:f>
              <c:numCache>
                <c:formatCode>0.0</c:formatCode>
                <c:ptCount val="4"/>
                <c:pt idx="0">
                  <c:v>3.0781859224297101E-3</c:v>
                </c:pt>
                <c:pt idx="1">
                  <c:v>2.1</c:v>
                </c:pt>
                <c:pt idx="2">
                  <c:v>4.2</c:v>
                </c:pt>
                <c:pt idx="3">
                  <c:v>5.5</c:v>
                </c:pt>
              </c:numCache>
            </c:numRef>
          </c:yVal>
          <c:smooth val="0"/>
        </c:ser>
        <c:ser>
          <c:idx val="3"/>
          <c:order val="1"/>
          <c:tx>
            <c:v>Mus81Δ21-26–Mms4Δ40N + Slx1–Slx4</c:v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W$62:$AB$62</c:f>
                <c:numCache>
                  <c:formatCode>General</c:formatCode>
                  <c:ptCount val="6"/>
                </c:numCache>
              </c:numRef>
            </c:plus>
            <c:minus>
              <c:numRef>
                <c:f>Sheet2!$W$62:$AB$62</c:f>
                <c:numCache>
                  <c:formatCode>General</c:formatCode>
                  <c:ptCount val="6"/>
                </c:numCache>
              </c:numRef>
            </c:minus>
          </c:errBars>
          <c:xVal>
            <c:numRef>
              <c:f>Sheet1!$D$58:$G$58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</c:numCache>
            </c:numRef>
          </c:xVal>
          <c:yVal>
            <c:numRef>
              <c:f>Sheet1!$P$57:$S$57</c:f>
              <c:numCache>
                <c:formatCode>0.0</c:formatCode>
                <c:ptCount val="4"/>
                <c:pt idx="0">
                  <c:v>5.3078556263269601E-3</c:v>
                </c:pt>
                <c:pt idx="1">
                  <c:v>1.9</c:v>
                </c:pt>
                <c:pt idx="2">
                  <c:v>3.7</c:v>
                </c:pt>
                <c:pt idx="3">
                  <c:v>4.6302497558253108</c:v>
                </c:pt>
              </c:numCache>
            </c:numRef>
          </c:yVal>
          <c:smooth val="0"/>
        </c:ser>
        <c:ser>
          <c:idx val="0"/>
          <c:order val="2"/>
          <c:tx>
            <c:v>Mus81–Mms4Δ40N</c:v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E$62:$J$62</c:f>
                <c:numCache>
                  <c:formatCode>General</c:formatCode>
                  <c:ptCount val="6"/>
                </c:numCache>
              </c:numRef>
            </c:plus>
            <c:minus>
              <c:numRef>
                <c:f>Sheet2!$E$62:$J$62</c:f>
                <c:numCache>
                  <c:formatCode>General</c:formatCode>
                  <c:ptCount val="6"/>
                </c:numCache>
              </c:numRef>
            </c:minus>
          </c:errBars>
          <c:xVal>
            <c:numRef>
              <c:f>Sheet1!$D$58:$G$58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</c:numCache>
            </c:numRef>
          </c:xVal>
          <c:yVal>
            <c:numRef>
              <c:f>Sheet1!$D$57:$G$57</c:f>
              <c:numCache>
                <c:formatCode>0.0</c:formatCode>
                <c:ptCount val="4"/>
                <c:pt idx="0">
                  <c:v>0</c:v>
                </c:pt>
                <c:pt idx="1">
                  <c:v>0.5</c:v>
                </c:pt>
                <c:pt idx="2">
                  <c:v>0.6</c:v>
                </c:pt>
                <c:pt idx="3">
                  <c:v>1</c:v>
                </c:pt>
              </c:numCache>
            </c:numRef>
          </c:yVal>
          <c:smooth val="0"/>
        </c:ser>
        <c:ser>
          <c:idx val="1"/>
          <c:order val="3"/>
          <c:tx>
            <c:v>Mus81Δ21-26–Mms4Δ40N</c:v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Q$62:$V$62</c:f>
                <c:numCache>
                  <c:formatCode>General</c:formatCode>
                  <c:ptCount val="6"/>
                </c:numCache>
              </c:numRef>
            </c:plus>
            <c:minus>
              <c:numRef>
                <c:f>Sheet2!$Q$62:$V$62</c:f>
                <c:numCache>
                  <c:formatCode>General</c:formatCode>
                  <c:ptCount val="6"/>
                </c:numCache>
              </c:numRef>
            </c:minus>
          </c:errBars>
          <c:xVal>
            <c:numRef>
              <c:f>Sheet1!$D$58:$G$58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</c:numCache>
            </c:numRef>
          </c:xVal>
          <c:yVal>
            <c:numRef>
              <c:f>Sheet1!$L$57:$O$57</c:f>
              <c:numCache>
                <c:formatCode>0.0</c:formatCode>
                <c:ptCount val="4"/>
                <c:pt idx="0">
                  <c:v>0</c:v>
                </c:pt>
                <c:pt idx="1">
                  <c:v>0.3</c:v>
                </c:pt>
                <c:pt idx="2">
                  <c:v>0.5</c:v>
                </c:pt>
                <c:pt idx="3">
                  <c:v>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1971712"/>
        <c:axId val="214092800"/>
      </c:scatterChart>
      <c:valAx>
        <c:axId val="191971712"/>
        <c:scaling>
          <c:orientation val="minMax"/>
          <c:max val="60"/>
        </c:scaling>
        <c:delete val="0"/>
        <c:axPos val="b"/>
        <c:title>
          <c:tx>
            <c:rich>
              <a:bodyPr/>
              <a:lstStyle/>
              <a:p>
                <a:pPr>
                  <a:defRPr sz="1200" b="0"/>
                </a:pPr>
                <a:r>
                  <a:rPr lang="en-US" sz="1200" b="0" dirty="0" smtClean="0"/>
                  <a:t>Incubation time </a:t>
                </a:r>
                <a:r>
                  <a:rPr lang="en-US" sz="1200" b="0" dirty="0"/>
                  <a:t>(min)</a:t>
                </a:r>
              </a:p>
            </c:rich>
          </c:tx>
          <c:layout>
            <c:manualLayout>
              <c:xMode val="edge"/>
              <c:yMode val="edge"/>
              <c:x val="0.20397664575306901"/>
              <c:y val="0.88783802474063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214092800"/>
        <c:crosses val="autoZero"/>
        <c:crossBetween val="midCat"/>
        <c:majorUnit val="30"/>
      </c:valAx>
      <c:valAx>
        <c:axId val="214092800"/>
        <c:scaling>
          <c:orientation val="minMax"/>
          <c:max val="8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/>
                </a:pPr>
                <a:r>
                  <a:rPr lang="en-US" sz="1200" b="0"/>
                  <a:t>Substrate cleaved (fmol)</a:t>
                </a:r>
              </a:p>
            </c:rich>
          </c:tx>
          <c:layout>
            <c:manualLayout>
              <c:xMode val="edge"/>
              <c:yMode val="edge"/>
              <c:x val="3.9407678145753397E-2"/>
              <c:y val="0.16123529284440999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91971712"/>
        <c:crosses val="autoZero"/>
        <c:crossBetween val="midCat"/>
        <c:majorUnit val="4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556511"/>
            <a:ext cx="7772400" cy="176403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663440"/>
            <a:ext cx="6400800" cy="21031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7A8E0-8611-4FC2-809F-2B81491E923F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1411BE-AE65-434B-B9B0-8E762190B1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70037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7A8E0-8611-4FC2-809F-2B81491E923F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1411BE-AE65-434B-B9B0-8E762190B1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843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396240"/>
            <a:ext cx="2057400" cy="842581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396240"/>
            <a:ext cx="6019800" cy="842581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7A8E0-8611-4FC2-809F-2B81491E923F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1411BE-AE65-434B-B9B0-8E762190B1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3538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7A8E0-8611-4FC2-809F-2B81491E923F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1411BE-AE65-434B-B9B0-8E762190B1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8794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5288281"/>
            <a:ext cx="7772400" cy="163449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3488056"/>
            <a:ext cx="7772400" cy="180022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7A8E0-8611-4FC2-809F-2B81491E923F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1411BE-AE65-434B-B9B0-8E762190B1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8005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2305050"/>
            <a:ext cx="4038600" cy="651700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2305050"/>
            <a:ext cx="4038600" cy="651700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7A8E0-8611-4FC2-809F-2B81491E923F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1411BE-AE65-434B-B9B0-8E762190B1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3913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329566"/>
            <a:ext cx="8229600" cy="13716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842136"/>
            <a:ext cx="4040188" cy="7677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609850"/>
            <a:ext cx="4040188" cy="474154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842136"/>
            <a:ext cx="4041775" cy="7677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609850"/>
            <a:ext cx="4041775" cy="474154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7A8E0-8611-4FC2-809F-2B81491E923F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1411BE-AE65-434B-B9B0-8E762190B1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83818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7A8E0-8611-4FC2-809F-2B81491E923F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1411BE-AE65-434B-B9B0-8E762190B1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2739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7A8E0-8611-4FC2-809F-2B81491E923F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1411BE-AE65-434B-B9B0-8E762190B1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6692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327660"/>
            <a:ext cx="3008313" cy="139446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327660"/>
            <a:ext cx="5111750" cy="702373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722120"/>
            <a:ext cx="3008313" cy="562927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7A8E0-8611-4FC2-809F-2B81491E923F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1411BE-AE65-434B-B9B0-8E762190B1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1971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5760720"/>
            <a:ext cx="5486400" cy="68008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735330"/>
            <a:ext cx="5486400" cy="493776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6440806"/>
            <a:ext cx="5486400" cy="96583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77A8E0-8611-4FC2-809F-2B81491E923F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1411BE-AE65-434B-B9B0-8E762190B1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62793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329566"/>
            <a:ext cx="8229600" cy="1371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920240"/>
            <a:ext cx="8229600" cy="54311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7627621"/>
            <a:ext cx="21336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77A8E0-8611-4FC2-809F-2B81491E923F}" type="datetimeFigureOut">
              <a:rPr lang="en-US" smtClean="0"/>
              <a:t>1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7627621"/>
            <a:ext cx="28956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7627621"/>
            <a:ext cx="21336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1411BE-AE65-434B-B9B0-8E762190B1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4194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microsoft.com/office/2007/relationships/hdphoto" Target="../media/hdphoto7.wdp"/><Relationship Id="rId3" Type="http://schemas.microsoft.com/office/2007/relationships/hdphoto" Target="../media/hdphoto2.wdp"/><Relationship Id="rId7" Type="http://schemas.microsoft.com/office/2007/relationships/hdphoto" Target="../media/hdphoto4.wdp"/><Relationship Id="rId12" Type="http://schemas.openxmlformats.org/officeDocument/2006/relationships/image" Target="../media/image8.png"/><Relationship Id="rId17" Type="http://schemas.microsoft.com/office/2007/relationships/hdphoto" Target="../media/hdphoto9.wdp"/><Relationship Id="rId2" Type="http://schemas.openxmlformats.org/officeDocument/2006/relationships/image" Target="../media/image3.jpeg"/><Relationship Id="rId16" Type="http://schemas.openxmlformats.org/officeDocument/2006/relationships/image" Target="../media/image10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microsoft.com/office/2007/relationships/hdphoto" Target="../media/hdphoto6.wdp"/><Relationship Id="rId5" Type="http://schemas.microsoft.com/office/2007/relationships/hdphoto" Target="../media/hdphoto3.wdp"/><Relationship Id="rId15" Type="http://schemas.microsoft.com/office/2007/relationships/hdphoto" Target="../media/hdphoto8.wdp"/><Relationship Id="rId10" Type="http://schemas.openxmlformats.org/officeDocument/2006/relationships/image" Target="../media/image7.png"/><Relationship Id="rId4" Type="http://schemas.openxmlformats.org/officeDocument/2006/relationships/image" Target="../media/image4.jpeg"/><Relationship Id="rId9" Type="http://schemas.microsoft.com/office/2007/relationships/hdphoto" Target="../media/hdphoto5.wdp"/><Relationship Id="rId14" Type="http://schemas.openxmlformats.org/officeDocument/2006/relationships/image" Target="../media/image9.jpe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0.wdp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.xml"/><Relationship Id="rId5" Type="http://schemas.microsoft.com/office/2007/relationships/hdphoto" Target="../media/hdphoto11.wdp"/><Relationship Id="rId4" Type="http://schemas.openxmlformats.org/officeDocument/2006/relationships/image" Target="../media/image12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Relationship Id="rId6" Type="http://schemas.microsoft.com/office/2007/relationships/hdphoto" Target="../media/hdphoto12.wdp"/><Relationship Id="rId5" Type="http://schemas.openxmlformats.org/officeDocument/2006/relationships/image" Target="../media/image16.png"/><Relationship Id="rId4" Type="http://schemas.openxmlformats.org/officeDocument/2006/relationships/image" Target="../media/image15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jpeg"/><Relationship Id="rId13" Type="http://schemas.microsoft.com/office/2007/relationships/hdphoto" Target="../media/hdphoto14.wdp"/><Relationship Id="rId3" Type="http://schemas.openxmlformats.org/officeDocument/2006/relationships/image" Target="../media/image18.png"/><Relationship Id="rId7" Type="http://schemas.openxmlformats.org/officeDocument/2006/relationships/image" Target="../media/image22.jpeg"/><Relationship Id="rId12" Type="http://schemas.openxmlformats.org/officeDocument/2006/relationships/image" Target="../media/image26.jpe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11" Type="http://schemas.openxmlformats.org/officeDocument/2006/relationships/image" Target="../media/image25.jpeg"/><Relationship Id="rId5" Type="http://schemas.openxmlformats.org/officeDocument/2006/relationships/image" Target="../media/image20.png"/><Relationship Id="rId10" Type="http://schemas.openxmlformats.org/officeDocument/2006/relationships/image" Target="../media/image24.jpeg"/><Relationship Id="rId4" Type="http://schemas.openxmlformats.org/officeDocument/2006/relationships/image" Target="../media/image19.png"/><Relationship Id="rId9" Type="http://schemas.microsoft.com/office/2007/relationships/hdphoto" Target="../media/hdphoto13.wdp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7" Type="http://schemas.openxmlformats.org/officeDocument/2006/relationships/image" Target="../media/image31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microsoft.com/office/2007/relationships/hdphoto" Target="../media/hdphoto15.wdp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tiff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506510" y="1563918"/>
            <a:ext cx="5943600" cy="4269217"/>
            <a:chOff x="228600" y="1775619"/>
            <a:chExt cx="5943600" cy="4269217"/>
          </a:xfrm>
        </p:grpSpPr>
        <p:sp>
          <p:nvSpPr>
            <p:cNvPr id="5" name="TextBox 4"/>
            <p:cNvSpPr txBox="1"/>
            <p:nvPr/>
          </p:nvSpPr>
          <p:spPr>
            <a:xfrm>
              <a:off x="784489" y="2049615"/>
              <a:ext cx="1298423" cy="276991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GST-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ad27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248083" y="4479648"/>
              <a:ext cx="834829" cy="276991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Lane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678955" y="3296122"/>
              <a:ext cx="739390" cy="276991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l-GR" sz="1200" dirty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α</a:t>
              </a:r>
              <a:r>
                <a:rPr lang="en-US" sz="1200" dirty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-Hi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678955" y="4070839"/>
              <a:ext cx="739390" cy="276991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l-GR" sz="1200" dirty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α</a:t>
              </a:r>
              <a:r>
                <a:rPr lang="en-US" sz="1200" dirty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-GST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019405" y="4494396"/>
              <a:ext cx="241543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196795" y="4494396"/>
              <a:ext cx="241543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361103" y="4494396"/>
              <a:ext cx="241543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516371" y="4494396"/>
              <a:ext cx="241543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707676" y="4494396"/>
              <a:ext cx="241543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876858" y="4494396"/>
              <a:ext cx="241543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054250" y="4494396"/>
              <a:ext cx="241543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221157" y="4494396"/>
              <a:ext cx="241543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409845" y="4494396"/>
              <a:ext cx="241543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491909" y="4494396"/>
              <a:ext cx="446404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664265" y="4494396"/>
              <a:ext cx="466652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274204" y="2783548"/>
              <a:ext cx="808705" cy="276991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GST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853036" y="4494396"/>
              <a:ext cx="433650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999370" y="1775619"/>
              <a:ext cx="1080467" cy="276991"/>
            </a:xfrm>
            <a:prstGeom prst="rect">
              <a:avLst/>
            </a:prstGeom>
            <a:noFill/>
            <a:effectLst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nput (20%)</a:t>
              </a:r>
            </a:p>
          </p:txBody>
        </p:sp>
        <p:cxnSp>
          <p:nvCxnSpPr>
            <p:cNvPr id="23" name="Straight Connector 22"/>
            <p:cNvCxnSpPr/>
            <p:nvPr/>
          </p:nvCxnSpPr>
          <p:spPr>
            <a:xfrm>
              <a:off x="2066068" y="2202525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4" name="Group 23"/>
            <p:cNvGrpSpPr/>
            <p:nvPr/>
          </p:nvGrpSpPr>
          <p:grpSpPr>
            <a:xfrm>
              <a:off x="2243480" y="2154650"/>
              <a:ext cx="92426" cy="95751"/>
              <a:chOff x="2174858" y="851949"/>
              <a:chExt cx="95716" cy="95716"/>
            </a:xfrm>
          </p:grpSpPr>
          <p:cxnSp>
            <p:nvCxnSpPr>
              <p:cNvPr id="102" name="Straight Connector 101"/>
              <p:cNvCxnSpPr/>
              <p:nvPr/>
            </p:nvCxnSpPr>
            <p:spPr>
              <a:xfrm>
                <a:off x="2174858" y="899807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Straight Connector 102"/>
              <p:cNvCxnSpPr/>
              <p:nvPr/>
            </p:nvCxnSpPr>
            <p:spPr>
              <a:xfrm rot="16200000">
                <a:off x="2174858" y="899807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5" name="Straight Connector 24"/>
            <p:cNvCxnSpPr/>
            <p:nvPr/>
          </p:nvCxnSpPr>
          <p:spPr>
            <a:xfrm>
              <a:off x="2420896" y="2202525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2598307" y="2202525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>
              <a:off x="2775721" y="2202525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8" name="Group 27"/>
            <p:cNvGrpSpPr/>
            <p:nvPr/>
          </p:nvGrpSpPr>
          <p:grpSpPr>
            <a:xfrm>
              <a:off x="3126731" y="2154650"/>
              <a:ext cx="92426" cy="95751"/>
              <a:chOff x="3089547" y="851949"/>
              <a:chExt cx="95716" cy="95716"/>
            </a:xfrm>
          </p:grpSpPr>
          <p:cxnSp>
            <p:nvCxnSpPr>
              <p:cNvPr id="100" name="Straight Connector 99"/>
              <p:cNvCxnSpPr/>
              <p:nvPr/>
            </p:nvCxnSpPr>
            <p:spPr>
              <a:xfrm>
                <a:off x="3089547" y="899807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Straight Connector 100"/>
              <p:cNvCxnSpPr/>
              <p:nvPr/>
            </p:nvCxnSpPr>
            <p:spPr>
              <a:xfrm rot="16200000">
                <a:off x="3089547" y="899807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9" name="Straight Connector 28"/>
            <p:cNvCxnSpPr/>
            <p:nvPr/>
          </p:nvCxnSpPr>
          <p:spPr>
            <a:xfrm>
              <a:off x="3304144" y="2202525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3481556" y="2202525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>
              <a:off x="3658972" y="2202525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>
              <a:off x="3836385" y="2202525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3" name="Group 32"/>
            <p:cNvGrpSpPr/>
            <p:nvPr/>
          </p:nvGrpSpPr>
          <p:grpSpPr>
            <a:xfrm>
              <a:off x="4004265" y="2154650"/>
              <a:ext cx="92426" cy="95751"/>
              <a:chOff x="4008187" y="851949"/>
              <a:chExt cx="95716" cy="95716"/>
            </a:xfrm>
          </p:grpSpPr>
          <p:cxnSp>
            <p:nvCxnSpPr>
              <p:cNvPr id="98" name="Straight Connector 97"/>
              <p:cNvCxnSpPr/>
              <p:nvPr/>
            </p:nvCxnSpPr>
            <p:spPr>
              <a:xfrm>
                <a:off x="4008187" y="899807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Straight Connector 98"/>
              <p:cNvCxnSpPr/>
              <p:nvPr/>
            </p:nvCxnSpPr>
            <p:spPr>
              <a:xfrm rot="16200000">
                <a:off x="4008187" y="899807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oup 33"/>
            <p:cNvGrpSpPr/>
            <p:nvPr/>
          </p:nvGrpSpPr>
          <p:grpSpPr>
            <a:xfrm>
              <a:off x="4181680" y="2154650"/>
              <a:ext cx="92426" cy="95751"/>
              <a:chOff x="4191916" y="851949"/>
              <a:chExt cx="95716" cy="95716"/>
            </a:xfrm>
          </p:grpSpPr>
          <p:cxnSp>
            <p:nvCxnSpPr>
              <p:cNvPr id="96" name="Straight Connector 95"/>
              <p:cNvCxnSpPr/>
              <p:nvPr/>
            </p:nvCxnSpPr>
            <p:spPr>
              <a:xfrm>
                <a:off x="4191916" y="899807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Straight Connector 96"/>
              <p:cNvCxnSpPr/>
              <p:nvPr/>
            </p:nvCxnSpPr>
            <p:spPr>
              <a:xfrm rot="16200000">
                <a:off x="4191916" y="899807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5" name="Right Bracket 34"/>
            <p:cNvSpPr/>
            <p:nvPr/>
          </p:nvSpPr>
          <p:spPr>
            <a:xfrm rot="5400000" flipH="1" flipV="1">
              <a:off x="2525840" y="1544622"/>
              <a:ext cx="45736" cy="1063137"/>
            </a:xfrm>
            <a:prstGeom prst="rightBracket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lIns="91433" tIns="45716" rIns="91433" bIns="45716" rtlCol="0" anchor="ctr"/>
            <a:lstStyle/>
            <a:p>
              <a:pPr algn="ctr"/>
              <a:endParaRPr lang="en-US" sz="2800"/>
            </a:p>
          </p:txBody>
        </p:sp>
        <p:cxnSp>
          <p:nvCxnSpPr>
            <p:cNvPr id="36" name="Straight Connector 35"/>
            <p:cNvCxnSpPr/>
            <p:nvPr/>
          </p:nvCxnSpPr>
          <p:spPr>
            <a:xfrm>
              <a:off x="2775721" y="2947468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7" name="Group 36"/>
            <p:cNvGrpSpPr/>
            <p:nvPr/>
          </p:nvGrpSpPr>
          <p:grpSpPr>
            <a:xfrm>
              <a:off x="2066068" y="2899595"/>
              <a:ext cx="92426" cy="95751"/>
              <a:chOff x="1991130" y="1596628"/>
              <a:chExt cx="95716" cy="95716"/>
            </a:xfrm>
          </p:grpSpPr>
          <p:cxnSp>
            <p:nvCxnSpPr>
              <p:cNvPr id="94" name="Straight Connector 93"/>
              <p:cNvCxnSpPr/>
              <p:nvPr/>
            </p:nvCxnSpPr>
            <p:spPr>
              <a:xfrm>
                <a:off x="1991130" y="1644486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Straight Connector 94"/>
              <p:cNvCxnSpPr/>
              <p:nvPr/>
            </p:nvCxnSpPr>
            <p:spPr>
              <a:xfrm rot="16200000">
                <a:off x="1991130" y="1644486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8" name="Straight Connector 37"/>
            <p:cNvCxnSpPr/>
            <p:nvPr/>
          </p:nvCxnSpPr>
          <p:spPr>
            <a:xfrm>
              <a:off x="2420896" y="2947468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2598307" y="2947468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>
              <a:off x="3126731" y="2947468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1" name="Group 40"/>
            <p:cNvGrpSpPr/>
            <p:nvPr/>
          </p:nvGrpSpPr>
          <p:grpSpPr>
            <a:xfrm>
              <a:off x="3658972" y="2899595"/>
              <a:ext cx="92426" cy="95751"/>
              <a:chOff x="3640731" y="1596628"/>
              <a:chExt cx="95716" cy="95716"/>
            </a:xfrm>
          </p:grpSpPr>
          <p:cxnSp>
            <p:nvCxnSpPr>
              <p:cNvPr id="92" name="Straight Connector 91"/>
              <p:cNvCxnSpPr/>
              <p:nvPr/>
            </p:nvCxnSpPr>
            <p:spPr>
              <a:xfrm>
                <a:off x="3640731" y="1644486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Straight Connector 92"/>
              <p:cNvCxnSpPr/>
              <p:nvPr/>
            </p:nvCxnSpPr>
            <p:spPr>
              <a:xfrm rot="16200000">
                <a:off x="3640731" y="1644486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2" name="Straight Connector 41"/>
            <p:cNvCxnSpPr/>
            <p:nvPr/>
          </p:nvCxnSpPr>
          <p:spPr>
            <a:xfrm>
              <a:off x="4181680" y="2947468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3" name="Group 42"/>
            <p:cNvGrpSpPr/>
            <p:nvPr/>
          </p:nvGrpSpPr>
          <p:grpSpPr>
            <a:xfrm>
              <a:off x="3481556" y="2899595"/>
              <a:ext cx="92426" cy="95751"/>
              <a:chOff x="3457003" y="1596628"/>
              <a:chExt cx="95716" cy="95716"/>
            </a:xfrm>
          </p:grpSpPr>
          <p:cxnSp>
            <p:nvCxnSpPr>
              <p:cNvPr id="90" name="Straight Connector 89"/>
              <p:cNvCxnSpPr/>
              <p:nvPr/>
            </p:nvCxnSpPr>
            <p:spPr>
              <a:xfrm>
                <a:off x="3457003" y="1644486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Straight Connector 90"/>
              <p:cNvCxnSpPr/>
              <p:nvPr/>
            </p:nvCxnSpPr>
            <p:spPr>
              <a:xfrm rot="16200000">
                <a:off x="3457003" y="1644486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4" name="Group 43"/>
            <p:cNvGrpSpPr/>
            <p:nvPr/>
          </p:nvGrpSpPr>
          <p:grpSpPr>
            <a:xfrm>
              <a:off x="3836385" y="2902124"/>
              <a:ext cx="92426" cy="95751"/>
              <a:chOff x="3824459" y="1599154"/>
              <a:chExt cx="95716" cy="95716"/>
            </a:xfrm>
          </p:grpSpPr>
          <p:cxnSp>
            <p:nvCxnSpPr>
              <p:cNvPr id="88" name="Straight Connector 87"/>
              <p:cNvCxnSpPr/>
              <p:nvPr/>
            </p:nvCxnSpPr>
            <p:spPr>
              <a:xfrm rot="16200000">
                <a:off x="3824459" y="1647012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Straight Connector 88"/>
              <p:cNvCxnSpPr/>
              <p:nvPr/>
            </p:nvCxnSpPr>
            <p:spPr>
              <a:xfrm>
                <a:off x="3824459" y="1647011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5" name="Straight Connector 44"/>
            <p:cNvCxnSpPr/>
            <p:nvPr/>
          </p:nvCxnSpPr>
          <p:spPr>
            <a:xfrm>
              <a:off x="4004265" y="2947468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>
              <a:off x="2243480" y="2947468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7" name="Group 46"/>
            <p:cNvGrpSpPr/>
            <p:nvPr/>
          </p:nvGrpSpPr>
          <p:grpSpPr>
            <a:xfrm>
              <a:off x="3304144" y="2899595"/>
              <a:ext cx="92426" cy="95751"/>
              <a:chOff x="3273275" y="1596628"/>
              <a:chExt cx="95716" cy="95716"/>
            </a:xfrm>
          </p:grpSpPr>
          <p:cxnSp>
            <p:nvCxnSpPr>
              <p:cNvPr id="86" name="Straight Connector 85"/>
              <p:cNvCxnSpPr/>
              <p:nvPr/>
            </p:nvCxnSpPr>
            <p:spPr>
              <a:xfrm>
                <a:off x="3273275" y="1644486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Straight Connector 86"/>
              <p:cNvCxnSpPr/>
              <p:nvPr/>
            </p:nvCxnSpPr>
            <p:spPr>
              <a:xfrm rot="16200000">
                <a:off x="3273275" y="1644486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8" name="Straight Connector 47"/>
            <p:cNvCxnSpPr/>
            <p:nvPr/>
          </p:nvCxnSpPr>
          <p:spPr>
            <a:xfrm>
              <a:off x="2066068" y="2622565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>
              <a:off x="3126731" y="2622565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/>
          </p:nvCxnSpPr>
          <p:spPr>
            <a:xfrm>
              <a:off x="2243480" y="2622565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>
            <a:xfrm>
              <a:off x="2963312" y="2203031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>
              <a:off x="2963312" y="2947976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3" name="Group 52"/>
            <p:cNvGrpSpPr/>
            <p:nvPr/>
          </p:nvGrpSpPr>
          <p:grpSpPr>
            <a:xfrm>
              <a:off x="4360639" y="2157142"/>
              <a:ext cx="92426" cy="95751"/>
              <a:chOff x="4377245" y="854439"/>
              <a:chExt cx="95716" cy="95716"/>
            </a:xfrm>
          </p:grpSpPr>
          <p:cxnSp>
            <p:nvCxnSpPr>
              <p:cNvPr id="84" name="Straight Connector 83"/>
              <p:cNvCxnSpPr/>
              <p:nvPr/>
            </p:nvCxnSpPr>
            <p:spPr>
              <a:xfrm>
                <a:off x="4377245" y="902297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Straight Connector 84"/>
              <p:cNvCxnSpPr/>
              <p:nvPr/>
            </p:nvCxnSpPr>
            <p:spPr>
              <a:xfrm rot="16200000">
                <a:off x="4377245" y="902297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4" name="Group 53"/>
            <p:cNvGrpSpPr/>
            <p:nvPr/>
          </p:nvGrpSpPr>
          <p:grpSpPr>
            <a:xfrm>
              <a:off x="4532949" y="2157142"/>
              <a:ext cx="92426" cy="95751"/>
              <a:chOff x="4555688" y="854439"/>
              <a:chExt cx="95716" cy="95716"/>
            </a:xfrm>
          </p:grpSpPr>
          <p:cxnSp>
            <p:nvCxnSpPr>
              <p:cNvPr id="82" name="Straight Connector 81"/>
              <p:cNvCxnSpPr/>
              <p:nvPr/>
            </p:nvCxnSpPr>
            <p:spPr>
              <a:xfrm>
                <a:off x="4555688" y="902297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/>
              <p:cNvCxnSpPr/>
              <p:nvPr/>
            </p:nvCxnSpPr>
            <p:spPr>
              <a:xfrm rot="16200000">
                <a:off x="4555688" y="902297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55" name="Straight Connector 54"/>
            <p:cNvCxnSpPr/>
            <p:nvPr/>
          </p:nvCxnSpPr>
          <p:spPr>
            <a:xfrm>
              <a:off x="4532949" y="2949961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>
            <a:xfrm>
              <a:off x="4360639" y="2949961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/>
            <p:cNvSpPr txBox="1"/>
            <p:nvPr/>
          </p:nvSpPr>
          <p:spPr>
            <a:xfrm rot="18344432">
              <a:off x="2194636" y="2507302"/>
              <a:ext cx="505542" cy="261602"/>
            </a:xfrm>
            <a:prstGeom prst="rect">
              <a:avLst/>
            </a:prstGeom>
            <a:noFill/>
            <a:effectLst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 rot="18344432">
              <a:off x="2291331" y="2354994"/>
              <a:ext cx="880836" cy="261602"/>
            </a:xfrm>
            <a:prstGeom prst="rect">
              <a:avLst/>
            </a:prstGeom>
            <a:noFill/>
            <a:effectLst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F474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 rot="18344432">
              <a:off x="2476328" y="2356361"/>
              <a:ext cx="877469" cy="261602"/>
            </a:xfrm>
            <a:prstGeom prst="rect">
              <a:avLst/>
            </a:prstGeom>
            <a:noFill/>
            <a:effectLst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F316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 rot="18344432">
              <a:off x="2681212" y="2357935"/>
              <a:ext cx="873589" cy="261602"/>
            </a:xfrm>
            <a:prstGeom prst="rect">
              <a:avLst/>
            </a:prstGeom>
            <a:noFill/>
            <a:effectLst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F158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 rot="18344432">
              <a:off x="3167386" y="2480055"/>
              <a:ext cx="572679" cy="261602"/>
            </a:xfrm>
            <a:prstGeom prst="rect">
              <a:avLst/>
            </a:prstGeom>
            <a:noFill/>
            <a:effectLst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 rot="18344432">
              <a:off x="3306778" y="2350347"/>
              <a:ext cx="892286" cy="261602"/>
            </a:xfrm>
            <a:prstGeom prst="rect">
              <a:avLst/>
            </a:prstGeom>
            <a:noFill/>
            <a:effectLst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F474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 rot="18344432">
              <a:off x="3506199" y="2377036"/>
              <a:ext cx="826524" cy="261602"/>
            </a:xfrm>
            <a:prstGeom prst="rect">
              <a:avLst/>
            </a:prstGeom>
            <a:noFill/>
            <a:effectLst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F316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 rot="18344432">
              <a:off x="3693349" y="2385693"/>
              <a:ext cx="805193" cy="261602"/>
            </a:xfrm>
            <a:prstGeom prst="rect">
              <a:avLst/>
            </a:prstGeom>
            <a:noFill/>
            <a:effectLst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F158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 rot="18344432">
              <a:off x="3910430" y="2470394"/>
              <a:ext cx="596484" cy="261602"/>
            </a:xfrm>
            <a:prstGeom prst="rect">
              <a:avLst/>
            </a:prstGeom>
            <a:noFill/>
            <a:effectLst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 rot="18344432">
              <a:off x="4041563" y="2359842"/>
              <a:ext cx="868891" cy="261602"/>
            </a:xfrm>
            <a:prstGeom prst="rect">
              <a:avLst/>
            </a:prstGeom>
            <a:noFill/>
            <a:effectLst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F474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 rot="18344432">
              <a:off x="4222903" y="2348800"/>
              <a:ext cx="896100" cy="261602"/>
            </a:xfrm>
            <a:prstGeom prst="rect">
              <a:avLst/>
            </a:prstGeom>
            <a:noFill/>
            <a:effectLst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F316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 rot="18344432">
              <a:off x="4418647" y="2386603"/>
              <a:ext cx="802950" cy="261602"/>
            </a:xfrm>
            <a:prstGeom prst="rect">
              <a:avLst/>
            </a:prstGeom>
            <a:noFill/>
            <a:effectLst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F158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4020537" y="4494396"/>
              <a:ext cx="449135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4148503" y="4494396"/>
              <a:ext cx="526210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4312671" y="4494396"/>
              <a:ext cx="549375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657148" y="2467810"/>
              <a:ext cx="1425765" cy="276991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s-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3133662" y="1775619"/>
              <a:ext cx="1545294" cy="276991"/>
            </a:xfrm>
            <a:prstGeom prst="rect">
              <a:avLst/>
            </a:prstGeom>
            <a:noFill/>
            <a:effectLst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P-GST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Right Bracket 73"/>
            <p:cNvSpPr/>
            <p:nvPr/>
          </p:nvSpPr>
          <p:spPr>
            <a:xfrm rot="5400000" flipH="1" flipV="1">
              <a:off x="3875470" y="1313103"/>
              <a:ext cx="46864" cy="1527309"/>
            </a:xfrm>
            <a:prstGeom prst="rightBracket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lIns="91433" tIns="45716" rIns="91433" bIns="45716" rtlCol="0" anchor="ctr"/>
            <a:lstStyle/>
            <a:p>
              <a:pPr algn="ctr"/>
              <a:endParaRPr lang="en-US" sz="3200"/>
            </a:p>
          </p:txBody>
        </p:sp>
        <p:sp>
          <p:nvSpPr>
            <p:cNvPr id="75" name="AutoShape 95"/>
            <p:cNvSpPr>
              <a:spLocks noChangeArrowheads="1"/>
            </p:cNvSpPr>
            <p:nvPr/>
          </p:nvSpPr>
          <p:spPr bwMode="auto">
            <a:xfrm rot="5400000" flipH="1">
              <a:off x="1838164" y="3905593"/>
              <a:ext cx="80598" cy="164148"/>
            </a:xfrm>
            <a:prstGeom prst="triangle">
              <a:avLst>
                <a:gd name="adj" fmla="val 49875"/>
              </a:avLst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scene3d>
              <a:camera prst="orthographicFront">
                <a:rot lat="0" lon="10799999" rev="0"/>
              </a:camera>
              <a:lightRig rig="threePt" dir="t"/>
            </a:scene3d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sz="2800"/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609600" y="3865955"/>
              <a:ext cx="1256553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1000" dirty="0" smtClean="0">
                  <a:latin typeface="Arial"/>
                  <a:cs typeface="Arial"/>
                </a:rPr>
                <a:t>GST-</a:t>
              </a:r>
              <a:r>
                <a:rPr lang="en-US" sz="1100" dirty="0" smtClean="0">
                  <a:latin typeface="Arial"/>
                  <a:cs typeface="Arial"/>
                </a:rPr>
                <a:t>Rad27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77" name="AutoShape 95"/>
            <p:cNvSpPr>
              <a:spLocks noChangeArrowheads="1"/>
            </p:cNvSpPr>
            <p:nvPr/>
          </p:nvSpPr>
          <p:spPr bwMode="auto">
            <a:xfrm rot="5400000" flipH="1">
              <a:off x="1838164" y="4317951"/>
              <a:ext cx="80598" cy="164148"/>
            </a:xfrm>
            <a:prstGeom prst="triangle">
              <a:avLst>
                <a:gd name="adj" fmla="val 49875"/>
              </a:avLst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scene3d>
              <a:camera prst="orthographicFront">
                <a:rot lat="0" lon="10799999" rev="0"/>
              </a:camera>
              <a:lightRig rig="threePt" dir="t"/>
            </a:scene3d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 sz="2800"/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1239314" y="4280779"/>
              <a:ext cx="626840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1100" dirty="0" smtClean="0">
                  <a:latin typeface="Arial"/>
                  <a:cs typeface="Arial"/>
                </a:rPr>
                <a:t>GST</a:t>
              </a:r>
              <a:endParaRPr lang="en-US" sz="1100" dirty="0">
                <a:latin typeface="Arial"/>
                <a:cs typeface="Arial"/>
              </a:endParaRPr>
            </a:p>
          </p:txBody>
        </p:sp>
        <p:pic>
          <p:nvPicPr>
            <p:cNvPr id="79" name="Picture 3" descr="E:\Study\Lab\MUS81-FEN1\Result image\2014\2014 Dec\GST pull down sup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3000" contrast="-1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42" r="9450"/>
            <a:stretch/>
          </p:blipFill>
          <p:spPr bwMode="auto">
            <a:xfrm>
              <a:off x="1999368" y="3101474"/>
              <a:ext cx="2679586" cy="692843"/>
            </a:xfrm>
            <a:prstGeom prst="rect">
              <a:avLst/>
            </a:prstGeom>
            <a:noFill/>
            <a:ln w="3175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0" name="Picture 2" descr="C:\Documents and Settings\Thanh\My Documents\Dropbox\Dissertation\Back-up folder\Back-up20130906 Detail-Figure\Western\5A.ti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8816"/>
            <a:stretch/>
          </p:blipFill>
          <p:spPr bwMode="auto">
            <a:xfrm>
              <a:off x="2004140" y="3865956"/>
              <a:ext cx="2670042" cy="6776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1" name="TextBox 80"/>
            <p:cNvSpPr txBox="1"/>
            <p:nvPr/>
          </p:nvSpPr>
          <p:spPr>
            <a:xfrm>
              <a:off x="228600" y="5213839"/>
              <a:ext cx="594360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S1</a:t>
              </a:r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The N-termin</a:t>
              </a:r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 part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of Mus81 is responsible for binding Rad27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.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GST pull-down assays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ere carried out with mixtures of GST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Rad27 and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ne of Mus81 derivatives, Mus81-FL, Mus81-NF474, Mus81-NF316, and Mus81-NF158 as described in Materials and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ethods.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074673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695774" y="897421"/>
            <a:ext cx="6518308" cy="6099063"/>
            <a:chOff x="0" y="814222"/>
            <a:chExt cx="6518308" cy="6099063"/>
          </a:xfrm>
        </p:grpSpPr>
        <p:sp>
          <p:nvSpPr>
            <p:cNvPr id="5" name="TextBox 4"/>
            <p:cNvSpPr txBox="1"/>
            <p:nvPr/>
          </p:nvSpPr>
          <p:spPr>
            <a:xfrm>
              <a:off x="0" y="814222"/>
              <a:ext cx="4074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52400" y="1319740"/>
              <a:ext cx="9162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ST-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d27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0" y="1575413"/>
              <a:ext cx="10686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s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Mus81-</a:t>
              </a: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F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33078" y="2957862"/>
              <a:ext cx="7355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ne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58516" y="2047904"/>
              <a:ext cx="6101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0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α</a:t>
              </a:r>
              <a:r>
                <a:rPr lang="en-US" sz="10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-Hi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58516" y="2539403"/>
              <a:ext cx="6101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0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α</a:t>
              </a:r>
              <a:r>
                <a:rPr lang="en-US" sz="10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-GS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001822" y="2957862"/>
              <a:ext cx="1868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143586" y="2957862"/>
              <a:ext cx="1868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283965" y="2957862"/>
              <a:ext cx="1868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424343" y="2957862"/>
              <a:ext cx="1868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582138" y="2957862"/>
              <a:ext cx="1868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731224" y="2957862"/>
              <a:ext cx="1868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889018" y="2957862"/>
              <a:ext cx="1868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029397" y="2957862"/>
              <a:ext cx="1868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178481" y="2957862"/>
              <a:ext cx="1868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226945" y="2957862"/>
              <a:ext cx="3810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421534" y="2957862"/>
              <a:ext cx="3294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01319" y="1839954"/>
              <a:ext cx="66730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S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516167" y="2957862"/>
              <a:ext cx="4250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4" name="Picture 23"/>
            <p:cNvPicPr>
              <a:picLocks noChangeAspect="1"/>
            </p:cNvPicPr>
            <p:nvPr/>
          </p:nvPicPr>
          <p:blipFill rotWithShape="1">
            <a:blip r:embed="rId2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1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4"/>
            <a:stretch/>
          </p:blipFill>
          <p:spPr>
            <a:xfrm>
              <a:off x="1033266" y="2045434"/>
              <a:ext cx="1766427" cy="201127"/>
            </a:xfrm>
            <a:prstGeom prst="rect">
              <a:avLst/>
            </a:prstGeom>
            <a:effectLst/>
          </p:spPr>
        </p:pic>
        <p:sp>
          <p:nvSpPr>
            <p:cNvPr id="25" name="TextBox 24"/>
            <p:cNvSpPr txBox="1"/>
            <p:nvPr/>
          </p:nvSpPr>
          <p:spPr>
            <a:xfrm>
              <a:off x="946509" y="1129286"/>
              <a:ext cx="882291" cy="246221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put (20%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Straight Connector 25"/>
            <p:cNvCxnSpPr/>
            <p:nvPr/>
          </p:nvCxnSpPr>
          <p:spPr>
            <a:xfrm>
              <a:off x="1069547" y="1439707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7" name="Group 26"/>
            <p:cNvGrpSpPr/>
            <p:nvPr/>
          </p:nvGrpSpPr>
          <p:grpSpPr>
            <a:xfrm>
              <a:off x="1215940" y="1401574"/>
              <a:ext cx="76266" cy="76266"/>
              <a:chOff x="1215940" y="762771"/>
              <a:chExt cx="76266" cy="76266"/>
            </a:xfrm>
          </p:grpSpPr>
          <p:cxnSp>
            <p:nvCxnSpPr>
              <p:cNvPr id="368" name="Straight Connector 367"/>
              <p:cNvCxnSpPr/>
              <p:nvPr/>
            </p:nvCxnSpPr>
            <p:spPr>
              <a:xfrm>
                <a:off x="1215940" y="800904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9" name="Straight Connector 368"/>
              <p:cNvCxnSpPr/>
              <p:nvPr/>
            </p:nvCxnSpPr>
            <p:spPr>
              <a:xfrm rot="16200000">
                <a:off x="1215940" y="800904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8" name="Straight Connector 27"/>
            <p:cNvCxnSpPr/>
            <p:nvPr/>
          </p:nvCxnSpPr>
          <p:spPr>
            <a:xfrm>
              <a:off x="1362334" y="1439707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/>
          </p:nvCxnSpPr>
          <p:spPr>
            <a:xfrm>
              <a:off x="1508727" y="1439707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1655120" y="1439707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1" name="Group 30"/>
            <p:cNvGrpSpPr/>
            <p:nvPr/>
          </p:nvGrpSpPr>
          <p:grpSpPr>
            <a:xfrm>
              <a:off x="1801513" y="1401574"/>
              <a:ext cx="76266" cy="76266"/>
              <a:chOff x="1801513" y="762771"/>
              <a:chExt cx="76266" cy="76266"/>
            </a:xfrm>
          </p:grpSpPr>
          <p:cxnSp>
            <p:nvCxnSpPr>
              <p:cNvPr id="366" name="Straight Connector 365"/>
              <p:cNvCxnSpPr/>
              <p:nvPr/>
            </p:nvCxnSpPr>
            <p:spPr>
              <a:xfrm>
                <a:off x="1801513" y="800904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7" name="Straight Connector 366"/>
              <p:cNvCxnSpPr/>
              <p:nvPr/>
            </p:nvCxnSpPr>
            <p:spPr>
              <a:xfrm rot="16200000">
                <a:off x="1801513" y="800904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2" name="Straight Connector 31"/>
            <p:cNvCxnSpPr/>
            <p:nvPr/>
          </p:nvCxnSpPr>
          <p:spPr>
            <a:xfrm>
              <a:off x="1947907" y="1439707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>
              <a:off x="2094300" y="1439707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2240693" y="1439707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5" name="Group 34"/>
            <p:cNvGrpSpPr/>
            <p:nvPr/>
          </p:nvGrpSpPr>
          <p:grpSpPr>
            <a:xfrm>
              <a:off x="2387086" y="1401574"/>
              <a:ext cx="76266" cy="76266"/>
              <a:chOff x="2387086" y="762771"/>
              <a:chExt cx="76266" cy="76266"/>
            </a:xfrm>
          </p:grpSpPr>
          <p:cxnSp>
            <p:nvCxnSpPr>
              <p:cNvPr id="364" name="Straight Connector 363"/>
              <p:cNvCxnSpPr/>
              <p:nvPr/>
            </p:nvCxnSpPr>
            <p:spPr>
              <a:xfrm>
                <a:off x="2387086" y="800904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5" name="Straight Connector 364"/>
              <p:cNvCxnSpPr/>
              <p:nvPr/>
            </p:nvCxnSpPr>
            <p:spPr>
              <a:xfrm rot="16200000">
                <a:off x="2387086" y="800904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6" name="Group 35"/>
            <p:cNvGrpSpPr/>
            <p:nvPr/>
          </p:nvGrpSpPr>
          <p:grpSpPr>
            <a:xfrm>
              <a:off x="2533480" y="1401574"/>
              <a:ext cx="76266" cy="76266"/>
              <a:chOff x="2533480" y="762771"/>
              <a:chExt cx="76266" cy="76266"/>
            </a:xfrm>
          </p:grpSpPr>
          <p:cxnSp>
            <p:nvCxnSpPr>
              <p:cNvPr id="362" name="Straight Connector 361"/>
              <p:cNvCxnSpPr/>
              <p:nvPr/>
            </p:nvCxnSpPr>
            <p:spPr>
              <a:xfrm>
                <a:off x="2533480" y="800904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3" name="Straight Connector 362"/>
              <p:cNvCxnSpPr/>
              <p:nvPr/>
            </p:nvCxnSpPr>
            <p:spPr>
              <a:xfrm rot="16200000">
                <a:off x="2533480" y="800904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Group 36"/>
            <p:cNvGrpSpPr/>
            <p:nvPr/>
          </p:nvGrpSpPr>
          <p:grpSpPr>
            <a:xfrm>
              <a:off x="2679874" y="1401574"/>
              <a:ext cx="76266" cy="76266"/>
              <a:chOff x="2679874" y="762771"/>
              <a:chExt cx="76266" cy="76266"/>
            </a:xfrm>
          </p:grpSpPr>
          <p:cxnSp>
            <p:nvCxnSpPr>
              <p:cNvPr id="360" name="Straight Connector 359"/>
              <p:cNvCxnSpPr/>
              <p:nvPr/>
            </p:nvCxnSpPr>
            <p:spPr>
              <a:xfrm>
                <a:off x="2679874" y="800904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1" name="Straight Connector 360"/>
              <p:cNvCxnSpPr/>
              <p:nvPr/>
            </p:nvCxnSpPr>
            <p:spPr>
              <a:xfrm rot="16200000">
                <a:off x="2679874" y="800904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8" name="Right Bracket 37"/>
            <p:cNvSpPr/>
            <p:nvPr/>
          </p:nvSpPr>
          <p:spPr>
            <a:xfrm rot="5400000" flipH="1" flipV="1">
              <a:off x="1372044" y="1008281"/>
              <a:ext cx="45719" cy="731461"/>
            </a:xfrm>
            <a:prstGeom prst="rightBracket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9" name="Straight Connector 38"/>
            <p:cNvCxnSpPr/>
            <p:nvPr/>
          </p:nvCxnSpPr>
          <p:spPr>
            <a:xfrm>
              <a:off x="1655120" y="1959922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0" name="Group 39"/>
            <p:cNvGrpSpPr/>
            <p:nvPr/>
          </p:nvGrpSpPr>
          <p:grpSpPr>
            <a:xfrm>
              <a:off x="1069547" y="1921789"/>
              <a:ext cx="76266" cy="76266"/>
              <a:chOff x="1069547" y="1282986"/>
              <a:chExt cx="76266" cy="76266"/>
            </a:xfrm>
          </p:grpSpPr>
          <p:cxnSp>
            <p:nvCxnSpPr>
              <p:cNvPr id="358" name="Straight Connector 357"/>
              <p:cNvCxnSpPr/>
              <p:nvPr/>
            </p:nvCxnSpPr>
            <p:spPr>
              <a:xfrm>
                <a:off x="1069547" y="1321119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9" name="Straight Connector 358"/>
              <p:cNvCxnSpPr/>
              <p:nvPr/>
            </p:nvCxnSpPr>
            <p:spPr>
              <a:xfrm rot="16200000">
                <a:off x="1069547" y="1321119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1" name="Straight Connector 40"/>
            <p:cNvCxnSpPr/>
            <p:nvPr/>
          </p:nvCxnSpPr>
          <p:spPr>
            <a:xfrm>
              <a:off x="1362334" y="1959922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1508727" y="1959922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1801513" y="1959922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4" name="Group 43"/>
            <p:cNvGrpSpPr/>
            <p:nvPr/>
          </p:nvGrpSpPr>
          <p:grpSpPr>
            <a:xfrm>
              <a:off x="2240693" y="1921789"/>
              <a:ext cx="76266" cy="76266"/>
              <a:chOff x="2240693" y="1282986"/>
              <a:chExt cx="76266" cy="76266"/>
            </a:xfrm>
          </p:grpSpPr>
          <p:cxnSp>
            <p:nvCxnSpPr>
              <p:cNvPr id="356" name="Straight Connector 355"/>
              <p:cNvCxnSpPr/>
              <p:nvPr/>
            </p:nvCxnSpPr>
            <p:spPr>
              <a:xfrm>
                <a:off x="2240693" y="1321119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7" name="Straight Connector 356"/>
              <p:cNvCxnSpPr/>
              <p:nvPr/>
            </p:nvCxnSpPr>
            <p:spPr>
              <a:xfrm rot="16200000">
                <a:off x="2240693" y="1321119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5" name="Straight Connector 44"/>
            <p:cNvCxnSpPr/>
            <p:nvPr/>
          </p:nvCxnSpPr>
          <p:spPr>
            <a:xfrm>
              <a:off x="2679874" y="1959922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6" name="Group 45"/>
            <p:cNvGrpSpPr/>
            <p:nvPr/>
          </p:nvGrpSpPr>
          <p:grpSpPr>
            <a:xfrm>
              <a:off x="2094300" y="1921789"/>
              <a:ext cx="76266" cy="76266"/>
              <a:chOff x="2094300" y="1282986"/>
              <a:chExt cx="76266" cy="76266"/>
            </a:xfrm>
          </p:grpSpPr>
          <p:cxnSp>
            <p:nvCxnSpPr>
              <p:cNvPr id="354" name="Straight Connector 353"/>
              <p:cNvCxnSpPr/>
              <p:nvPr/>
            </p:nvCxnSpPr>
            <p:spPr>
              <a:xfrm>
                <a:off x="2094300" y="1321119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5" name="Straight Connector 354"/>
              <p:cNvCxnSpPr/>
              <p:nvPr/>
            </p:nvCxnSpPr>
            <p:spPr>
              <a:xfrm rot="16200000">
                <a:off x="2094300" y="1321119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7" name="Straight Connector 46"/>
            <p:cNvCxnSpPr/>
            <p:nvPr/>
          </p:nvCxnSpPr>
          <p:spPr>
            <a:xfrm>
              <a:off x="2387086" y="1959922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>
              <a:off x="2533480" y="1959922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>
              <a:off x="1215940" y="1959922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0" name="Group 49"/>
            <p:cNvGrpSpPr/>
            <p:nvPr/>
          </p:nvGrpSpPr>
          <p:grpSpPr>
            <a:xfrm>
              <a:off x="1947907" y="1921789"/>
              <a:ext cx="76266" cy="76266"/>
              <a:chOff x="1947907" y="1282986"/>
              <a:chExt cx="76266" cy="76266"/>
            </a:xfrm>
          </p:grpSpPr>
          <p:cxnSp>
            <p:nvCxnSpPr>
              <p:cNvPr id="352" name="Straight Connector 351"/>
              <p:cNvCxnSpPr/>
              <p:nvPr/>
            </p:nvCxnSpPr>
            <p:spPr>
              <a:xfrm>
                <a:off x="1947907" y="1321119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3" name="Straight Connector 352"/>
              <p:cNvCxnSpPr/>
              <p:nvPr/>
            </p:nvCxnSpPr>
            <p:spPr>
              <a:xfrm rot="16200000">
                <a:off x="1947907" y="1321119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1" name="TextBox 50"/>
            <p:cNvSpPr txBox="1"/>
            <p:nvPr/>
          </p:nvSpPr>
          <p:spPr>
            <a:xfrm rot="18871834">
              <a:off x="2593610" y="1561669"/>
              <a:ext cx="377026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120</a:t>
              </a:r>
              <a:endParaRPr lang="en-US" sz="900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 rot="18871834">
              <a:off x="2440646" y="1561669"/>
              <a:ext cx="377026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100</a:t>
              </a:r>
              <a:endParaRPr lang="en-US" sz="900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 rot="18871834">
              <a:off x="2307363" y="1584524"/>
              <a:ext cx="312906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80</a:t>
              </a:r>
              <a:endParaRPr lang="en-US" sz="900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 rot="18871834">
              <a:off x="2110940" y="1517841"/>
              <a:ext cx="499987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120</a:t>
              </a:r>
              <a:endParaRPr lang="en-US" sz="900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 rot="18871834">
              <a:off x="1970490" y="1561669"/>
              <a:ext cx="377026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100</a:t>
              </a:r>
              <a:endParaRPr lang="en-US" sz="900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 rot="18871834">
              <a:off x="1843953" y="1584524"/>
              <a:ext cx="312906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80</a:t>
              </a:r>
              <a:endParaRPr lang="en-US" sz="900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 rot="18871834">
              <a:off x="1541633" y="1561669"/>
              <a:ext cx="377026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120</a:t>
              </a:r>
              <a:endParaRPr lang="en-US" sz="900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 rot="18871834">
              <a:off x="1373213" y="1561669"/>
              <a:ext cx="377026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100</a:t>
              </a:r>
              <a:endParaRPr lang="en-US" sz="900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 rot="18871834">
              <a:off x="1231554" y="1566862"/>
              <a:ext cx="325730" cy="246221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80</a:t>
              </a:r>
              <a:endParaRPr lang="en-US" sz="1000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cxnSp>
          <p:nvCxnSpPr>
            <p:cNvPr id="60" name="Straight Connector 59"/>
            <p:cNvCxnSpPr/>
            <p:nvPr/>
          </p:nvCxnSpPr>
          <p:spPr>
            <a:xfrm>
              <a:off x="1069547" y="1697850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/>
            <p:cNvCxnSpPr/>
            <p:nvPr/>
          </p:nvCxnSpPr>
          <p:spPr>
            <a:xfrm>
              <a:off x="1801513" y="1697850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/>
            <p:cNvCxnSpPr/>
            <p:nvPr/>
          </p:nvCxnSpPr>
          <p:spPr>
            <a:xfrm>
              <a:off x="1215940" y="1697850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/>
            <p:cNvSpPr txBox="1"/>
            <p:nvPr/>
          </p:nvSpPr>
          <p:spPr>
            <a:xfrm>
              <a:off x="3296885" y="814222"/>
              <a:ext cx="407484" cy="461665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24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B</a:t>
              </a:r>
              <a:endParaRPr lang="en-US" sz="2400" b="1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64" name="Picture 4" descr="E:\Study\Lab\Manuscript\Back-up folder\Back-up20130906 Detail-Figure\2B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45"/>
            <a:stretch/>
          </p:blipFill>
          <p:spPr bwMode="auto">
            <a:xfrm>
              <a:off x="4191981" y="2054302"/>
              <a:ext cx="1768471" cy="197398"/>
            </a:xfrm>
            <a:prstGeom prst="rect">
              <a:avLst/>
            </a:prstGeom>
            <a:noFill/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5" name="TextBox 64"/>
            <p:cNvSpPr txBox="1"/>
            <p:nvPr/>
          </p:nvSpPr>
          <p:spPr>
            <a:xfrm>
              <a:off x="3341650" y="1309493"/>
              <a:ext cx="912250" cy="246221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ST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Rad27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3322579" y="1569542"/>
              <a:ext cx="93132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s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Mus81-</a:t>
              </a: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F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3758946" y="2957862"/>
              <a:ext cx="4949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ne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3643791" y="2079462"/>
              <a:ext cx="610110" cy="246221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0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α</a:t>
              </a:r>
              <a:r>
                <a:rPr lang="en-US" sz="10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-Hi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3643791" y="2570960"/>
              <a:ext cx="6101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0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α</a:t>
              </a:r>
              <a:r>
                <a:rPr lang="en-US" sz="10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-GS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4182370" y="2957862"/>
              <a:ext cx="19778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4311072" y="2957862"/>
              <a:ext cx="19778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4460159" y="2957862"/>
              <a:ext cx="19778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4609245" y="2957862"/>
              <a:ext cx="19778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4767040" y="2957862"/>
              <a:ext cx="19778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4916126" y="2957862"/>
              <a:ext cx="19778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5056504" y="2957862"/>
              <a:ext cx="19778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5205591" y="2957862"/>
              <a:ext cx="19778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5367737" y="2957862"/>
              <a:ext cx="19778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5367843" y="2957862"/>
              <a:ext cx="4817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5549090" y="2957862"/>
              <a:ext cx="4402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3586594" y="1829708"/>
              <a:ext cx="667307" cy="246221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S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5611079" y="2957862"/>
              <a:ext cx="60478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3" name="Straight Connector 82"/>
            <p:cNvCxnSpPr/>
            <p:nvPr/>
          </p:nvCxnSpPr>
          <p:spPr>
            <a:xfrm>
              <a:off x="4229322" y="1429461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4" name="Group 83"/>
            <p:cNvGrpSpPr/>
            <p:nvPr/>
          </p:nvGrpSpPr>
          <p:grpSpPr>
            <a:xfrm>
              <a:off x="4376097" y="1391328"/>
              <a:ext cx="76266" cy="76266"/>
              <a:chOff x="4376097" y="752525"/>
              <a:chExt cx="76266" cy="76266"/>
            </a:xfrm>
          </p:grpSpPr>
          <p:cxnSp>
            <p:nvCxnSpPr>
              <p:cNvPr id="350" name="Straight Connector 349"/>
              <p:cNvCxnSpPr/>
              <p:nvPr/>
            </p:nvCxnSpPr>
            <p:spPr>
              <a:xfrm>
                <a:off x="4376097" y="790658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1" name="Straight Connector 350"/>
              <p:cNvCxnSpPr/>
              <p:nvPr/>
            </p:nvCxnSpPr>
            <p:spPr>
              <a:xfrm rot="16200000">
                <a:off x="4376097" y="790658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85" name="Straight Connector 84"/>
            <p:cNvCxnSpPr/>
            <p:nvPr/>
          </p:nvCxnSpPr>
          <p:spPr>
            <a:xfrm>
              <a:off x="4522872" y="1429461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Connector 85"/>
            <p:cNvCxnSpPr/>
            <p:nvPr/>
          </p:nvCxnSpPr>
          <p:spPr>
            <a:xfrm>
              <a:off x="4669647" y="1429461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Straight Connector 86"/>
            <p:cNvCxnSpPr/>
            <p:nvPr/>
          </p:nvCxnSpPr>
          <p:spPr>
            <a:xfrm>
              <a:off x="4816422" y="1429461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8" name="Group 87"/>
            <p:cNvGrpSpPr/>
            <p:nvPr/>
          </p:nvGrpSpPr>
          <p:grpSpPr>
            <a:xfrm>
              <a:off x="4963197" y="1391328"/>
              <a:ext cx="76266" cy="76266"/>
              <a:chOff x="4963197" y="752525"/>
              <a:chExt cx="76266" cy="76266"/>
            </a:xfrm>
          </p:grpSpPr>
          <p:cxnSp>
            <p:nvCxnSpPr>
              <p:cNvPr id="348" name="Straight Connector 347"/>
              <p:cNvCxnSpPr/>
              <p:nvPr/>
            </p:nvCxnSpPr>
            <p:spPr>
              <a:xfrm>
                <a:off x="4963197" y="790658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9" name="Straight Connector 348"/>
              <p:cNvCxnSpPr/>
              <p:nvPr/>
            </p:nvCxnSpPr>
            <p:spPr>
              <a:xfrm rot="16200000">
                <a:off x="4963197" y="790658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89" name="Straight Connector 88"/>
            <p:cNvCxnSpPr/>
            <p:nvPr/>
          </p:nvCxnSpPr>
          <p:spPr>
            <a:xfrm>
              <a:off x="5109972" y="1429461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Connector 89"/>
            <p:cNvCxnSpPr/>
            <p:nvPr/>
          </p:nvCxnSpPr>
          <p:spPr>
            <a:xfrm>
              <a:off x="5256747" y="1429461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/>
            <p:cNvCxnSpPr/>
            <p:nvPr/>
          </p:nvCxnSpPr>
          <p:spPr>
            <a:xfrm>
              <a:off x="5403522" y="1429461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2" name="Group 91"/>
            <p:cNvGrpSpPr/>
            <p:nvPr/>
          </p:nvGrpSpPr>
          <p:grpSpPr>
            <a:xfrm>
              <a:off x="5550297" y="1391328"/>
              <a:ext cx="76266" cy="76266"/>
              <a:chOff x="5550297" y="752525"/>
              <a:chExt cx="76266" cy="76266"/>
            </a:xfrm>
          </p:grpSpPr>
          <p:cxnSp>
            <p:nvCxnSpPr>
              <p:cNvPr id="346" name="Straight Connector 345"/>
              <p:cNvCxnSpPr/>
              <p:nvPr/>
            </p:nvCxnSpPr>
            <p:spPr>
              <a:xfrm>
                <a:off x="5550297" y="790658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7" name="Straight Connector 346"/>
              <p:cNvCxnSpPr/>
              <p:nvPr/>
            </p:nvCxnSpPr>
            <p:spPr>
              <a:xfrm rot="16200000">
                <a:off x="5550297" y="790658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3" name="Group 92"/>
            <p:cNvGrpSpPr/>
            <p:nvPr/>
          </p:nvGrpSpPr>
          <p:grpSpPr>
            <a:xfrm>
              <a:off x="5697072" y="1391328"/>
              <a:ext cx="76266" cy="76266"/>
              <a:chOff x="5697072" y="752525"/>
              <a:chExt cx="76266" cy="76266"/>
            </a:xfrm>
          </p:grpSpPr>
          <p:cxnSp>
            <p:nvCxnSpPr>
              <p:cNvPr id="344" name="Straight Connector 343"/>
              <p:cNvCxnSpPr/>
              <p:nvPr/>
            </p:nvCxnSpPr>
            <p:spPr>
              <a:xfrm>
                <a:off x="5697072" y="790658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5" name="Straight Connector 344"/>
              <p:cNvCxnSpPr/>
              <p:nvPr/>
            </p:nvCxnSpPr>
            <p:spPr>
              <a:xfrm rot="16200000">
                <a:off x="5697072" y="790658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4" name="Group 93"/>
            <p:cNvGrpSpPr/>
            <p:nvPr/>
          </p:nvGrpSpPr>
          <p:grpSpPr>
            <a:xfrm>
              <a:off x="5843847" y="1391328"/>
              <a:ext cx="76266" cy="76266"/>
              <a:chOff x="5843847" y="752525"/>
              <a:chExt cx="76266" cy="76266"/>
            </a:xfrm>
          </p:grpSpPr>
          <p:cxnSp>
            <p:nvCxnSpPr>
              <p:cNvPr id="342" name="Straight Connector 341"/>
              <p:cNvCxnSpPr/>
              <p:nvPr/>
            </p:nvCxnSpPr>
            <p:spPr>
              <a:xfrm>
                <a:off x="5843847" y="790658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3" name="Straight Connector 342"/>
              <p:cNvCxnSpPr/>
              <p:nvPr/>
            </p:nvCxnSpPr>
            <p:spPr>
              <a:xfrm rot="16200000">
                <a:off x="5843847" y="790658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5" name="Right Bracket 94"/>
            <p:cNvSpPr/>
            <p:nvPr/>
          </p:nvSpPr>
          <p:spPr>
            <a:xfrm rot="5400000" flipH="1" flipV="1">
              <a:off x="4557319" y="1008276"/>
              <a:ext cx="45719" cy="731461"/>
            </a:xfrm>
            <a:prstGeom prst="rightBracket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96" name="Straight Connector 95"/>
            <p:cNvCxnSpPr/>
            <p:nvPr/>
          </p:nvCxnSpPr>
          <p:spPr>
            <a:xfrm>
              <a:off x="4816422" y="1949676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7" name="Group 96"/>
            <p:cNvGrpSpPr/>
            <p:nvPr/>
          </p:nvGrpSpPr>
          <p:grpSpPr>
            <a:xfrm>
              <a:off x="4229322" y="1911543"/>
              <a:ext cx="76266" cy="76266"/>
              <a:chOff x="4229322" y="1272740"/>
              <a:chExt cx="76266" cy="76266"/>
            </a:xfrm>
          </p:grpSpPr>
          <p:cxnSp>
            <p:nvCxnSpPr>
              <p:cNvPr id="340" name="Straight Connector 339"/>
              <p:cNvCxnSpPr/>
              <p:nvPr/>
            </p:nvCxnSpPr>
            <p:spPr>
              <a:xfrm>
                <a:off x="4229322" y="1310873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1" name="Straight Connector 340"/>
              <p:cNvCxnSpPr/>
              <p:nvPr/>
            </p:nvCxnSpPr>
            <p:spPr>
              <a:xfrm rot="16200000">
                <a:off x="4229322" y="1310873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8" name="Straight Connector 97"/>
            <p:cNvCxnSpPr/>
            <p:nvPr/>
          </p:nvCxnSpPr>
          <p:spPr>
            <a:xfrm>
              <a:off x="4522872" y="1949676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Straight Connector 98"/>
            <p:cNvCxnSpPr/>
            <p:nvPr/>
          </p:nvCxnSpPr>
          <p:spPr>
            <a:xfrm>
              <a:off x="4669647" y="1949676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Straight Connector 99"/>
            <p:cNvCxnSpPr/>
            <p:nvPr/>
          </p:nvCxnSpPr>
          <p:spPr>
            <a:xfrm>
              <a:off x="4963197" y="1949676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1" name="Group 100"/>
            <p:cNvGrpSpPr/>
            <p:nvPr/>
          </p:nvGrpSpPr>
          <p:grpSpPr>
            <a:xfrm>
              <a:off x="5403522" y="1911543"/>
              <a:ext cx="76266" cy="76266"/>
              <a:chOff x="5403522" y="1272740"/>
              <a:chExt cx="76266" cy="76266"/>
            </a:xfrm>
          </p:grpSpPr>
          <p:cxnSp>
            <p:nvCxnSpPr>
              <p:cNvPr id="338" name="Straight Connector 337"/>
              <p:cNvCxnSpPr/>
              <p:nvPr/>
            </p:nvCxnSpPr>
            <p:spPr>
              <a:xfrm>
                <a:off x="5403522" y="1310873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9" name="Straight Connector 338"/>
              <p:cNvCxnSpPr/>
              <p:nvPr/>
            </p:nvCxnSpPr>
            <p:spPr>
              <a:xfrm rot="16200000">
                <a:off x="5403522" y="1310873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2" name="Straight Connector 101"/>
            <p:cNvCxnSpPr/>
            <p:nvPr/>
          </p:nvCxnSpPr>
          <p:spPr>
            <a:xfrm>
              <a:off x="5843847" y="1949676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3" name="Group 102"/>
            <p:cNvGrpSpPr/>
            <p:nvPr/>
          </p:nvGrpSpPr>
          <p:grpSpPr>
            <a:xfrm>
              <a:off x="5256747" y="1911543"/>
              <a:ext cx="76266" cy="76266"/>
              <a:chOff x="5256747" y="1272740"/>
              <a:chExt cx="76266" cy="76266"/>
            </a:xfrm>
          </p:grpSpPr>
          <p:cxnSp>
            <p:nvCxnSpPr>
              <p:cNvPr id="336" name="Straight Connector 335"/>
              <p:cNvCxnSpPr/>
              <p:nvPr/>
            </p:nvCxnSpPr>
            <p:spPr>
              <a:xfrm>
                <a:off x="5256747" y="1310873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7" name="Straight Connector 336"/>
              <p:cNvCxnSpPr/>
              <p:nvPr/>
            </p:nvCxnSpPr>
            <p:spPr>
              <a:xfrm rot="16200000">
                <a:off x="5256747" y="1310873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4" name="Straight Connector 103"/>
            <p:cNvCxnSpPr/>
            <p:nvPr/>
          </p:nvCxnSpPr>
          <p:spPr>
            <a:xfrm>
              <a:off x="5550297" y="1949676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Straight Connector 104"/>
            <p:cNvCxnSpPr/>
            <p:nvPr/>
          </p:nvCxnSpPr>
          <p:spPr>
            <a:xfrm>
              <a:off x="5697072" y="1949676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105"/>
            <p:cNvCxnSpPr/>
            <p:nvPr/>
          </p:nvCxnSpPr>
          <p:spPr>
            <a:xfrm>
              <a:off x="4376097" y="1949676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7" name="Group 106"/>
            <p:cNvGrpSpPr/>
            <p:nvPr/>
          </p:nvGrpSpPr>
          <p:grpSpPr>
            <a:xfrm>
              <a:off x="5109972" y="1911543"/>
              <a:ext cx="76266" cy="76266"/>
              <a:chOff x="5109972" y="1272740"/>
              <a:chExt cx="76266" cy="76266"/>
            </a:xfrm>
          </p:grpSpPr>
          <p:cxnSp>
            <p:nvCxnSpPr>
              <p:cNvPr id="334" name="Straight Connector 333"/>
              <p:cNvCxnSpPr/>
              <p:nvPr/>
            </p:nvCxnSpPr>
            <p:spPr>
              <a:xfrm>
                <a:off x="5109972" y="1310873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5" name="Straight Connector 334"/>
              <p:cNvCxnSpPr/>
              <p:nvPr/>
            </p:nvCxnSpPr>
            <p:spPr>
              <a:xfrm rot="16200000">
                <a:off x="5109972" y="1310873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8" name="TextBox 107"/>
            <p:cNvSpPr txBox="1"/>
            <p:nvPr/>
          </p:nvSpPr>
          <p:spPr>
            <a:xfrm rot="18764870">
              <a:off x="5699866" y="1549160"/>
              <a:ext cx="543739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40-120</a:t>
              </a:r>
              <a:endParaRPr lang="en-US" sz="900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 rot="18764870">
              <a:off x="5564072" y="1549160"/>
              <a:ext cx="543739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20-120</a:t>
              </a:r>
              <a:endParaRPr lang="en-US" sz="900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 rot="18764870">
              <a:off x="5450843" y="1621434"/>
              <a:ext cx="377026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120</a:t>
              </a:r>
              <a:endParaRPr lang="en-US" sz="900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 rot="18764870">
              <a:off x="5251672" y="1501467"/>
              <a:ext cx="673632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40-120</a:t>
              </a:r>
              <a:endParaRPr lang="en-US" sz="900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 rot="18764870">
              <a:off x="5124834" y="1549160"/>
              <a:ext cx="543739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20-120</a:t>
              </a:r>
              <a:endParaRPr lang="en-US" sz="900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 rot="18764870">
              <a:off x="5011492" y="1621434"/>
              <a:ext cx="377026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120</a:t>
              </a:r>
              <a:endParaRPr lang="en-US" sz="900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 rot="18764870">
              <a:off x="4624366" y="1549160"/>
              <a:ext cx="543739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40-120</a:t>
              </a:r>
              <a:endParaRPr lang="en-US" sz="900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 rot="18764870">
              <a:off x="4482859" y="1549160"/>
              <a:ext cx="543739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20-120</a:t>
              </a:r>
              <a:endParaRPr lang="en-US" sz="900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6" name="TextBox 115"/>
            <p:cNvSpPr txBox="1"/>
            <p:nvPr/>
          </p:nvSpPr>
          <p:spPr>
            <a:xfrm rot="18764870">
              <a:off x="4377705" y="1621434"/>
              <a:ext cx="377026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120</a:t>
              </a:r>
              <a:endParaRPr lang="en-US" sz="900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cxnSp>
          <p:nvCxnSpPr>
            <p:cNvPr id="117" name="Straight Connector 116"/>
            <p:cNvCxnSpPr/>
            <p:nvPr/>
          </p:nvCxnSpPr>
          <p:spPr>
            <a:xfrm>
              <a:off x="4229322" y="1687604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Straight Connector 117"/>
            <p:cNvCxnSpPr/>
            <p:nvPr/>
          </p:nvCxnSpPr>
          <p:spPr>
            <a:xfrm>
              <a:off x="4963197" y="1687604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Straight Connector 118"/>
            <p:cNvCxnSpPr/>
            <p:nvPr/>
          </p:nvCxnSpPr>
          <p:spPr>
            <a:xfrm>
              <a:off x="4376097" y="1687604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TextBox 119"/>
            <p:cNvSpPr txBox="1"/>
            <p:nvPr/>
          </p:nvSpPr>
          <p:spPr>
            <a:xfrm>
              <a:off x="4114800" y="1129268"/>
              <a:ext cx="886760" cy="246221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put (20%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0" y="3214609"/>
              <a:ext cx="407484" cy="461665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3296885" y="3214101"/>
              <a:ext cx="407484" cy="461665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pic>
          <p:nvPicPr>
            <p:cNvPr id="123" name="Picture 5" descr="E:\Study\Lab\Manuscript\Back-up folder\Back-up20130906 Detail-Figure\2D.jp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03" r="4285"/>
            <a:stretch/>
          </p:blipFill>
          <p:spPr bwMode="auto">
            <a:xfrm>
              <a:off x="4063946" y="4411105"/>
              <a:ext cx="2194313" cy="20825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4" name="TextBox 123"/>
            <p:cNvSpPr txBox="1"/>
            <p:nvPr/>
          </p:nvSpPr>
          <p:spPr>
            <a:xfrm>
              <a:off x="3188163" y="3691280"/>
              <a:ext cx="912250" cy="246221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ST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Rad27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3075098" y="3946953"/>
              <a:ext cx="1025316" cy="246221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s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Mus81-</a:t>
              </a: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F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3200400" y="5307132"/>
              <a:ext cx="8546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ne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3490304" y="4419444"/>
              <a:ext cx="6101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0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α</a:t>
              </a:r>
              <a:r>
                <a:rPr lang="en-US" sz="10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-Hi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3490304" y="4910943"/>
              <a:ext cx="6101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0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α</a:t>
              </a:r>
              <a:r>
                <a:rPr lang="en-US" sz="10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-GS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4034750" y="5307132"/>
              <a:ext cx="2564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4176513" y="5307132"/>
              <a:ext cx="2564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4325600" y="5307132"/>
              <a:ext cx="2564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4474686" y="5307132"/>
              <a:ext cx="2564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4629769" y="5307132"/>
              <a:ext cx="2564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4772859" y="5307132"/>
              <a:ext cx="2564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4921946" y="5307132"/>
              <a:ext cx="2564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5071032" y="5307132"/>
              <a:ext cx="2564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5206400" y="5307132"/>
              <a:ext cx="2564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5178755" y="5307132"/>
              <a:ext cx="5949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5331125" y="5307132"/>
              <a:ext cx="5936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3433107" y="4211494"/>
              <a:ext cx="667307" cy="246221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S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5437021" y="5307132"/>
              <a:ext cx="6635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4060961" y="3481222"/>
              <a:ext cx="876889" cy="246221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put (20%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3" name="Straight Connector 142"/>
            <p:cNvCxnSpPr/>
            <p:nvPr/>
          </p:nvCxnSpPr>
          <p:spPr>
            <a:xfrm>
              <a:off x="4101335" y="3811248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4" name="Group 143"/>
            <p:cNvGrpSpPr/>
            <p:nvPr/>
          </p:nvGrpSpPr>
          <p:grpSpPr>
            <a:xfrm>
              <a:off x="4247728" y="3773115"/>
              <a:ext cx="76266" cy="76266"/>
              <a:chOff x="4383028" y="2915055"/>
              <a:chExt cx="76266" cy="76266"/>
            </a:xfrm>
          </p:grpSpPr>
          <p:cxnSp>
            <p:nvCxnSpPr>
              <p:cNvPr id="332" name="Straight Connector 331"/>
              <p:cNvCxnSpPr/>
              <p:nvPr/>
            </p:nvCxnSpPr>
            <p:spPr>
              <a:xfrm>
                <a:off x="4383028" y="2953188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3" name="Straight Connector 332"/>
              <p:cNvCxnSpPr/>
              <p:nvPr/>
            </p:nvCxnSpPr>
            <p:spPr>
              <a:xfrm rot="16200000">
                <a:off x="4383028" y="2953188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45" name="Straight Connector 144"/>
            <p:cNvCxnSpPr/>
            <p:nvPr/>
          </p:nvCxnSpPr>
          <p:spPr>
            <a:xfrm>
              <a:off x="4394122" y="3811248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Straight Connector 145"/>
            <p:cNvCxnSpPr/>
            <p:nvPr/>
          </p:nvCxnSpPr>
          <p:spPr>
            <a:xfrm>
              <a:off x="4540515" y="3811248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Straight Connector 146"/>
            <p:cNvCxnSpPr/>
            <p:nvPr/>
          </p:nvCxnSpPr>
          <p:spPr>
            <a:xfrm>
              <a:off x="4686908" y="3811248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8" name="Group 147"/>
            <p:cNvGrpSpPr/>
            <p:nvPr/>
          </p:nvGrpSpPr>
          <p:grpSpPr>
            <a:xfrm>
              <a:off x="4976547" y="3773115"/>
              <a:ext cx="76266" cy="76266"/>
              <a:chOff x="5111847" y="2915055"/>
              <a:chExt cx="76266" cy="76266"/>
            </a:xfrm>
          </p:grpSpPr>
          <p:cxnSp>
            <p:nvCxnSpPr>
              <p:cNvPr id="330" name="Straight Connector 329"/>
              <p:cNvCxnSpPr/>
              <p:nvPr/>
            </p:nvCxnSpPr>
            <p:spPr>
              <a:xfrm>
                <a:off x="5111847" y="2953188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1" name="Straight Connector 330"/>
              <p:cNvCxnSpPr/>
              <p:nvPr/>
            </p:nvCxnSpPr>
            <p:spPr>
              <a:xfrm rot="16200000">
                <a:off x="5111847" y="2953188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49" name="Straight Connector 148"/>
            <p:cNvCxnSpPr/>
            <p:nvPr/>
          </p:nvCxnSpPr>
          <p:spPr>
            <a:xfrm>
              <a:off x="5122940" y="3811248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Straight Connector 149"/>
            <p:cNvCxnSpPr/>
            <p:nvPr/>
          </p:nvCxnSpPr>
          <p:spPr>
            <a:xfrm>
              <a:off x="5269333" y="3811248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Straight Connector 150"/>
            <p:cNvCxnSpPr/>
            <p:nvPr/>
          </p:nvCxnSpPr>
          <p:spPr>
            <a:xfrm>
              <a:off x="5415727" y="3811248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Straight Connector 151"/>
            <p:cNvCxnSpPr/>
            <p:nvPr/>
          </p:nvCxnSpPr>
          <p:spPr>
            <a:xfrm>
              <a:off x="5562120" y="3811248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53" name="Group 152"/>
            <p:cNvGrpSpPr/>
            <p:nvPr/>
          </p:nvGrpSpPr>
          <p:grpSpPr>
            <a:xfrm>
              <a:off x="5708513" y="3773115"/>
              <a:ext cx="76266" cy="76266"/>
              <a:chOff x="5843813" y="2915055"/>
              <a:chExt cx="76266" cy="76266"/>
            </a:xfrm>
          </p:grpSpPr>
          <p:cxnSp>
            <p:nvCxnSpPr>
              <p:cNvPr id="328" name="Straight Connector 327"/>
              <p:cNvCxnSpPr/>
              <p:nvPr/>
            </p:nvCxnSpPr>
            <p:spPr>
              <a:xfrm>
                <a:off x="5843813" y="2953188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9" name="Straight Connector 328"/>
              <p:cNvCxnSpPr/>
              <p:nvPr/>
            </p:nvCxnSpPr>
            <p:spPr>
              <a:xfrm rot="16200000">
                <a:off x="5843813" y="2953188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" name="Group 153"/>
            <p:cNvGrpSpPr/>
            <p:nvPr/>
          </p:nvGrpSpPr>
          <p:grpSpPr>
            <a:xfrm>
              <a:off x="5854907" y="3773115"/>
              <a:ext cx="76266" cy="76266"/>
              <a:chOff x="5990207" y="2915055"/>
              <a:chExt cx="76266" cy="76266"/>
            </a:xfrm>
          </p:grpSpPr>
          <p:cxnSp>
            <p:nvCxnSpPr>
              <p:cNvPr id="326" name="Straight Connector 325"/>
              <p:cNvCxnSpPr/>
              <p:nvPr/>
            </p:nvCxnSpPr>
            <p:spPr>
              <a:xfrm>
                <a:off x="5990207" y="2953188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7" name="Straight Connector 326"/>
              <p:cNvCxnSpPr/>
              <p:nvPr/>
            </p:nvCxnSpPr>
            <p:spPr>
              <a:xfrm rot="16200000">
                <a:off x="5990207" y="2953188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5" name="Right Bracket 154"/>
            <p:cNvSpPr/>
            <p:nvPr/>
          </p:nvSpPr>
          <p:spPr>
            <a:xfrm rot="5400000" flipH="1" flipV="1">
              <a:off x="4476727" y="3298180"/>
              <a:ext cx="45719" cy="877252"/>
            </a:xfrm>
            <a:prstGeom prst="rightBracket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900"/>
            </a:p>
          </p:txBody>
        </p:sp>
        <p:cxnSp>
          <p:nvCxnSpPr>
            <p:cNvPr id="156" name="Straight Connector 155"/>
            <p:cNvCxnSpPr/>
            <p:nvPr/>
          </p:nvCxnSpPr>
          <p:spPr>
            <a:xfrm>
              <a:off x="4686908" y="4331462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57" name="Group 156"/>
            <p:cNvGrpSpPr/>
            <p:nvPr/>
          </p:nvGrpSpPr>
          <p:grpSpPr>
            <a:xfrm>
              <a:off x="4101335" y="4293330"/>
              <a:ext cx="76266" cy="76266"/>
              <a:chOff x="4236635" y="3435270"/>
              <a:chExt cx="76266" cy="76266"/>
            </a:xfrm>
          </p:grpSpPr>
          <p:cxnSp>
            <p:nvCxnSpPr>
              <p:cNvPr id="324" name="Straight Connector 323"/>
              <p:cNvCxnSpPr/>
              <p:nvPr/>
            </p:nvCxnSpPr>
            <p:spPr>
              <a:xfrm>
                <a:off x="4236635" y="3473403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5" name="Straight Connector 324"/>
              <p:cNvCxnSpPr/>
              <p:nvPr/>
            </p:nvCxnSpPr>
            <p:spPr>
              <a:xfrm rot="16200000">
                <a:off x="4236635" y="3473403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58" name="Straight Connector 157"/>
            <p:cNvCxnSpPr/>
            <p:nvPr/>
          </p:nvCxnSpPr>
          <p:spPr>
            <a:xfrm>
              <a:off x="4394122" y="4331462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Straight Connector 158"/>
            <p:cNvCxnSpPr/>
            <p:nvPr/>
          </p:nvCxnSpPr>
          <p:spPr>
            <a:xfrm>
              <a:off x="4540515" y="4331462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Straight Connector 159"/>
            <p:cNvCxnSpPr/>
            <p:nvPr/>
          </p:nvCxnSpPr>
          <p:spPr>
            <a:xfrm>
              <a:off x="4976547" y="4331462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61" name="Group 160"/>
            <p:cNvGrpSpPr/>
            <p:nvPr/>
          </p:nvGrpSpPr>
          <p:grpSpPr>
            <a:xfrm>
              <a:off x="5415727" y="4293330"/>
              <a:ext cx="76266" cy="76266"/>
              <a:chOff x="5551027" y="3435270"/>
              <a:chExt cx="76266" cy="76266"/>
            </a:xfrm>
          </p:grpSpPr>
          <p:cxnSp>
            <p:nvCxnSpPr>
              <p:cNvPr id="322" name="Straight Connector 321"/>
              <p:cNvCxnSpPr/>
              <p:nvPr/>
            </p:nvCxnSpPr>
            <p:spPr>
              <a:xfrm>
                <a:off x="5551027" y="3473403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3" name="Straight Connector 322"/>
              <p:cNvCxnSpPr/>
              <p:nvPr/>
            </p:nvCxnSpPr>
            <p:spPr>
              <a:xfrm rot="16200000">
                <a:off x="5551027" y="3473403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62" name="Straight Connector 161"/>
            <p:cNvCxnSpPr/>
            <p:nvPr/>
          </p:nvCxnSpPr>
          <p:spPr>
            <a:xfrm>
              <a:off x="5854907" y="4331462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63" name="Group 162"/>
            <p:cNvGrpSpPr/>
            <p:nvPr/>
          </p:nvGrpSpPr>
          <p:grpSpPr>
            <a:xfrm>
              <a:off x="5269333" y="4293330"/>
              <a:ext cx="76266" cy="76266"/>
              <a:chOff x="5404633" y="3435270"/>
              <a:chExt cx="76266" cy="76266"/>
            </a:xfrm>
          </p:grpSpPr>
          <p:cxnSp>
            <p:nvCxnSpPr>
              <p:cNvPr id="320" name="Straight Connector 319"/>
              <p:cNvCxnSpPr/>
              <p:nvPr/>
            </p:nvCxnSpPr>
            <p:spPr>
              <a:xfrm>
                <a:off x="5404633" y="3473403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1" name="Straight Connector 320"/>
              <p:cNvCxnSpPr/>
              <p:nvPr/>
            </p:nvCxnSpPr>
            <p:spPr>
              <a:xfrm rot="16200000">
                <a:off x="5404633" y="3473403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64" name="Straight Connector 163"/>
            <p:cNvCxnSpPr/>
            <p:nvPr/>
          </p:nvCxnSpPr>
          <p:spPr>
            <a:xfrm>
              <a:off x="5708513" y="4331462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Straight Connector 164"/>
            <p:cNvCxnSpPr/>
            <p:nvPr/>
          </p:nvCxnSpPr>
          <p:spPr>
            <a:xfrm>
              <a:off x="4247728" y="4331462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66" name="Group 165"/>
            <p:cNvGrpSpPr/>
            <p:nvPr/>
          </p:nvGrpSpPr>
          <p:grpSpPr>
            <a:xfrm>
              <a:off x="5122940" y="4293330"/>
              <a:ext cx="76266" cy="76266"/>
              <a:chOff x="5258240" y="3435270"/>
              <a:chExt cx="76266" cy="76266"/>
            </a:xfrm>
          </p:grpSpPr>
          <p:cxnSp>
            <p:nvCxnSpPr>
              <p:cNvPr id="318" name="Straight Connector 317"/>
              <p:cNvCxnSpPr/>
              <p:nvPr/>
            </p:nvCxnSpPr>
            <p:spPr>
              <a:xfrm>
                <a:off x="5258240" y="3473403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9" name="Straight Connector 318"/>
              <p:cNvCxnSpPr/>
              <p:nvPr/>
            </p:nvCxnSpPr>
            <p:spPr>
              <a:xfrm rot="16200000">
                <a:off x="5258240" y="3473403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67" name="Straight Connector 166"/>
            <p:cNvCxnSpPr/>
            <p:nvPr/>
          </p:nvCxnSpPr>
          <p:spPr>
            <a:xfrm>
              <a:off x="4101335" y="4069391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Straight Connector 167"/>
            <p:cNvCxnSpPr/>
            <p:nvPr/>
          </p:nvCxnSpPr>
          <p:spPr>
            <a:xfrm>
              <a:off x="4976547" y="4069391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Straight Connector 168"/>
            <p:cNvCxnSpPr/>
            <p:nvPr/>
          </p:nvCxnSpPr>
          <p:spPr>
            <a:xfrm>
              <a:off x="4247728" y="4069391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Straight Connector 169"/>
            <p:cNvCxnSpPr/>
            <p:nvPr/>
          </p:nvCxnSpPr>
          <p:spPr>
            <a:xfrm>
              <a:off x="4841701" y="3811651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Straight Connector 170"/>
            <p:cNvCxnSpPr/>
            <p:nvPr/>
          </p:nvCxnSpPr>
          <p:spPr>
            <a:xfrm>
              <a:off x="4841701" y="4331866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2" name="Group 171"/>
            <p:cNvGrpSpPr/>
            <p:nvPr/>
          </p:nvGrpSpPr>
          <p:grpSpPr>
            <a:xfrm>
              <a:off x="6002576" y="3775099"/>
              <a:ext cx="76266" cy="76266"/>
              <a:chOff x="6137876" y="2917039"/>
              <a:chExt cx="76266" cy="76266"/>
            </a:xfrm>
          </p:grpSpPr>
          <p:cxnSp>
            <p:nvCxnSpPr>
              <p:cNvPr id="316" name="Straight Connector 315"/>
              <p:cNvCxnSpPr/>
              <p:nvPr/>
            </p:nvCxnSpPr>
            <p:spPr>
              <a:xfrm>
                <a:off x="6137876" y="2955172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7" name="Straight Connector 316"/>
              <p:cNvCxnSpPr/>
              <p:nvPr/>
            </p:nvCxnSpPr>
            <p:spPr>
              <a:xfrm rot="16200000">
                <a:off x="6137876" y="2955172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3" name="Group 172"/>
            <p:cNvGrpSpPr/>
            <p:nvPr/>
          </p:nvGrpSpPr>
          <p:grpSpPr>
            <a:xfrm>
              <a:off x="6144758" y="3775099"/>
              <a:ext cx="76266" cy="76266"/>
              <a:chOff x="6280058" y="2917039"/>
              <a:chExt cx="76266" cy="76266"/>
            </a:xfrm>
          </p:grpSpPr>
          <p:cxnSp>
            <p:nvCxnSpPr>
              <p:cNvPr id="314" name="Straight Connector 313"/>
              <p:cNvCxnSpPr/>
              <p:nvPr/>
            </p:nvCxnSpPr>
            <p:spPr>
              <a:xfrm>
                <a:off x="6280058" y="2955172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5" name="Straight Connector 314"/>
              <p:cNvCxnSpPr/>
              <p:nvPr/>
            </p:nvCxnSpPr>
            <p:spPr>
              <a:xfrm rot="16200000">
                <a:off x="6280058" y="2955172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74" name="Straight Connector 173"/>
            <p:cNvCxnSpPr/>
            <p:nvPr/>
          </p:nvCxnSpPr>
          <p:spPr>
            <a:xfrm>
              <a:off x="6144758" y="4333446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Straight Connector 174"/>
            <p:cNvCxnSpPr/>
            <p:nvPr/>
          </p:nvCxnSpPr>
          <p:spPr>
            <a:xfrm>
              <a:off x="6002576" y="4333446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6" name="TextBox 175"/>
            <p:cNvSpPr txBox="1"/>
            <p:nvPr/>
          </p:nvSpPr>
          <p:spPr>
            <a:xfrm rot="18976411">
              <a:off x="4088691" y="3808367"/>
              <a:ext cx="940037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12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TextBox 176"/>
            <p:cNvSpPr txBox="1"/>
            <p:nvPr/>
          </p:nvSpPr>
          <p:spPr>
            <a:xfrm rot="18976411">
              <a:off x="4269373" y="3879046"/>
              <a:ext cx="735530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6-12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TextBox 177"/>
            <p:cNvSpPr txBox="1"/>
            <p:nvPr/>
          </p:nvSpPr>
          <p:spPr>
            <a:xfrm rot="18976411">
              <a:off x="4393333" y="3808367"/>
              <a:ext cx="940037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-12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TextBox 178"/>
            <p:cNvSpPr txBox="1"/>
            <p:nvPr/>
          </p:nvSpPr>
          <p:spPr>
            <a:xfrm rot="18976411">
              <a:off x="4545652" y="3808367"/>
              <a:ext cx="940037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-12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TextBox 179"/>
            <p:cNvSpPr txBox="1"/>
            <p:nvPr/>
          </p:nvSpPr>
          <p:spPr>
            <a:xfrm rot="18976411">
              <a:off x="4866590" y="3915260"/>
              <a:ext cx="607424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12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TextBox 180"/>
            <p:cNvSpPr txBox="1"/>
            <p:nvPr/>
          </p:nvSpPr>
          <p:spPr>
            <a:xfrm rot="18976411">
              <a:off x="5005103" y="3877320"/>
              <a:ext cx="725479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6-12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TextBox 181"/>
            <p:cNvSpPr txBox="1"/>
            <p:nvPr/>
          </p:nvSpPr>
          <p:spPr>
            <a:xfrm rot="18976411">
              <a:off x="5132328" y="3808367"/>
              <a:ext cx="940037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-12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TextBox 182"/>
            <p:cNvSpPr txBox="1"/>
            <p:nvPr/>
          </p:nvSpPr>
          <p:spPr>
            <a:xfrm rot="18976411">
              <a:off x="5284648" y="3808367"/>
              <a:ext cx="940037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-12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TextBox 183"/>
            <p:cNvSpPr txBox="1"/>
            <p:nvPr/>
          </p:nvSpPr>
          <p:spPr>
            <a:xfrm rot="18976411">
              <a:off x="5425951" y="3808367"/>
              <a:ext cx="940037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-12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TextBox 184"/>
            <p:cNvSpPr txBox="1"/>
            <p:nvPr/>
          </p:nvSpPr>
          <p:spPr>
            <a:xfrm rot="18976411">
              <a:off x="5578271" y="3808367"/>
              <a:ext cx="940037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6-12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TextBox 185"/>
            <p:cNvSpPr txBox="1"/>
            <p:nvPr/>
          </p:nvSpPr>
          <p:spPr>
            <a:xfrm rot="18976411">
              <a:off x="5767569" y="3906023"/>
              <a:ext cx="644555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-12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TextBox 186"/>
            <p:cNvSpPr txBox="1"/>
            <p:nvPr/>
          </p:nvSpPr>
          <p:spPr>
            <a:xfrm rot="18976411">
              <a:off x="5929796" y="3934006"/>
              <a:ext cx="55585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-12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TextBox 187"/>
            <p:cNvSpPr txBox="1"/>
            <p:nvPr/>
          </p:nvSpPr>
          <p:spPr>
            <a:xfrm>
              <a:off x="5629975" y="5307132"/>
              <a:ext cx="5949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TextBox 188"/>
            <p:cNvSpPr txBox="1"/>
            <p:nvPr/>
          </p:nvSpPr>
          <p:spPr>
            <a:xfrm>
              <a:off x="5793220" y="5307132"/>
              <a:ext cx="5588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TextBox 189"/>
            <p:cNvSpPr txBox="1"/>
            <p:nvPr/>
          </p:nvSpPr>
          <p:spPr>
            <a:xfrm>
              <a:off x="5937598" y="5307132"/>
              <a:ext cx="5394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1" name="Group 190"/>
            <p:cNvGrpSpPr/>
            <p:nvPr/>
          </p:nvGrpSpPr>
          <p:grpSpPr>
            <a:xfrm>
              <a:off x="5562383" y="4295314"/>
              <a:ext cx="76266" cy="76266"/>
              <a:chOff x="5697683" y="3437254"/>
              <a:chExt cx="76266" cy="76266"/>
            </a:xfrm>
          </p:grpSpPr>
          <p:cxnSp>
            <p:nvCxnSpPr>
              <p:cNvPr id="312" name="Straight Connector 311"/>
              <p:cNvCxnSpPr/>
              <p:nvPr/>
            </p:nvCxnSpPr>
            <p:spPr>
              <a:xfrm>
                <a:off x="5697683" y="3475387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3" name="Straight Connector 312"/>
              <p:cNvCxnSpPr/>
              <p:nvPr/>
            </p:nvCxnSpPr>
            <p:spPr>
              <a:xfrm rot="16200000">
                <a:off x="5697683" y="3475387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2" name="TextBox 191"/>
            <p:cNvSpPr txBox="1"/>
            <p:nvPr/>
          </p:nvSpPr>
          <p:spPr>
            <a:xfrm rot="18881069">
              <a:off x="2619188" y="3923575"/>
              <a:ext cx="468763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7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TextBox 192"/>
            <p:cNvSpPr txBox="1"/>
            <p:nvPr/>
          </p:nvSpPr>
          <p:spPr>
            <a:xfrm rot="18881069">
              <a:off x="2746469" y="3896059"/>
              <a:ext cx="530941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4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TextBox 193"/>
            <p:cNvSpPr txBox="1"/>
            <p:nvPr/>
          </p:nvSpPr>
          <p:spPr>
            <a:xfrm rot="18881069">
              <a:off x="2909306" y="3951955"/>
              <a:ext cx="388930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95" name="Picture 7" descr="E:\Study\Lab\Manuscript\Back-up folder\Back-up20130906 Detail-Figure\2C.jpg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48" b="16144"/>
            <a:stretch/>
          </p:blipFill>
          <p:spPr bwMode="auto">
            <a:xfrm>
              <a:off x="906242" y="4411105"/>
              <a:ext cx="2204156" cy="20825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96" name="TextBox 195"/>
            <p:cNvSpPr txBox="1"/>
            <p:nvPr/>
          </p:nvSpPr>
          <p:spPr>
            <a:xfrm>
              <a:off x="42235" y="3691788"/>
              <a:ext cx="912250" cy="246221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ST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Rad27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TextBox 196"/>
            <p:cNvSpPr txBox="1"/>
            <p:nvPr/>
          </p:nvSpPr>
          <p:spPr>
            <a:xfrm>
              <a:off x="0" y="3945284"/>
              <a:ext cx="954486" cy="246221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s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Mus81-</a:t>
              </a: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F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TextBox 197"/>
            <p:cNvSpPr txBox="1"/>
            <p:nvPr/>
          </p:nvSpPr>
          <p:spPr>
            <a:xfrm>
              <a:off x="124330" y="5307132"/>
              <a:ext cx="8301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ane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TextBox 198"/>
            <p:cNvSpPr txBox="1"/>
            <p:nvPr/>
          </p:nvSpPr>
          <p:spPr>
            <a:xfrm>
              <a:off x="344376" y="4419953"/>
              <a:ext cx="6101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0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α</a:t>
              </a:r>
              <a:r>
                <a:rPr lang="en-US" sz="10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-Hi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TextBox 199"/>
            <p:cNvSpPr txBox="1"/>
            <p:nvPr/>
          </p:nvSpPr>
          <p:spPr>
            <a:xfrm>
              <a:off x="344376" y="4886572"/>
              <a:ext cx="6101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sz="10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α</a:t>
              </a:r>
              <a:r>
                <a:rPr lang="en-US" sz="10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-GS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TextBox 200"/>
            <p:cNvSpPr txBox="1"/>
            <p:nvPr/>
          </p:nvSpPr>
          <p:spPr>
            <a:xfrm>
              <a:off x="873008" y="5307132"/>
              <a:ext cx="2135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" name="TextBox 201"/>
            <p:cNvSpPr txBox="1"/>
            <p:nvPr/>
          </p:nvSpPr>
          <p:spPr>
            <a:xfrm>
              <a:off x="1014772" y="5307132"/>
              <a:ext cx="2135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203" name="TextBox 202"/>
            <p:cNvSpPr txBox="1"/>
            <p:nvPr/>
          </p:nvSpPr>
          <p:spPr>
            <a:xfrm>
              <a:off x="1163858" y="5307132"/>
              <a:ext cx="2135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TextBox 203"/>
            <p:cNvSpPr txBox="1"/>
            <p:nvPr/>
          </p:nvSpPr>
          <p:spPr>
            <a:xfrm>
              <a:off x="1312945" y="5307132"/>
              <a:ext cx="2135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TextBox 204"/>
            <p:cNvSpPr txBox="1"/>
            <p:nvPr/>
          </p:nvSpPr>
          <p:spPr>
            <a:xfrm>
              <a:off x="1468028" y="5307132"/>
              <a:ext cx="2135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TextBox 205"/>
            <p:cNvSpPr txBox="1"/>
            <p:nvPr/>
          </p:nvSpPr>
          <p:spPr>
            <a:xfrm>
              <a:off x="1611117" y="5307132"/>
              <a:ext cx="2135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207" name="TextBox 206"/>
            <p:cNvSpPr txBox="1"/>
            <p:nvPr/>
          </p:nvSpPr>
          <p:spPr>
            <a:xfrm>
              <a:off x="1760204" y="5307132"/>
              <a:ext cx="2135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TextBox 207"/>
            <p:cNvSpPr txBox="1"/>
            <p:nvPr/>
          </p:nvSpPr>
          <p:spPr>
            <a:xfrm>
              <a:off x="1909290" y="5307132"/>
              <a:ext cx="2135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TextBox 208"/>
            <p:cNvSpPr txBox="1"/>
            <p:nvPr/>
          </p:nvSpPr>
          <p:spPr>
            <a:xfrm>
              <a:off x="2031020" y="5307132"/>
              <a:ext cx="2735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210" name="TextBox 209"/>
            <p:cNvSpPr txBox="1"/>
            <p:nvPr/>
          </p:nvSpPr>
          <p:spPr>
            <a:xfrm>
              <a:off x="2026515" y="5307132"/>
              <a:ext cx="5579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TextBox 210"/>
            <p:cNvSpPr txBox="1"/>
            <p:nvPr/>
          </p:nvSpPr>
          <p:spPr>
            <a:xfrm>
              <a:off x="2219408" y="5307132"/>
              <a:ext cx="48230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TextBox 211"/>
            <p:cNvSpPr txBox="1"/>
            <p:nvPr/>
          </p:nvSpPr>
          <p:spPr>
            <a:xfrm>
              <a:off x="287179" y="4212003"/>
              <a:ext cx="667307" cy="246221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S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TextBox 212"/>
            <p:cNvSpPr txBox="1"/>
            <p:nvPr/>
          </p:nvSpPr>
          <p:spPr>
            <a:xfrm>
              <a:off x="2367004" y="5307132"/>
              <a:ext cx="4551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TextBox 213"/>
            <p:cNvSpPr txBox="1"/>
            <p:nvPr/>
          </p:nvSpPr>
          <p:spPr>
            <a:xfrm>
              <a:off x="915033" y="3481736"/>
              <a:ext cx="876889" cy="246221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put (20%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5" name="Straight Connector 214"/>
            <p:cNvCxnSpPr/>
            <p:nvPr/>
          </p:nvCxnSpPr>
          <p:spPr>
            <a:xfrm>
              <a:off x="955407" y="3811756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6" name="Group 215"/>
            <p:cNvGrpSpPr/>
            <p:nvPr/>
          </p:nvGrpSpPr>
          <p:grpSpPr>
            <a:xfrm>
              <a:off x="1101801" y="3773623"/>
              <a:ext cx="76266" cy="76266"/>
              <a:chOff x="1237101" y="2915563"/>
              <a:chExt cx="76266" cy="76266"/>
            </a:xfrm>
          </p:grpSpPr>
          <p:cxnSp>
            <p:nvCxnSpPr>
              <p:cNvPr id="310" name="Straight Connector 309"/>
              <p:cNvCxnSpPr/>
              <p:nvPr/>
            </p:nvCxnSpPr>
            <p:spPr>
              <a:xfrm>
                <a:off x="1237101" y="2953696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1" name="Straight Connector 310"/>
              <p:cNvCxnSpPr/>
              <p:nvPr/>
            </p:nvCxnSpPr>
            <p:spPr>
              <a:xfrm rot="16200000">
                <a:off x="1237101" y="2953696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17" name="Straight Connector 216"/>
            <p:cNvCxnSpPr/>
            <p:nvPr/>
          </p:nvCxnSpPr>
          <p:spPr>
            <a:xfrm>
              <a:off x="1248194" y="3811756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8" name="Straight Connector 217"/>
            <p:cNvCxnSpPr/>
            <p:nvPr/>
          </p:nvCxnSpPr>
          <p:spPr>
            <a:xfrm>
              <a:off x="1394587" y="3811756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Straight Connector 218"/>
            <p:cNvCxnSpPr/>
            <p:nvPr/>
          </p:nvCxnSpPr>
          <p:spPr>
            <a:xfrm>
              <a:off x="1540981" y="3811756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20" name="Group 219"/>
            <p:cNvGrpSpPr/>
            <p:nvPr/>
          </p:nvGrpSpPr>
          <p:grpSpPr>
            <a:xfrm>
              <a:off x="1830619" y="3773623"/>
              <a:ext cx="76266" cy="76266"/>
              <a:chOff x="1965919" y="2915563"/>
              <a:chExt cx="76266" cy="76266"/>
            </a:xfrm>
          </p:grpSpPr>
          <p:cxnSp>
            <p:nvCxnSpPr>
              <p:cNvPr id="308" name="Straight Connector 307"/>
              <p:cNvCxnSpPr/>
              <p:nvPr/>
            </p:nvCxnSpPr>
            <p:spPr>
              <a:xfrm>
                <a:off x="1965919" y="2953696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9" name="Straight Connector 308"/>
              <p:cNvCxnSpPr/>
              <p:nvPr/>
            </p:nvCxnSpPr>
            <p:spPr>
              <a:xfrm rot="16200000">
                <a:off x="1965919" y="2953696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21" name="Straight Connector 220"/>
            <p:cNvCxnSpPr/>
            <p:nvPr/>
          </p:nvCxnSpPr>
          <p:spPr>
            <a:xfrm>
              <a:off x="1977012" y="3811756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Straight Connector 221"/>
            <p:cNvCxnSpPr/>
            <p:nvPr/>
          </p:nvCxnSpPr>
          <p:spPr>
            <a:xfrm>
              <a:off x="2123405" y="3811756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3" name="Straight Connector 222"/>
            <p:cNvCxnSpPr/>
            <p:nvPr/>
          </p:nvCxnSpPr>
          <p:spPr>
            <a:xfrm>
              <a:off x="2269799" y="3811756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24" name="Group 223"/>
            <p:cNvGrpSpPr/>
            <p:nvPr/>
          </p:nvGrpSpPr>
          <p:grpSpPr>
            <a:xfrm>
              <a:off x="2562585" y="3773623"/>
              <a:ext cx="76266" cy="76266"/>
              <a:chOff x="2697885" y="2915563"/>
              <a:chExt cx="76266" cy="76266"/>
            </a:xfrm>
          </p:grpSpPr>
          <p:cxnSp>
            <p:nvCxnSpPr>
              <p:cNvPr id="306" name="Straight Connector 305"/>
              <p:cNvCxnSpPr/>
              <p:nvPr/>
            </p:nvCxnSpPr>
            <p:spPr>
              <a:xfrm>
                <a:off x="2697885" y="2953696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7" name="Straight Connector 306"/>
              <p:cNvCxnSpPr/>
              <p:nvPr/>
            </p:nvCxnSpPr>
            <p:spPr>
              <a:xfrm rot="16200000">
                <a:off x="2697885" y="2953696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25" name="Group 224"/>
            <p:cNvGrpSpPr/>
            <p:nvPr/>
          </p:nvGrpSpPr>
          <p:grpSpPr>
            <a:xfrm>
              <a:off x="2708979" y="3773623"/>
              <a:ext cx="76266" cy="76266"/>
              <a:chOff x="2844279" y="2915563"/>
              <a:chExt cx="76266" cy="76266"/>
            </a:xfrm>
          </p:grpSpPr>
          <p:cxnSp>
            <p:nvCxnSpPr>
              <p:cNvPr id="304" name="Straight Connector 303"/>
              <p:cNvCxnSpPr/>
              <p:nvPr/>
            </p:nvCxnSpPr>
            <p:spPr>
              <a:xfrm>
                <a:off x="2844279" y="2953696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5" name="Straight Connector 304"/>
              <p:cNvCxnSpPr/>
              <p:nvPr/>
            </p:nvCxnSpPr>
            <p:spPr>
              <a:xfrm rot="16200000">
                <a:off x="2844279" y="2953696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6" name="Right Bracket 225"/>
            <p:cNvSpPr/>
            <p:nvPr/>
          </p:nvSpPr>
          <p:spPr>
            <a:xfrm rot="5400000" flipH="1" flipV="1">
              <a:off x="1333572" y="3298537"/>
              <a:ext cx="45719" cy="882798"/>
            </a:xfrm>
            <a:prstGeom prst="rightBracket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900"/>
            </a:p>
          </p:txBody>
        </p:sp>
        <p:cxnSp>
          <p:nvCxnSpPr>
            <p:cNvPr id="227" name="Straight Connector 226"/>
            <p:cNvCxnSpPr/>
            <p:nvPr/>
          </p:nvCxnSpPr>
          <p:spPr>
            <a:xfrm>
              <a:off x="1540981" y="4331971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28" name="Group 227"/>
            <p:cNvGrpSpPr/>
            <p:nvPr/>
          </p:nvGrpSpPr>
          <p:grpSpPr>
            <a:xfrm>
              <a:off x="955407" y="4293838"/>
              <a:ext cx="76266" cy="76266"/>
              <a:chOff x="1090707" y="3435778"/>
              <a:chExt cx="76266" cy="76266"/>
            </a:xfrm>
          </p:grpSpPr>
          <p:cxnSp>
            <p:nvCxnSpPr>
              <p:cNvPr id="302" name="Straight Connector 301"/>
              <p:cNvCxnSpPr/>
              <p:nvPr/>
            </p:nvCxnSpPr>
            <p:spPr>
              <a:xfrm>
                <a:off x="1090707" y="3473911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3" name="Straight Connector 302"/>
              <p:cNvCxnSpPr/>
              <p:nvPr/>
            </p:nvCxnSpPr>
            <p:spPr>
              <a:xfrm rot="16200000">
                <a:off x="1090707" y="3473911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29" name="Straight Connector 228"/>
            <p:cNvCxnSpPr/>
            <p:nvPr/>
          </p:nvCxnSpPr>
          <p:spPr>
            <a:xfrm>
              <a:off x="1248194" y="4331971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Straight Connector 229"/>
            <p:cNvCxnSpPr/>
            <p:nvPr/>
          </p:nvCxnSpPr>
          <p:spPr>
            <a:xfrm>
              <a:off x="1394587" y="4331971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1" name="Straight Connector 230"/>
            <p:cNvCxnSpPr/>
            <p:nvPr/>
          </p:nvCxnSpPr>
          <p:spPr>
            <a:xfrm>
              <a:off x="1830619" y="4331971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32" name="Group 231"/>
            <p:cNvGrpSpPr/>
            <p:nvPr/>
          </p:nvGrpSpPr>
          <p:grpSpPr>
            <a:xfrm>
              <a:off x="2269799" y="4293838"/>
              <a:ext cx="76266" cy="76266"/>
              <a:chOff x="2405099" y="3435778"/>
              <a:chExt cx="76266" cy="76266"/>
            </a:xfrm>
          </p:grpSpPr>
          <p:cxnSp>
            <p:nvCxnSpPr>
              <p:cNvPr id="300" name="Straight Connector 299"/>
              <p:cNvCxnSpPr/>
              <p:nvPr/>
            </p:nvCxnSpPr>
            <p:spPr>
              <a:xfrm>
                <a:off x="2405099" y="3473911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1" name="Straight Connector 300"/>
              <p:cNvCxnSpPr/>
              <p:nvPr/>
            </p:nvCxnSpPr>
            <p:spPr>
              <a:xfrm rot="16200000">
                <a:off x="2405099" y="3473911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33" name="Straight Connector 232"/>
            <p:cNvCxnSpPr/>
            <p:nvPr/>
          </p:nvCxnSpPr>
          <p:spPr>
            <a:xfrm>
              <a:off x="2708979" y="4331971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34" name="Group 233"/>
            <p:cNvGrpSpPr/>
            <p:nvPr/>
          </p:nvGrpSpPr>
          <p:grpSpPr>
            <a:xfrm>
              <a:off x="2123405" y="4293838"/>
              <a:ext cx="76266" cy="76266"/>
              <a:chOff x="2258705" y="3435778"/>
              <a:chExt cx="76266" cy="76266"/>
            </a:xfrm>
          </p:grpSpPr>
          <p:cxnSp>
            <p:nvCxnSpPr>
              <p:cNvPr id="298" name="Straight Connector 297"/>
              <p:cNvCxnSpPr/>
              <p:nvPr/>
            </p:nvCxnSpPr>
            <p:spPr>
              <a:xfrm>
                <a:off x="2258705" y="3473911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9" name="Straight Connector 298"/>
              <p:cNvCxnSpPr/>
              <p:nvPr/>
            </p:nvCxnSpPr>
            <p:spPr>
              <a:xfrm rot="16200000">
                <a:off x="2258705" y="3473911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35" name="Straight Connector 234"/>
            <p:cNvCxnSpPr/>
            <p:nvPr/>
          </p:nvCxnSpPr>
          <p:spPr>
            <a:xfrm>
              <a:off x="2562585" y="4331971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6" name="Straight Connector 235"/>
            <p:cNvCxnSpPr/>
            <p:nvPr/>
          </p:nvCxnSpPr>
          <p:spPr>
            <a:xfrm>
              <a:off x="1101801" y="4331971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37" name="Group 236"/>
            <p:cNvGrpSpPr/>
            <p:nvPr/>
          </p:nvGrpSpPr>
          <p:grpSpPr>
            <a:xfrm>
              <a:off x="1977012" y="4293838"/>
              <a:ext cx="76266" cy="76266"/>
              <a:chOff x="2112312" y="3435778"/>
              <a:chExt cx="76266" cy="76266"/>
            </a:xfrm>
          </p:grpSpPr>
          <p:cxnSp>
            <p:nvCxnSpPr>
              <p:cNvPr id="296" name="Straight Connector 295"/>
              <p:cNvCxnSpPr/>
              <p:nvPr/>
            </p:nvCxnSpPr>
            <p:spPr>
              <a:xfrm>
                <a:off x="2112312" y="3473911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7" name="Straight Connector 296"/>
              <p:cNvCxnSpPr/>
              <p:nvPr/>
            </p:nvCxnSpPr>
            <p:spPr>
              <a:xfrm rot="16200000">
                <a:off x="2112312" y="3473911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38" name="Straight Connector 237"/>
            <p:cNvCxnSpPr/>
            <p:nvPr/>
          </p:nvCxnSpPr>
          <p:spPr>
            <a:xfrm>
              <a:off x="955407" y="4069899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9" name="Straight Connector 238"/>
            <p:cNvCxnSpPr/>
            <p:nvPr/>
          </p:nvCxnSpPr>
          <p:spPr>
            <a:xfrm>
              <a:off x="1830619" y="4069899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0" name="Straight Connector 239"/>
            <p:cNvCxnSpPr/>
            <p:nvPr/>
          </p:nvCxnSpPr>
          <p:spPr>
            <a:xfrm>
              <a:off x="1101801" y="4069899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Straight Connector 240"/>
            <p:cNvCxnSpPr/>
            <p:nvPr/>
          </p:nvCxnSpPr>
          <p:spPr>
            <a:xfrm>
              <a:off x="1695774" y="3812159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2" name="Straight Connector 241"/>
            <p:cNvCxnSpPr/>
            <p:nvPr/>
          </p:nvCxnSpPr>
          <p:spPr>
            <a:xfrm>
              <a:off x="1695774" y="4332374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43" name="Group 242"/>
            <p:cNvGrpSpPr/>
            <p:nvPr/>
          </p:nvGrpSpPr>
          <p:grpSpPr>
            <a:xfrm>
              <a:off x="2856648" y="3775607"/>
              <a:ext cx="76266" cy="76266"/>
              <a:chOff x="2991948" y="2917547"/>
              <a:chExt cx="76266" cy="76266"/>
            </a:xfrm>
          </p:grpSpPr>
          <p:cxnSp>
            <p:nvCxnSpPr>
              <p:cNvPr id="294" name="Straight Connector 293"/>
              <p:cNvCxnSpPr/>
              <p:nvPr/>
            </p:nvCxnSpPr>
            <p:spPr>
              <a:xfrm>
                <a:off x="2991948" y="2955680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5" name="Straight Connector 294"/>
              <p:cNvCxnSpPr/>
              <p:nvPr/>
            </p:nvCxnSpPr>
            <p:spPr>
              <a:xfrm rot="16200000">
                <a:off x="2991948" y="2955680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44" name="Group 243"/>
            <p:cNvGrpSpPr/>
            <p:nvPr/>
          </p:nvGrpSpPr>
          <p:grpSpPr>
            <a:xfrm>
              <a:off x="2998831" y="3775607"/>
              <a:ext cx="76266" cy="76266"/>
              <a:chOff x="3134131" y="2917547"/>
              <a:chExt cx="76266" cy="76266"/>
            </a:xfrm>
          </p:grpSpPr>
          <p:cxnSp>
            <p:nvCxnSpPr>
              <p:cNvPr id="292" name="Straight Connector 291"/>
              <p:cNvCxnSpPr/>
              <p:nvPr/>
            </p:nvCxnSpPr>
            <p:spPr>
              <a:xfrm>
                <a:off x="3134131" y="2955680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3" name="Straight Connector 292"/>
              <p:cNvCxnSpPr/>
              <p:nvPr/>
            </p:nvCxnSpPr>
            <p:spPr>
              <a:xfrm rot="16200000">
                <a:off x="3134131" y="2955680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45" name="Straight Connector 244"/>
            <p:cNvCxnSpPr/>
            <p:nvPr/>
          </p:nvCxnSpPr>
          <p:spPr>
            <a:xfrm>
              <a:off x="2998831" y="4333955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6" name="Straight Connector 245"/>
            <p:cNvCxnSpPr/>
            <p:nvPr/>
          </p:nvCxnSpPr>
          <p:spPr>
            <a:xfrm>
              <a:off x="2856648" y="4333955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47" name="TextBox 246"/>
            <p:cNvSpPr txBox="1"/>
            <p:nvPr/>
          </p:nvSpPr>
          <p:spPr>
            <a:xfrm rot="18881069">
              <a:off x="1066412" y="3862713"/>
              <a:ext cx="624740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TextBox 247"/>
            <p:cNvSpPr txBox="1"/>
            <p:nvPr/>
          </p:nvSpPr>
          <p:spPr>
            <a:xfrm rot="18881069">
              <a:off x="1214991" y="3853752"/>
              <a:ext cx="649950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7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TextBox 248"/>
            <p:cNvSpPr txBox="1"/>
            <p:nvPr/>
          </p:nvSpPr>
          <p:spPr>
            <a:xfrm rot="18881069">
              <a:off x="1394162" y="3923485"/>
              <a:ext cx="469014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4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TextBox 249"/>
            <p:cNvSpPr txBox="1"/>
            <p:nvPr/>
          </p:nvSpPr>
          <p:spPr>
            <a:xfrm rot="18881069">
              <a:off x="1544550" y="3918857"/>
              <a:ext cx="482033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1" name="TextBox 250"/>
            <p:cNvSpPr txBox="1"/>
            <p:nvPr/>
          </p:nvSpPr>
          <p:spPr>
            <a:xfrm rot="18881069">
              <a:off x="1858965" y="3931890"/>
              <a:ext cx="430147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TextBox 251"/>
            <p:cNvSpPr txBox="1"/>
            <p:nvPr/>
          </p:nvSpPr>
          <p:spPr>
            <a:xfrm rot="18881069">
              <a:off x="2017569" y="3952356"/>
              <a:ext cx="387802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7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3" name="TextBox 252"/>
            <p:cNvSpPr txBox="1"/>
            <p:nvPr/>
          </p:nvSpPr>
          <p:spPr>
            <a:xfrm rot="18881069">
              <a:off x="2160973" y="3930993"/>
              <a:ext cx="447894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4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4" name="TextBox 253"/>
            <p:cNvSpPr txBox="1"/>
            <p:nvPr/>
          </p:nvSpPr>
          <p:spPr>
            <a:xfrm rot="18881069">
              <a:off x="2295857" y="3883816"/>
              <a:ext cx="565378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TextBox 254"/>
            <p:cNvSpPr txBox="1"/>
            <p:nvPr/>
          </p:nvSpPr>
          <p:spPr>
            <a:xfrm rot="18828344">
              <a:off x="2467293" y="3914064"/>
              <a:ext cx="491683" cy="230832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TextBox 255"/>
            <p:cNvSpPr txBox="1"/>
            <p:nvPr/>
          </p:nvSpPr>
          <p:spPr>
            <a:xfrm>
              <a:off x="2470949" y="5307132"/>
              <a:ext cx="5579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TextBox 256"/>
            <p:cNvSpPr txBox="1"/>
            <p:nvPr/>
          </p:nvSpPr>
          <p:spPr>
            <a:xfrm>
              <a:off x="2631397" y="5307132"/>
              <a:ext cx="5240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TextBox 257"/>
            <p:cNvSpPr txBox="1"/>
            <p:nvPr/>
          </p:nvSpPr>
          <p:spPr>
            <a:xfrm>
              <a:off x="2730575" y="5307132"/>
              <a:ext cx="6222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59" name="Group 258"/>
            <p:cNvGrpSpPr/>
            <p:nvPr/>
          </p:nvGrpSpPr>
          <p:grpSpPr>
            <a:xfrm>
              <a:off x="2416192" y="4295651"/>
              <a:ext cx="76266" cy="76266"/>
              <a:chOff x="2551492" y="3437591"/>
              <a:chExt cx="76266" cy="76266"/>
            </a:xfrm>
          </p:grpSpPr>
          <p:cxnSp>
            <p:nvCxnSpPr>
              <p:cNvPr id="290" name="Straight Connector 289"/>
              <p:cNvCxnSpPr/>
              <p:nvPr/>
            </p:nvCxnSpPr>
            <p:spPr>
              <a:xfrm>
                <a:off x="2551492" y="3473911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1" name="Straight Connector 290"/>
              <p:cNvCxnSpPr/>
              <p:nvPr/>
            </p:nvCxnSpPr>
            <p:spPr>
              <a:xfrm rot="5400000">
                <a:off x="2551492" y="3475724"/>
                <a:ext cx="762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60" name="Straight Connector 259"/>
            <p:cNvCxnSpPr/>
            <p:nvPr/>
          </p:nvCxnSpPr>
          <p:spPr>
            <a:xfrm>
              <a:off x="2418333" y="3811247"/>
              <a:ext cx="7626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261" name="Picture 2" descr="E:\Study\Lab\Manuscript\Back-up folder\Back-up20130906 Detail-Figure\Western\4A.tif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31446" y="2286595"/>
              <a:ext cx="1761048" cy="70201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62" name="Picture 3" descr="E:\Study\Lab\Manuscript\Back-up folder\Back-up20130906 Detail-Figure\Western\1B.tif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93824" y="2302418"/>
              <a:ext cx="1770470" cy="7016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63" name="Picture 4" descr="E:\Study\Lab\Manuscript\Back-up folder\Back-up20130906 Detail-Figure\Western\1C.jpg"/>
            <p:cNvPicPr>
              <a:picLocks noChangeAspect="1" noChangeArrowheads="1"/>
            </p:cNvPicPr>
            <p:nvPr/>
          </p:nvPicPr>
          <p:blipFill rotWithShape="1"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5259"/>
            <a:stretch/>
          </p:blipFill>
          <p:spPr bwMode="auto">
            <a:xfrm>
              <a:off x="900368" y="4659631"/>
              <a:ext cx="2210030" cy="69278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64" name="TextBox 263"/>
            <p:cNvSpPr txBox="1"/>
            <p:nvPr/>
          </p:nvSpPr>
          <p:spPr>
            <a:xfrm>
              <a:off x="1794274" y="1129294"/>
              <a:ext cx="970673" cy="246213"/>
            </a:xfrm>
            <a:prstGeom prst="rect">
              <a:avLst/>
            </a:prstGeom>
            <a:noFill/>
            <a:effectLst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P-GS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5" name="Right Bracket 264"/>
            <p:cNvSpPr/>
            <p:nvPr/>
          </p:nvSpPr>
          <p:spPr>
            <a:xfrm rot="5400000" flipH="1" flipV="1">
              <a:off x="2255837" y="894324"/>
              <a:ext cx="45719" cy="959377"/>
            </a:xfrm>
            <a:prstGeom prst="rightBracket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lIns="91433" tIns="45716" rIns="91433" bIns="45716" rtlCol="0" anchor="ctr"/>
            <a:lstStyle/>
            <a:p>
              <a:pPr algn="ctr"/>
              <a:endParaRPr lang="en-US" sz="2000"/>
            </a:p>
          </p:txBody>
        </p:sp>
        <p:sp>
          <p:nvSpPr>
            <p:cNvPr id="266" name="TextBox 265"/>
            <p:cNvSpPr txBox="1"/>
            <p:nvPr/>
          </p:nvSpPr>
          <p:spPr>
            <a:xfrm>
              <a:off x="4963197" y="1127889"/>
              <a:ext cx="967976" cy="246213"/>
            </a:xfrm>
            <a:prstGeom prst="rect">
              <a:avLst/>
            </a:prstGeom>
            <a:noFill/>
            <a:effectLst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P-GS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Right Bracket 266"/>
            <p:cNvSpPr/>
            <p:nvPr/>
          </p:nvSpPr>
          <p:spPr>
            <a:xfrm rot="5400000" flipH="1" flipV="1">
              <a:off x="5423428" y="894251"/>
              <a:ext cx="45719" cy="956714"/>
            </a:xfrm>
            <a:prstGeom prst="rightBracket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lIns="91433" tIns="45716" rIns="91433" bIns="45716" rtlCol="0" anchor="ctr"/>
            <a:lstStyle/>
            <a:p>
              <a:pPr algn="ctr"/>
              <a:endParaRPr lang="en-US" sz="2000"/>
            </a:p>
          </p:txBody>
        </p:sp>
        <p:sp>
          <p:nvSpPr>
            <p:cNvPr id="268" name="TextBox 267"/>
            <p:cNvSpPr txBox="1"/>
            <p:nvPr/>
          </p:nvSpPr>
          <p:spPr>
            <a:xfrm>
              <a:off x="1835041" y="3500186"/>
              <a:ext cx="1240056" cy="246213"/>
            </a:xfrm>
            <a:prstGeom prst="rect">
              <a:avLst/>
            </a:prstGeom>
            <a:noFill/>
            <a:effectLst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P-GS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9" name="Right Bracket 268"/>
            <p:cNvSpPr/>
            <p:nvPr/>
          </p:nvSpPr>
          <p:spPr>
            <a:xfrm rot="5400000" flipH="1" flipV="1">
              <a:off x="2429728" y="3127122"/>
              <a:ext cx="45719" cy="1225625"/>
            </a:xfrm>
            <a:prstGeom prst="rightBracket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lIns="91433" tIns="45716" rIns="91433" bIns="45716" rtlCol="0" anchor="ctr"/>
            <a:lstStyle/>
            <a:p>
              <a:pPr algn="ctr"/>
              <a:endParaRPr lang="en-US" sz="2000"/>
            </a:p>
          </p:txBody>
        </p:sp>
        <p:sp>
          <p:nvSpPr>
            <p:cNvPr id="270" name="TextBox 269"/>
            <p:cNvSpPr txBox="1"/>
            <p:nvPr/>
          </p:nvSpPr>
          <p:spPr>
            <a:xfrm>
              <a:off x="4984086" y="3493723"/>
              <a:ext cx="1240056" cy="246213"/>
            </a:xfrm>
            <a:prstGeom prst="rect">
              <a:avLst/>
            </a:prstGeom>
            <a:noFill/>
            <a:effectLst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P-GS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1" name="Right Bracket 270"/>
            <p:cNvSpPr/>
            <p:nvPr/>
          </p:nvSpPr>
          <p:spPr>
            <a:xfrm rot="5400000" flipH="1" flipV="1">
              <a:off x="5578773" y="3123993"/>
              <a:ext cx="45719" cy="1225625"/>
            </a:xfrm>
            <a:prstGeom prst="rightBracket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lIns="91433" tIns="45716" rIns="91433" bIns="45716" rtlCol="0" anchor="ctr"/>
            <a:lstStyle/>
            <a:p>
              <a:pPr algn="ctr"/>
              <a:endParaRPr lang="en-US" sz="2000"/>
            </a:p>
          </p:txBody>
        </p:sp>
        <p:sp>
          <p:nvSpPr>
            <p:cNvPr id="272" name="AutoShape 95"/>
            <p:cNvSpPr>
              <a:spLocks noChangeArrowheads="1"/>
            </p:cNvSpPr>
            <p:nvPr/>
          </p:nvSpPr>
          <p:spPr bwMode="auto">
            <a:xfrm rot="5400000" flipH="1">
              <a:off x="908058" y="2336511"/>
              <a:ext cx="61913" cy="127000"/>
            </a:xfrm>
            <a:prstGeom prst="triangle">
              <a:avLst>
                <a:gd name="adj" fmla="val 49875"/>
              </a:avLst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scene3d>
              <a:camera prst="orthographicFront">
                <a:rot lat="0" lon="10799999" rev="0"/>
              </a:camera>
              <a:lightRig rig="threePt" dir="t"/>
            </a:scene3d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73" name="TextBox 272"/>
            <p:cNvSpPr txBox="1"/>
            <p:nvPr/>
          </p:nvSpPr>
          <p:spPr>
            <a:xfrm>
              <a:off x="152400" y="2276753"/>
              <a:ext cx="777090" cy="230824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700" dirty="0" smtClean="0">
                  <a:latin typeface="Arial"/>
                  <a:cs typeface="Arial"/>
                </a:rPr>
                <a:t>GST-</a:t>
              </a:r>
              <a:r>
                <a:rPr lang="en-US" sz="900" dirty="0" smtClean="0">
                  <a:latin typeface="Arial"/>
                  <a:cs typeface="Arial"/>
                </a:rPr>
                <a:t>Rad27</a:t>
              </a:r>
              <a:endParaRPr lang="en-US" sz="900" dirty="0">
                <a:latin typeface="Arial"/>
                <a:cs typeface="Arial"/>
              </a:endParaRPr>
            </a:p>
          </p:txBody>
        </p:sp>
        <p:sp>
          <p:nvSpPr>
            <p:cNvPr id="274" name="AutoShape 95"/>
            <p:cNvSpPr>
              <a:spLocks noChangeArrowheads="1"/>
            </p:cNvSpPr>
            <p:nvPr/>
          </p:nvSpPr>
          <p:spPr bwMode="auto">
            <a:xfrm rot="5400000" flipH="1">
              <a:off x="908058" y="2813742"/>
              <a:ext cx="61913" cy="127000"/>
            </a:xfrm>
            <a:prstGeom prst="triangle">
              <a:avLst>
                <a:gd name="adj" fmla="val 49875"/>
              </a:avLst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scene3d>
              <a:camera prst="orthographicFront">
                <a:rot lat="0" lon="10799999" rev="0"/>
              </a:camera>
              <a:lightRig rig="threePt" dir="t"/>
            </a:scene3d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75" name="TextBox 274"/>
            <p:cNvSpPr txBox="1"/>
            <p:nvPr/>
          </p:nvSpPr>
          <p:spPr>
            <a:xfrm>
              <a:off x="444510" y="2761829"/>
              <a:ext cx="484981" cy="230824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900" dirty="0" smtClean="0">
                  <a:latin typeface="Arial"/>
                  <a:cs typeface="Arial"/>
                </a:rPr>
                <a:t>GST</a:t>
              </a:r>
              <a:endParaRPr lang="en-US" sz="900" dirty="0">
                <a:latin typeface="Arial"/>
                <a:cs typeface="Arial"/>
              </a:endParaRPr>
            </a:p>
          </p:txBody>
        </p:sp>
        <p:sp>
          <p:nvSpPr>
            <p:cNvPr id="276" name="AutoShape 95"/>
            <p:cNvSpPr>
              <a:spLocks noChangeArrowheads="1"/>
            </p:cNvSpPr>
            <p:nvPr/>
          </p:nvSpPr>
          <p:spPr bwMode="auto">
            <a:xfrm rot="5400000" flipH="1">
              <a:off x="4064192" y="2313400"/>
              <a:ext cx="61913" cy="127000"/>
            </a:xfrm>
            <a:prstGeom prst="triangle">
              <a:avLst>
                <a:gd name="adj" fmla="val 49875"/>
              </a:avLst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scene3d>
              <a:camera prst="orthographicFront">
                <a:rot lat="0" lon="10799999" rev="0"/>
              </a:camera>
              <a:lightRig rig="threePt" dir="t"/>
            </a:scene3d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77" name="TextBox 276"/>
            <p:cNvSpPr txBox="1"/>
            <p:nvPr/>
          </p:nvSpPr>
          <p:spPr>
            <a:xfrm>
              <a:off x="3341650" y="2253642"/>
              <a:ext cx="743974" cy="230824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700" dirty="0" smtClean="0">
                  <a:latin typeface="Arial"/>
                  <a:cs typeface="Arial"/>
                </a:rPr>
                <a:t>GST-</a:t>
              </a:r>
              <a:r>
                <a:rPr lang="en-US" sz="900" dirty="0" smtClean="0">
                  <a:latin typeface="Arial"/>
                  <a:cs typeface="Arial"/>
                </a:rPr>
                <a:t>Rad27</a:t>
              </a:r>
              <a:endParaRPr lang="en-US" sz="900" dirty="0">
                <a:latin typeface="Arial"/>
                <a:cs typeface="Arial"/>
              </a:endParaRPr>
            </a:p>
          </p:txBody>
        </p:sp>
        <p:sp>
          <p:nvSpPr>
            <p:cNvPr id="278" name="AutoShape 95"/>
            <p:cNvSpPr>
              <a:spLocks noChangeArrowheads="1"/>
            </p:cNvSpPr>
            <p:nvPr/>
          </p:nvSpPr>
          <p:spPr bwMode="auto">
            <a:xfrm rot="5400000" flipH="1">
              <a:off x="4064192" y="2859842"/>
              <a:ext cx="61913" cy="127000"/>
            </a:xfrm>
            <a:prstGeom prst="triangle">
              <a:avLst>
                <a:gd name="adj" fmla="val 49875"/>
              </a:avLst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scene3d>
              <a:camera prst="orthographicFront">
                <a:rot lat="0" lon="10799999" rev="0"/>
              </a:camera>
              <a:lightRig rig="threePt" dir="t"/>
            </a:scene3d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79" name="TextBox 278"/>
            <p:cNvSpPr txBox="1"/>
            <p:nvPr/>
          </p:nvSpPr>
          <p:spPr>
            <a:xfrm>
              <a:off x="3600644" y="2807929"/>
              <a:ext cx="484981" cy="230824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900" dirty="0" smtClean="0">
                  <a:latin typeface="Arial"/>
                  <a:cs typeface="Arial"/>
                </a:rPr>
                <a:t>GST</a:t>
              </a:r>
              <a:endParaRPr lang="en-US" sz="900" dirty="0">
                <a:latin typeface="Arial"/>
                <a:cs typeface="Arial"/>
              </a:endParaRPr>
            </a:p>
          </p:txBody>
        </p:sp>
        <p:sp>
          <p:nvSpPr>
            <p:cNvPr id="280" name="AutoShape 95"/>
            <p:cNvSpPr>
              <a:spLocks noChangeArrowheads="1"/>
            </p:cNvSpPr>
            <p:nvPr/>
          </p:nvSpPr>
          <p:spPr bwMode="auto">
            <a:xfrm rot="5400000" flipH="1">
              <a:off x="789524" y="4704502"/>
              <a:ext cx="61913" cy="127000"/>
            </a:xfrm>
            <a:prstGeom prst="triangle">
              <a:avLst>
                <a:gd name="adj" fmla="val 49875"/>
              </a:avLst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scene3d>
              <a:camera prst="orthographicFront">
                <a:rot lat="0" lon="10799999" rev="0"/>
              </a:camera>
              <a:lightRig rig="threePt" dir="t"/>
            </a:scene3d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81" name="TextBox 280"/>
            <p:cNvSpPr txBox="1"/>
            <p:nvPr/>
          </p:nvSpPr>
          <p:spPr>
            <a:xfrm>
              <a:off x="0" y="4644744"/>
              <a:ext cx="810956" cy="230824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700" dirty="0" smtClean="0">
                  <a:latin typeface="Arial"/>
                  <a:cs typeface="Arial"/>
                </a:rPr>
                <a:t>GST-</a:t>
              </a:r>
              <a:r>
                <a:rPr lang="en-US" sz="900" dirty="0" smtClean="0">
                  <a:latin typeface="Arial"/>
                  <a:cs typeface="Arial"/>
                </a:rPr>
                <a:t>Rad27</a:t>
              </a:r>
              <a:endParaRPr lang="en-US" sz="900" dirty="0">
                <a:latin typeface="Arial"/>
                <a:cs typeface="Arial"/>
              </a:endParaRPr>
            </a:p>
          </p:txBody>
        </p:sp>
        <p:sp>
          <p:nvSpPr>
            <p:cNvPr id="282" name="AutoShape 95"/>
            <p:cNvSpPr>
              <a:spLocks noChangeArrowheads="1"/>
            </p:cNvSpPr>
            <p:nvPr/>
          </p:nvSpPr>
          <p:spPr bwMode="auto">
            <a:xfrm rot="5400000" flipH="1">
              <a:off x="789524" y="5184722"/>
              <a:ext cx="61913" cy="127000"/>
            </a:xfrm>
            <a:prstGeom prst="triangle">
              <a:avLst>
                <a:gd name="adj" fmla="val 49875"/>
              </a:avLst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scene3d>
              <a:camera prst="orthographicFront">
                <a:rot lat="0" lon="10799999" rev="0"/>
              </a:camera>
              <a:lightRig rig="threePt" dir="t"/>
            </a:scene3d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83" name="TextBox 282"/>
            <p:cNvSpPr txBox="1"/>
            <p:nvPr/>
          </p:nvSpPr>
          <p:spPr>
            <a:xfrm>
              <a:off x="325976" y="5132809"/>
              <a:ext cx="484981" cy="230824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900" dirty="0" smtClean="0">
                  <a:latin typeface="Arial"/>
                  <a:cs typeface="Arial"/>
                </a:rPr>
                <a:t>GST</a:t>
              </a:r>
              <a:endParaRPr lang="en-US" sz="900" dirty="0">
                <a:latin typeface="Arial"/>
                <a:cs typeface="Arial"/>
              </a:endParaRPr>
            </a:p>
          </p:txBody>
        </p:sp>
        <p:sp>
          <p:nvSpPr>
            <p:cNvPr id="284" name="AutoShape 95"/>
            <p:cNvSpPr>
              <a:spLocks noChangeArrowheads="1"/>
            </p:cNvSpPr>
            <p:nvPr/>
          </p:nvSpPr>
          <p:spPr bwMode="auto">
            <a:xfrm rot="5400000" flipH="1">
              <a:off x="3941880" y="4694475"/>
              <a:ext cx="61913" cy="127000"/>
            </a:xfrm>
            <a:prstGeom prst="triangle">
              <a:avLst>
                <a:gd name="adj" fmla="val 49875"/>
              </a:avLst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scene3d>
              <a:camera prst="orthographicFront">
                <a:rot lat="0" lon="10799999" rev="0"/>
              </a:camera>
              <a:lightRig rig="threePt" dir="t"/>
            </a:scene3d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85" name="TextBox 284"/>
            <p:cNvSpPr txBox="1"/>
            <p:nvPr/>
          </p:nvSpPr>
          <p:spPr>
            <a:xfrm>
              <a:off x="3211678" y="4634717"/>
              <a:ext cx="751633" cy="230824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700" dirty="0" smtClean="0">
                  <a:latin typeface="Arial"/>
                  <a:cs typeface="Arial"/>
                </a:rPr>
                <a:t>GST-</a:t>
              </a:r>
              <a:r>
                <a:rPr lang="en-US" sz="900" dirty="0" smtClean="0">
                  <a:latin typeface="Arial"/>
                  <a:cs typeface="Arial"/>
                </a:rPr>
                <a:t>Rad27</a:t>
              </a:r>
              <a:endParaRPr lang="en-US" sz="900" dirty="0">
                <a:latin typeface="Arial"/>
                <a:cs typeface="Arial"/>
              </a:endParaRPr>
            </a:p>
          </p:txBody>
        </p:sp>
        <p:sp>
          <p:nvSpPr>
            <p:cNvPr id="286" name="AutoShape 95"/>
            <p:cNvSpPr>
              <a:spLocks noChangeArrowheads="1"/>
            </p:cNvSpPr>
            <p:nvPr/>
          </p:nvSpPr>
          <p:spPr bwMode="auto">
            <a:xfrm rot="5400000" flipH="1">
              <a:off x="3941880" y="5189783"/>
              <a:ext cx="61913" cy="127000"/>
            </a:xfrm>
            <a:prstGeom prst="triangle">
              <a:avLst>
                <a:gd name="adj" fmla="val 49875"/>
              </a:avLst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scene3d>
              <a:camera prst="orthographicFront">
                <a:rot lat="0" lon="10799999" rev="0"/>
              </a:camera>
              <a:lightRig rig="threePt" dir="t"/>
            </a:scene3d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87" name="TextBox 286"/>
            <p:cNvSpPr txBox="1"/>
            <p:nvPr/>
          </p:nvSpPr>
          <p:spPr>
            <a:xfrm>
              <a:off x="3478332" y="5137870"/>
              <a:ext cx="484981" cy="230824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900" dirty="0" smtClean="0">
                  <a:latin typeface="Arial"/>
                  <a:cs typeface="Arial"/>
                </a:rPr>
                <a:t>GST</a:t>
              </a:r>
              <a:endParaRPr lang="en-US" sz="900" dirty="0">
                <a:latin typeface="Arial"/>
                <a:cs typeface="Arial"/>
              </a:endParaRPr>
            </a:p>
          </p:txBody>
        </p:sp>
        <p:pic>
          <p:nvPicPr>
            <p:cNvPr id="288" name="Picture 2" descr="C:\Documents and Settings\Thanh\My Documents\Dropbox\Dissertation\Back-up folder\Back-up20130906 Detail-Figure\7A.jpg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70183" y="4659631"/>
              <a:ext cx="2197299" cy="67336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89" name="TextBox 288"/>
            <p:cNvSpPr txBox="1"/>
            <p:nvPr/>
          </p:nvSpPr>
          <p:spPr>
            <a:xfrm>
              <a:off x="228600" y="5897622"/>
              <a:ext cx="5943600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S2. Mapping specific domain(s)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of 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he N-terminus of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us81 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quired to interact with Rad27.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GST pull-down assays were carried out with mixtures of GST-Rad27 and one of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erivatives of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he N-terminal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0-aa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fragment of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us81.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he numbers in each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ragment (denoted as </a:t>
              </a:r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s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Mus81-</a:t>
              </a:r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F)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ndicate the positions of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mino acids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n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us81.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567157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0" name="Group 369"/>
          <p:cNvGrpSpPr/>
          <p:nvPr/>
        </p:nvGrpSpPr>
        <p:grpSpPr>
          <a:xfrm>
            <a:off x="1828800" y="762000"/>
            <a:ext cx="5943600" cy="6843593"/>
            <a:chOff x="228600" y="928490"/>
            <a:chExt cx="5943600" cy="6843593"/>
          </a:xfrm>
        </p:grpSpPr>
        <p:pic>
          <p:nvPicPr>
            <p:cNvPr id="371" name="Picture 2" descr="E:\Study\Lab\MUS81-FEN1\Result image\2014\2014 Dec\Mms4 IP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r="14432" b="-1"/>
            <a:stretch/>
          </p:blipFill>
          <p:spPr bwMode="auto">
            <a:xfrm>
              <a:off x="2889172" y="1889521"/>
              <a:ext cx="626217" cy="1555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72" name="TextBox 371"/>
            <p:cNvSpPr txBox="1"/>
            <p:nvPr/>
          </p:nvSpPr>
          <p:spPr>
            <a:xfrm>
              <a:off x="2274538" y="1693594"/>
              <a:ext cx="649212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3" name="Straight Connector 372"/>
            <p:cNvCxnSpPr/>
            <p:nvPr/>
          </p:nvCxnSpPr>
          <p:spPr>
            <a:xfrm>
              <a:off x="3373980" y="1826053"/>
              <a:ext cx="92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74" name="TextBox 373"/>
            <p:cNvSpPr txBox="1"/>
            <p:nvPr/>
          </p:nvSpPr>
          <p:spPr>
            <a:xfrm>
              <a:off x="2889172" y="1265340"/>
              <a:ext cx="626217" cy="253908"/>
            </a:xfrm>
            <a:prstGeom prst="rect">
              <a:avLst/>
            </a:prstGeom>
            <a:noFill/>
            <a:effectLst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P-Flag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5" name="Right Bracket 374"/>
            <p:cNvSpPr/>
            <p:nvPr/>
          </p:nvSpPr>
          <p:spPr>
            <a:xfrm rot="5400000" flipH="1" flipV="1">
              <a:off x="3175980" y="1257015"/>
              <a:ext cx="46864" cy="618928"/>
            </a:xfrm>
            <a:prstGeom prst="rightBracket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lIns="91433" tIns="45716" rIns="91433" bIns="45716" rtlCol="0" anchor="ctr"/>
            <a:lstStyle/>
            <a:p>
              <a:pPr algn="ctr"/>
              <a:endParaRPr lang="en-US" sz="3200"/>
            </a:p>
          </p:txBody>
        </p:sp>
        <p:sp>
          <p:nvSpPr>
            <p:cNvPr id="376" name="TextBox 375"/>
            <p:cNvSpPr txBox="1"/>
            <p:nvPr/>
          </p:nvSpPr>
          <p:spPr>
            <a:xfrm rot="18597532">
              <a:off x="3047731" y="1587236"/>
              <a:ext cx="585653" cy="230824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l-G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0N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7" name="TextBox 376"/>
            <p:cNvSpPr txBox="1"/>
            <p:nvPr/>
          </p:nvSpPr>
          <p:spPr>
            <a:xfrm rot="18597532">
              <a:off x="2848912" y="1626201"/>
              <a:ext cx="522850" cy="230824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" name="TextBox 377"/>
            <p:cNvSpPr txBox="1"/>
            <p:nvPr/>
          </p:nvSpPr>
          <p:spPr>
            <a:xfrm>
              <a:off x="3450180" y="1844197"/>
              <a:ext cx="1066800" cy="246221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l-GR" sz="10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α</a:t>
              </a:r>
              <a:r>
                <a:rPr lang="en-US" sz="10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-T7 (Mms4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9" name="TextBox 378"/>
            <p:cNvSpPr txBox="1"/>
            <p:nvPr/>
          </p:nvSpPr>
          <p:spPr>
            <a:xfrm>
              <a:off x="3450180" y="2119905"/>
              <a:ext cx="1143000" cy="246221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l-GR" sz="10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α</a:t>
              </a:r>
              <a:r>
                <a:rPr lang="en-US" sz="10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-FLAG (Mus81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0" name="TextBox 379"/>
            <p:cNvSpPr txBox="1"/>
            <p:nvPr/>
          </p:nvSpPr>
          <p:spPr>
            <a:xfrm>
              <a:off x="1295400" y="928490"/>
              <a:ext cx="4074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1" name="TextBox 380"/>
            <p:cNvSpPr txBox="1"/>
            <p:nvPr/>
          </p:nvSpPr>
          <p:spPr>
            <a:xfrm>
              <a:off x="1295400" y="2594726"/>
              <a:ext cx="407484" cy="461665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en-US" sz="2400" b="1" dirty="0" smtClean="0">
                  <a:latin typeface="Arial" panose="020B0604020202020204" pitchFamily="34" charset="0"/>
                  <a:ea typeface="굴림" pitchFamily="50" charset="-127"/>
                  <a:cs typeface="Arial" panose="020B0604020202020204" pitchFamily="34" charset="0"/>
                </a:rPr>
                <a:t>B</a:t>
              </a:r>
              <a:endParaRPr lang="en-US" sz="2400" b="1" dirty="0">
                <a:latin typeface="Arial" panose="020B0604020202020204" pitchFamily="34" charset="0"/>
                <a:ea typeface="굴림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382" name="Picture 5" descr="E:\Study\Lab\MUS81-FEN1\Result image\2014\2014 Dec\Flag-1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r="15089" b="-1"/>
            <a:stretch/>
          </p:blipFill>
          <p:spPr bwMode="auto">
            <a:xfrm>
              <a:off x="2891283" y="2165227"/>
              <a:ext cx="624106" cy="1555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83" name="TextBox 382"/>
            <p:cNvSpPr txBox="1"/>
            <p:nvPr/>
          </p:nvSpPr>
          <p:spPr>
            <a:xfrm>
              <a:off x="228600" y="5463759"/>
              <a:ext cx="5943600" cy="23083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smtClean="0">
                  <a:latin typeface="Arial" panose="020B0604020202020204" pitchFamily="34" charset="0"/>
                  <a:cs typeface="Arial" panose="020B0604020202020204" pitchFamily="34" charset="0"/>
                </a:rPr>
                <a:t>Figure S3. 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eletion of the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-terminal 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0-aa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egion of Mus81 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oes not affect the complex formation with Mms4 </a:t>
              </a:r>
              <a:r>
                <a:rPr lang="en-US" sz="12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 vivo 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r endonuclease activity.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A) Immunoprecipitation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by anti-FLAG antibody-conjugated agarose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ads using crude extracts of the NJY1777 strain (</a:t>
              </a:r>
              <a:r>
                <a:rPr lang="en-US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gs1</a:t>
              </a:r>
              <a:r>
                <a:rPr lang="el-GR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Δ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+ pJM500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-URA3-SGS1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that expressed T7-Mms4 (in pRS314, native promoter) and FLAG-Mus81 or FLAG-Mus81</a:t>
              </a:r>
              <a:r>
                <a:rPr lang="el-GR" sz="1200" baseline="-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baseline="-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0N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both in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RS325, native promoter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. The presence or absence of Mms4 in the precipitated materials was confirmed by western blot using anti-T7 monoclonal antibodies (</a:t>
              </a:r>
              <a:r>
                <a:rPr lang="el-GR" sz="12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α</a:t>
              </a:r>
              <a:r>
                <a:rPr lang="en-US" sz="12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-T7).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B) The nuclease activities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of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ild type Mus81–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ms4 and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utant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200" baseline="-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baseline="-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0N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–Mms4 complexes in the immunoprecipitated materials were measured using the 3’F substrate as described in Materials and Methods.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he graph with error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ars representing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he standard deviation from the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an values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of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hree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ndependent experiments. </a:t>
              </a:r>
            </a:p>
          </p:txBody>
        </p:sp>
        <p:graphicFrame>
          <p:nvGraphicFramePr>
            <p:cNvPr id="384" name="Chart 38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47040373"/>
                </p:ext>
              </p:extLst>
            </p:nvPr>
          </p:nvGraphicFramePr>
          <p:xfrm>
            <a:off x="2088111" y="2676966"/>
            <a:ext cx="2571737" cy="278679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pSp>
          <p:nvGrpSpPr>
            <p:cNvPr id="385" name="Group 384"/>
            <p:cNvGrpSpPr/>
            <p:nvPr/>
          </p:nvGrpSpPr>
          <p:grpSpPr>
            <a:xfrm>
              <a:off x="2719081" y="2977010"/>
              <a:ext cx="2194933" cy="534147"/>
              <a:chOff x="3886200" y="6789022"/>
              <a:chExt cx="1762026" cy="390826"/>
            </a:xfrm>
          </p:grpSpPr>
          <p:sp>
            <p:nvSpPr>
              <p:cNvPr id="386" name="Isosceles Triangle 385"/>
              <p:cNvSpPr/>
              <p:nvPr/>
            </p:nvSpPr>
            <p:spPr>
              <a:xfrm>
                <a:off x="3994404" y="6987858"/>
                <a:ext cx="88392" cy="76200"/>
              </a:xfrm>
              <a:prstGeom prst="triangle">
                <a:avLst/>
              </a:prstGeom>
              <a:solidFill>
                <a:srgbClr val="000000"/>
              </a:solidFill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387" name="Straight Connector 386"/>
              <p:cNvCxnSpPr/>
              <p:nvPr/>
            </p:nvCxnSpPr>
            <p:spPr>
              <a:xfrm>
                <a:off x="3886200" y="7034764"/>
                <a:ext cx="304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8" name="Rectangle 387"/>
              <p:cNvSpPr/>
              <p:nvPr/>
            </p:nvSpPr>
            <p:spPr>
              <a:xfrm>
                <a:off x="4000500" y="6844264"/>
                <a:ext cx="76200" cy="7620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389" name="Straight Connector 388"/>
              <p:cNvCxnSpPr/>
              <p:nvPr/>
            </p:nvCxnSpPr>
            <p:spPr>
              <a:xfrm>
                <a:off x="3886200" y="6882364"/>
                <a:ext cx="304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0" name="TextBox 389"/>
              <p:cNvSpPr txBox="1"/>
              <p:nvPr/>
            </p:nvSpPr>
            <p:spPr>
              <a:xfrm>
                <a:off x="4144673" y="6933635"/>
                <a:ext cx="1503553" cy="246213"/>
              </a:xfrm>
              <a:prstGeom prst="rect">
                <a:avLst/>
              </a:prstGeom>
              <a:noFill/>
            </p:spPr>
            <p:txBody>
              <a:bodyPr wrap="square" lIns="91433" tIns="45716" rIns="91433" bIns="45716" rtlCol="0">
                <a:spAutoFit/>
              </a:bodyPr>
              <a:lstStyle/>
              <a:p>
                <a:pPr fontAlgn="b">
                  <a:defRPr/>
                </a:pPr>
                <a:r>
                  <a:rPr lang="en-US" sz="1000" spc="-5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us81</a:t>
                </a:r>
                <a:r>
                  <a:rPr lang="el-GR" sz="1000" spc="-50" baseline="-50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r>
                  <a:rPr lang="en-US" sz="1000" spc="-50" baseline="-5000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20N</a:t>
                </a:r>
                <a:r>
                  <a:rPr lang="en-US" sz="1000" spc="-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–</a:t>
                </a:r>
                <a:r>
                  <a:rPr lang="en-US" sz="1000" spc="-50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ms4</a:t>
                </a:r>
                <a:endParaRPr lang="en-US" sz="1000" spc="-50" baseline="-5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1" name="TextBox 390"/>
              <p:cNvSpPr txBox="1"/>
              <p:nvPr/>
            </p:nvSpPr>
            <p:spPr>
              <a:xfrm>
                <a:off x="4144673" y="6789022"/>
                <a:ext cx="1131958" cy="246213"/>
              </a:xfrm>
              <a:prstGeom prst="rect">
                <a:avLst/>
              </a:prstGeom>
              <a:noFill/>
            </p:spPr>
            <p:txBody>
              <a:bodyPr wrap="square" lIns="91433" tIns="45716" rIns="91433" bIns="45716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us81–Mms4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8501876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886343" y="914400"/>
            <a:ext cx="5715000" cy="6238458"/>
            <a:chOff x="457200" y="1013619"/>
            <a:chExt cx="5715000" cy="6238458"/>
          </a:xfrm>
        </p:grpSpPr>
        <p:pic>
          <p:nvPicPr>
            <p:cNvPr id="5" name="Picture 4" descr="E:\Study\Lab\MUS81-FEN1\Result image\2014\2014 Dec\native promoter control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30076" y="1755193"/>
              <a:ext cx="812982" cy="90578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>
              <a:off x="3810261" y="1493591"/>
              <a:ext cx="737225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+ 5-FOA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671722" y="1013619"/>
              <a:ext cx="407470" cy="461657"/>
            </a:xfrm>
            <a:prstGeom prst="rect">
              <a:avLst/>
            </a:prstGeom>
            <a:noFill/>
          </p:spPr>
          <p:txBody>
            <a:bodyPr wrap="none" lIns="91433" tIns="45716" rIns="91433" bIns="45716" rtlCol="0">
              <a:spAutoFit/>
            </a:bodyPr>
            <a:lstStyle/>
            <a:p>
              <a:r>
                <a:rPr lang="en-US" altLang="ko-KR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962782" y="1489057"/>
              <a:ext cx="776028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- 5-FOA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160787" y="2669322"/>
              <a:ext cx="1204796" cy="276991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altLang="ko-KR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sgs1</a:t>
              </a:r>
              <a:r>
                <a:rPr lang="el-GR" sz="1200" i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ko-KR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200" i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endParaRPr lang="en-US" sz="12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974409" y="1755193"/>
              <a:ext cx="980013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1100" i="1" dirty="0"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994859" y="2187971"/>
              <a:ext cx="952499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 fontAlgn="b">
                <a:defRPr/>
              </a:pPr>
              <a:r>
                <a:rPr lang="en-US" sz="1100" i="1" spc="-5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10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10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26</a:t>
              </a:r>
              <a:endParaRPr lang="en-US" sz="1100" spc="-50" baseline="-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994858" y="2404361"/>
              <a:ext cx="953481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 fontAlgn="b">
                <a:defRPr/>
              </a:pPr>
              <a:r>
                <a:rPr lang="en-US" sz="1100" i="1" spc="-5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n-US" sz="110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SCE</a:t>
              </a:r>
              <a:endParaRPr lang="en-US" sz="1100" spc="-50" baseline="-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994858" y="1971582"/>
              <a:ext cx="953481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 fontAlgn="b">
                <a:defRPr/>
              </a:pPr>
              <a:r>
                <a:rPr lang="en-US" sz="1100" i="1" spc="-5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US" sz="1100" i="1" spc="-5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s81</a:t>
              </a:r>
              <a:r>
                <a:rPr lang="el-GR" sz="110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10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0N</a:t>
              </a:r>
              <a:endParaRPr lang="en-US" sz="1100" spc="-50" baseline="-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4" name="Picture 2" descr="E:\Study\Lab\MUS81-FEN1\Result image\2014\2014 Dec\native promoter.jp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70310" y="1755193"/>
              <a:ext cx="837707" cy="90578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TextBox 14"/>
            <p:cNvSpPr txBox="1"/>
            <p:nvPr/>
          </p:nvSpPr>
          <p:spPr>
            <a:xfrm>
              <a:off x="1671722" y="3263041"/>
              <a:ext cx="407470" cy="461657"/>
            </a:xfrm>
            <a:prstGeom prst="rect">
              <a:avLst/>
            </a:prstGeom>
            <a:noFill/>
          </p:spPr>
          <p:txBody>
            <a:bodyPr wrap="none" lIns="91433" tIns="45716" rIns="91433" bIns="45716" rtlCol="0">
              <a:spAutoFit/>
            </a:bodyPr>
            <a:lstStyle/>
            <a:p>
              <a:r>
                <a:rPr lang="en-US" altLang="ko-KR" sz="24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2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239315" y="4092363"/>
              <a:ext cx="605161" cy="200055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l-GR" sz="7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α</a:t>
              </a:r>
              <a:r>
                <a:rPr lang="en-US" sz="7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-FLAG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239315" y="4392214"/>
              <a:ext cx="833761" cy="200055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ading control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 rot="18597532">
              <a:off x="2635968" y="3641524"/>
              <a:ext cx="855829" cy="230824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sz="900" i="1" spc="-5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90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90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0N</a:t>
              </a:r>
              <a:endParaRPr lang="en-US" sz="900" spc="-50" baseline="-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 rot="18597532">
              <a:off x="2455167" y="3618969"/>
              <a:ext cx="940996" cy="230824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 rot="18597532">
              <a:off x="2963929" y="3648404"/>
              <a:ext cx="829852" cy="230824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sz="900" i="1" spc="-5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n-US" sz="90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SCE</a:t>
              </a:r>
              <a:endParaRPr lang="en-US" sz="900" spc="-50" baseline="-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 rot="18597532">
              <a:off x="2767492" y="3618969"/>
              <a:ext cx="940996" cy="230824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sz="900" i="1" spc="-5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900" spc="-50" baseline="-5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900" spc="-50" baseline="-5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26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2" name="Picture 6" descr="E:\Study\Lab\MUS81-FEN1\Result image\2014\2014 Dec\Flag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424" t="2" r="7980" b="-2"/>
            <a:stretch/>
          </p:blipFill>
          <p:spPr bwMode="auto">
            <a:xfrm>
              <a:off x="2611151" y="4096704"/>
              <a:ext cx="687906" cy="19137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3" name="Picture 25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3455" r="21099" b="44681"/>
            <a:stretch/>
          </p:blipFill>
          <p:spPr bwMode="auto">
            <a:xfrm>
              <a:off x="2611151" y="4402253"/>
              <a:ext cx="687906" cy="1665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4" name="TextBox 23"/>
            <p:cNvSpPr txBox="1"/>
            <p:nvPr/>
          </p:nvSpPr>
          <p:spPr>
            <a:xfrm>
              <a:off x="457200" y="5128419"/>
              <a:ext cx="5715000" cy="21236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S4.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he cellular defects associated with 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he loss of interaction between Mus81 and Rad27 are not affected by the promoters used.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A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 The complementation of 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sgs1</a:t>
              </a:r>
              <a:r>
                <a:rPr lang="el-GR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Δ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ynthetic lethality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as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examined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ith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he 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mus81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utant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s under the control of the native promoter. The NJY1777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sgs1</a:t>
              </a:r>
              <a:r>
                <a:rPr lang="el-GR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Δ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+ pJM500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-URA3-SGS1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 strain was transformed with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ctors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aining 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MUS81, mus81</a:t>
              </a:r>
              <a:r>
                <a:rPr lang="el-GR" sz="1200" baseline="-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baseline="-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0N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200" baseline="-5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baseline="-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-26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nd </a:t>
              </a:r>
              <a:r>
                <a:rPr lang="en-US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n-US" sz="1200" baseline="-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SCE</a:t>
              </a:r>
              <a:r>
                <a:rPr lang="en-US" sz="1200" i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riven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y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he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ative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moter. (B)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nalysis of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tein expressions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n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% SDS-PAGE. The gels were stained with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oomassie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blue for loading control (bottom). The expression of Mus81 and its derivatives was confirmed by western blotting using anti-FLAG monoclonal antibodies.</a:t>
              </a:r>
            </a:p>
            <a:p>
              <a:pPr algn="just"/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385354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088664" y="1166019"/>
            <a:ext cx="6629400" cy="5442467"/>
            <a:chOff x="-228600" y="1166019"/>
            <a:chExt cx="6629400" cy="5442467"/>
          </a:xfrm>
        </p:grpSpPr>
        <p:sp>
          <p:nvSpPr>
            <p:cNvPr id="5" name="TextBox 4"/>
            <p:cNvSpPr txBox="1"/>
            <p:nvPr/>
          </p:nvSpPr>
          <p:spPr>
            <a:xfrm>
              <a:off x="1990847" y="1470818"/>
              <a:ext cx="819175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5-FOA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819400" y="1166019"/>
              <a:ext cx="407470" cy="461657"/>
            </a:xfrm>
            <a:prstGeom prst="rect">
              <a:avLst/>
            </a:prstGeom>
            <a:noFill/>
          </p:spPr>
          <p:txBody>
            <a:bodyPr wrap="none" lIns="91433" tIns="45716" rIns="91433" bIns="45716" rtlCol="0">
              <a:spAutoFit/>
            </a:bodyPr>
            <a:lstStyle/>
            <a:p>
              <a:r>
                <a:rPr lang="en-US" altLang="ko-KR" sz="2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2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178813" y="1470818"/>
              <a:ext cx="862292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5-FOA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64139" y="1166019"/>
              <a:ext cx="407470" cy="461657"/>
            </a:xfrm>
            <a:prstGeom prst="rect">
              <a:avLst/>
            </a:prstGeom>
            <a:noFill/>
          </p:spPr>
          <p:txBody>
            <a:bodyPr wrap="none" lIns="91433" tIns="45716" rIns="91433" bIns="45716" rtlCol="0">
              <a:spAutoFit/>
            </a:bodyPr>
            <a:lstStyle/>
            <a:p>
              <a:r>
                <a:rPr lang="en-US" altLang="ko-KR" sz="2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2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930374" y="3712390"/>
              <a:ext cx="776786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1050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64139" y="2994818"/>
              <a:ext cx="407470" cy="461657"/>
            </a:xfrm>
            <a:prstGeom prst="rect">
              <a:avLst/>
            </a:prstGeom>
            <a:noFill/>
          </p:spPr>
          <p:txBody>
            <a:bodyPr wrap="none" lIns="91433" tIns="45716" rIns="91433" bIns="45716" rtlCol="0">
              <a:spAutoFit/>
            </a:bodyPr>
            <a:lstStyle/>
            <a:p>
              <a:r>
                <a:rPr lang="en-US" altLang="ko-KR" sz="2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ko-KR" altLang="en-US" sz="2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472628" y="3489989"/>
              <a:ext cx="785093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02%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273752" y="3489989"/>
              <a:ext cx="841048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04%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905000" y="3260073"/>
              <a:ext cx="1969739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MS</a:t>
              </a:r>
            </a:p>
          </p:txBody>
        </p:sp>
        <p:sp>
          <p:nvSpPr>
            <p:cNvPr id="14" name="Right Bracket 13"/>
            <p:cNvSpPr/>
            <p:nvPr/>
          </p:nvSpPr>
          <p:spPr>
            <a:xfrm rot="5400000" flipH="1" flipV="1">
              <a:off x="2853487" y="2467214"/>
              <a:ext cx="62843" cy="2113508"/>
            </a:xfrm>
            <a:prstGeom prst="rightBracket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lIns="91433" tIns="45716" rIns="91433" bIns="45716" rtlCol="0" anchor="ctr"/>
            <a:lstStyle/>
            <a:p>
              <a:pPr algn="ctr"/>
              <a:endParaRPr lang="en-US" sz="1600">
                <a:solidFill>
                  <a:prstClr val="black"/>
                </a:solidFill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430204" y="2537618"/>
              <a:ext cx="1207755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altLang="ko-KR" sz="1100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gs1</a:t>
              </a:r>
              <a:r>
                <a:rPr lang="el-GR" sz="1100" i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ko-KR" sz="1100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100" i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endParaRPr lang="en-US" sz="11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277516" y="4332787"/>
              <a:ext cx="1175316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altLang="ko-KR" sz="1100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gs1</a:t>
              </a:r>
              <a:r>
                <a:rPr lang="el-GR" sz="1100" i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ko-KR" sz="1100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100" i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endParaRPr lang="en-US" sz="11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929" y="1879173"/>
              <a:ext cx="1279125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altLang="ko-KR" sz="10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mpty vector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99401" y="1680662"/>
              <a:ext cx="1184813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1050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-228600" y="2077684"/>
              <a:ext cx="1517496" cy="253908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 fontAlgn="b">
                <a:defRPr/>
              </a:pPr>
              <a:r>
                <a:rPr lang="en-US" sz="1050" i="1" spc="-5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05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5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26</a:t>
              </a:r>
              <a:r>
                <a:rPr lang="en-US" sz="1050" i="1" spc="-5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RAD27</a:t>
              </a:r>
              <a:endParaRPr lang="en-US" sz="1050" spc="-50" baseline="-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55623" y="2276195"/>
              <a:ext cx="1152738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 fontAlgn="b">
                <a:defRPr/>
              </a:pPr>
              <a:r>
                <a:rPr lang="en-US" sz="1050" i="1" spc="-5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050" spc="-50" baseline="-5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5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26</a:t>
              </a:r>
              <a:endParaRPr lang="en-US" sz="1050" spc="-50" baseline="-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741971" y="4118860"/>
              <a:ext cx="952499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 fontAlgn="b">
                <a:defRPr/>
              </a:pPr>
              <a:r>
                <a:rPr lang="en-US" sz="1050" i="1" spc="-5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050" spc="-50" baseline="-5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50" spc="-50" baseline="-5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24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52400" y="3915625"/>
              <a:ext cx="1543051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 fontAlgn="b">
                <a:defRPr/>
              </a:pPr>
              <a:r>
                <a:rPr lang="en-US" sz="1050" i="1" spc="-5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050" spc="-50" baseline="-5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5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24</a:t>
              </a:r>
              <a:r>
                <a:rPr lang="en-US" sz="1050" i="1" spc="-5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+ RAD27</a:t>
              </a:r>
              <a:endParaRPr lang="en-US" sz="1050" spc="-50" baseline="-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3" name="Picture 2" descr="E:\Study\Lab\MUS81-FEN1\Result image\2014\2014.12 Mus81D21-24.26 + 424-Rad27\SD21-26-4days(crop).bmp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33704" y="1699116"/>
              <a:ext cx="752511" cy="78910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4" name="Picture 3" descr="E:\Study\Lab\MUS81-FEN1\Result image\2014\2014.12 Mus81D21-24.26 + 424-Rad27\FOA21-26-4days(crop).bmp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13207" y="1692244"/>
              <a:ext cx="774455" cy="79510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5" name="Picture 4" descr="E:\Study\Lab\MUS81-FEN1\Result image\2014\2014.12 Mus81D21-24.26 + 424-Rad27\sgs1D + Rad27 0.004MMS.bmp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16345" y="1685043"/>
              <a:ext cx="747749" cy="52782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6" name="Picture 5" descr="E:\Study\Lab\MUS81-FEN1\Result image\2014\2014.12 Mus81D21-24.26 + 424-Rad27\sgs1D + Rad27 0.008MMS.bmp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84528" y="1686818"/>
              <a:ext cx="730694" cy="53145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7" name="TextBox 26"/>
            <p:cNvSpPr txBox="1"/>
            <p:nvPr/>
          </p:nvSpPr>
          <p:spPr>
            <a:xfrm>
              <a:off x="3047856" y="1623218"/>
              <a:ext cx="1081012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1050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514600" y="1817305"/>
              <a:ext cx="1607205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 fontAlgn="b">
                <a:defRPr/>
              </a:pPr>
              <a:r>
                <a:rPr lang="en-US" sz="1050" i="1" spc="-5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05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5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26</a:t>
              </a:r>
              <a:r>
                <a:rPr lang="en-US" sz="1050" i="1" spc="-5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RAD27</a:t>
              </a:r>
              <a:endParaRPr lang="en-US" sz="1050" spc="-50" baseline="-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071038" y="2011392"/>
              <a:ext cx="1051745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 fontAlgn="b">
                <a:defRPr/>
              </a:pPr>
              <a:r>
                <a:rPr lang="en-US" sz="1050" i="1" spc="-5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050" spc="-50" baseline="-5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5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26</a:t>
              </a:r>
              <a:endParaRPr lang="en-US" sz="1050" spc="-50" baseline="-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739042" y="1437816"/>
              <a:ext cx="899758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08%</a:t>
              </a:r>
              <a:endPara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539211" y="1437816"/>
              <a:ext cx="861589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16%</a:t>
              </a:r>
              <a:endPara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212570" y="1251702"/>
              <a:ext cx="1959629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MS</a:t>
              </a:r>
            </a:p>
          </p:txBody>
        </p:sp>
        <p:sp>
          <p:nvSpPr>
            <p:cNvPr id="33" name="Right Bracket 32"/>
            <p:cNvSpPr/>
            <p:nvPr/>
          </p:nvSpPr>
          <p:spPr>
            <a:xfrm rot="5400000" flipH="1" flipV="1">
              <a:off x="5173863" y="464261"/>
              <a:ext cx="62843" cy="2102665"/>
            </a:xfrm>
            <a:prstGeom prst="rightBracket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lIns="91433" tIns="45716" rIns="91433" bIns="45716" rtlCol="0" anchor="ctr"/>
            <a:lstStyle/>
            <a:p>
              <a:pPr algn="ctr"/>
              <a:endParaRPr lang="en-US" sz="1600">
                <a:solidFill>
                  <a:prstClr val="black"/>
                </a:solidFill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756151" y="2340860"/>
              <a:ext cx="1204796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altLang="ko-KR" sz="1100" i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100" i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endParaRPr lang="en-US" sz="11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5" name="Picture 2" descr="E:\Study\Lab\MUS81-FEN1\Result image\2014\2014.12 Mus81D21-24.26 + 424-Rad27\0.002MMS 21-24(crop)-1.bmp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54209" y="3746787"/>
              <a:ext cx="778557" cy="57782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6" name="Picture 3" descr="E:\Study\Lab\MUS81-FEN1\Result image\2014\2014.12 Mus81D21-24.26 + 424-Rad27\0.004MMS 21-24 (crop)-1.bmp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51424" y="3746787"/>
              <a:ext cx="845734" cy="57782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7" name="Picture 5" descr="E:\Study\Lab\MUS81-FEN1\Result image\2014\2014.12 Mus81D21-24.26 + 424-Rad27\SD-2.jpg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24" r="2272"/>
            <a:stretch/>
          </p:blipFill>
          <p:spPr bwMode="auto">
            <a:xfrm>
              <a:off x="1656995" y="3742722"/>
              <a:ext cx="778557" cy="58189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8" name="TextBox 37"/>
            <p:cNvSpPr txBox="1"/>
            <p:nvPr/>
          </p:nvSpPr>
          <p:spPr>
            <a:xfrm>
              <a:off x="1656995" y="3481120"/>
              <a:ext cx="785093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ne</a:t>
              </a:r>
              <a:endPara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4376094" y="2994818"/>
              <a:ext cx="407470" cy="461657"/>
            </a:xfrm>
            <a:prstGeom prst="rect">
              <a:avLst/>
            </a:prstGeom>
            <a:noFill/>
          </p:spPr>
          <p:txBody>
            <a:bodyPr wrap="none" lIns="91433" tIns="45716" rIns="91433" bIns="45716" rtlCol="0">
              <a:spAutoFit/>
            </a:bodyPr>
            <a:lstStyle/>
            <a:p>
              <a:r>
                <a:rPr lang="en-US" altLang="ko-KR" sz="24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ko-KR" altLang="en-US" sz="2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0" name="Picture 2" descr="E:\Study\Lab\MUS81-FEN1\Result image\2014\2014 Dec\Rad27myc.jpg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40223" y="3875412"/>
              <a:ext cx="615950" cy="12340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1" name="Picture 3" descr="E:\Study\Lab\MUS81-FEN1\Result image\2014\2014 Dec\Rad27control.jpg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40223" y="4063983"/>
              <a:ext cx="622377" cy="12340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2" name="TextBox 41"/>
            <p:cNvSpPr txBox="1"/>
            <p:nvPr/>
          </p:nvSpPr>
          <p:spPr>
            <a:xfrm>
              <a:off x="5490839" y="3824140"/>
              <a:ext cx="605161" cy="184666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l-GR" sz="6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α</a:t>
              </a:r>
              <a:r>
                <a:rPr lang="en-US" sz="6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-MYC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5490839" y="4017228"/>
              <a:ext cx="833761" cy="184666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lang="en-US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ading control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 rot="18597532">
              <a:off x="4820229" y="3187217"/>
              <a:ext cx="1513855" cy="215436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sz="800" i="1" spc="-5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800" spc="-50" baseline="-5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80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24</a:t>
              </a:r>
              <a:r>
                <a:rPr lang="en-US" sz="800" i="1" spc="-5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RAD27</a:t>
              </a:r>
              <a:endParaRPr lang="en-US" sz="800" spc="-50" baseline="-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 rot="18597532">
              <a:off x="4773301" y="3386388"/>
              <a:ext cx="994172" cy="215436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sz="800" i="1" spc="-5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800" spc="-50" baseline="-5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80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24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 rot="18597532">
              <a:off x="5111055" y="3187217"/>
              <a:ext cx="1513855" cy="215436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sz="800" i="1" spc="-5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800" spc="-50" baseline="-5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800" spc="-50" baseline="-5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26</a:t>
              </a:r>
              <a:r>
                <a:rPr lang="en-US" sz="800" i="1" spc="-5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sz="800" i="1" spc="-5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AD27</a:t>
              </a:r>
              <a:endParaRPr lang="en-US" sz="800" spc="-50" baseline="-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 rot="18597532">
              <a:off x="5064127" y="3386388"/>
              <a:ext cx="994172" cy="215436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sz="800" i="1" spc="-5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800" spc="-50" baseline="-5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800" spc="-50" baseline="-5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26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8" name="Picture 4" descr="E:\Study\Lab\MUS81-FEN1\Result image\2014\2014 Dec\control.jpg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1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50300" y="1680662"/>
              <a:ext cx="745611" cy="52782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9" name="TextBox 48"/>
            <p:cNvSpPr txBox="1"/>
            <p:nvPr/>
          </p:nvSpPr>
          <p:spPr>
            <a:xfrm>
              <a:off x="4010818" y="1437816"/>
              <a:ext cx="785093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ne</a:t>
              </a:r>
              <a:endPara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28600" y="4854159"/>
              <a:ext cx="5943600" cy="17543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S5. Overexpression of Rad27 neither suppresses the synthetic lethality </a:t>
              </a:r>
              <a:r>
                <a:rPr lang="en-US" altLang="ko-KR" sz="1200" b="1" i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gs1</a:t>
              </a:r>
              <a:r>
                <a:rPr lang="el-GR" sz="1200" b="1" i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ko-KR" sz="1200" b="1" i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200" b="1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b="1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  <a:r>
                <a:rPr lang="en-US" sz="1200" b="1" spc="-50" baseline="-5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sz="1200" b="1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  <a:r>
                <a:rPr lang="en-US" sz="1200" b="1" i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b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r 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scues the MMS sensitivity of </a:t>
              </a:r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200" b="1" baseline="-5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b="1" baseline="-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-26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verexpression of Rad27 (in pRS424, ADH1 promoter) failed to suppress the synthetic lethality of 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sgs1</a:t>
              </a:r>
              <a:r>
                <a:rPr lang="el-GR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200" baseline="-5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baseline="-5000" dirty="0">
                  <a:latin typeface="Arial" panose="020B0604020202020204" pitchFamily="34" charset="0"/>
                  <a:cs typeface="Arial" panose="020B0604020202020204" pitchFamily="34" charset="0"/>
                </a:rPr>
                <a:t>21-26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A) and the MMS sensitivity of 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200" baseline="-5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baseline="-5000" dirty="0">
                  <a:latin typeface="Arial" panose="020B0604020202020204" pitchFamily="34" charset="0"/>
                  <a:cs typeface="Arial" panose="020B0604020202020204" pitchFamily="34" charset="0"/>
                </a:rPr>
                <a:t>21-26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B). (C)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Overexpression of Rad27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oorly suppressed the MMS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ensitivity of </a:t>
              </a:r>
              <a:r>
                <a:rPr lang="en-US" altLang="ko-KR" sz="1200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gs1</a:t>
              </a:r>
              <a:r>
                <a:rPr lang="el-GR" sz="1200" i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200" baseline="-5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baseline="-5000" dirty="0">
                  <a:latin typeface="Arial" panose="020B0604020202020204" pitchFamily="34" charset="0"/>
                  <a:cs typeface="Arial" panose="020B0604020202020204" pitchFamily="34" charset="0"/>
                </a:rPr>
                <a:t>21-24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 (D) Analysis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of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tein expressions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n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% SDS-PAGE. The gels were stained with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oomassie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blue for loading control (bottom). The expression of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d27 was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onfirmed by western blotting using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ti-MYC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onoclonal antibodies.</a:t>
              </a:r>
            </a:p>
            <a:p>
              <a:pPr algn="just"/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629035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394111" y="778994"/>
            <a:ext cx="6096000" cy="7076658"/>
            <a:chOff x="228600" y="785019"/>
            <a:chExt cx="6096000" cy="7076658"/>
          </a:xfrm>
        </p:grpSpPr>
        <p:sp>
          <p:nvSpPr>
            <p:cNvPr id="5" name="TextBox 4"/>
            <p:cNvSpPr txBox="1"/>
            <p:nvPr/>
          </p:nvSpPr>
          <p:spPr>
            <a:xfrm>
              <a:off x="1183327" y="785019"/>
              <a:ext cx="407470" cy="461657"/>
            </a:xfrm>
            <a:prstGeom prst="rect">
              <a:avLst/>
            </a:prstGeom>
            <a:noFill/>
          </p:spPr>
          <p:txBody>
            <a:bodyPr wrap="none" lIns="91433" tIns="45716" rIns="91433" bIns="45716" rtlCol="0">
              <a:spAutoFit/>
            </a:bodyPr>
            <a:lstStyle/>
            <a:p>
              <a:r>
                <a:rPr lang="en-US" altLang="ko-KR" sz="24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2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1524000" y="2385219"/>
              <a:ext cx="3981068" cy="1615791"/>
              <a:chOff x="1434965" y="1107230"/>
              <a:chExt cx="3981068" cy="1615791"/>
            </a:xfrm>
          </p:grpSpPr>
          <p:sp>
            <p:nvSpPr>
              <p:cNvPr id="36" name="TextBox 35"/>
              <p:cNvSpPr txBox="1"/>
              <p:nvPr/>
            </p:nvSpPr>
            <p:spPr>
              <a:xfrm>
                <a:off x="1447799" y="1542130"/>
                <a:ext cx="1044995" cy="261602"/>
              </a:xfrm>
              <a:prstGeom prst="rect">
                <a:avLst/>
              </a:prstGeom>
              <a:noFill/>
            </p:spPr>
            <p:txBody>
              <a:bodyPr wrap="square" lIns="91433" tIns="45716" rIns="91433" bIns="45716" rtlCol="0">
                <a:spAutoFit/>
              </a:bodyPr>
              <a:lstStyle/>
              <a:p>
                <a:pPr algn="r"/>
                <a:r>
                  <a:rPr lang="en-US" altLang="ko-KR" sz="105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mpty vector</a:t>
                </a: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1590797" y="1773109"/>
                <a:ext cx="894935" cy="261602"/>
              </a:xfrm>
              <a:prstGeom prst="rect">
                <a:avLst/>
              </a:prstGeom>
              <a:noFill/>
            </p:spPr>
            <p:txBody>
              <a:bodyPr wrap="square" lIns="91433" tIns="45716" rIns="91433" bIns="45716" rtlCol="0">
                <a:spAutoFit/>
              </a:bodyPr>
              <a:lstStyle/>
              <a:p>
                <a:pPr algn="r" fontAlgn="b">
                  <a:defRPr/>
                </a:pPr>
                <a:r>
                  <a:rPr lang="en-US" sz="1050" i="1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ad27</a:t>
                </a:r>
                <a:endParaRPr lang="en-US" sz="105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1434965" y="2004088"/>
                <a:ext cx="1051745" cy="261602"/>
              </a:xfrm>
              <a:prstGeom prst="rect">
                <a:avLst/>
              </a:prstGeom>
              <a:noFill/>
            </p:spPr>
            <p:txBody>
              <a:bodyPr wrap="square" lIns="91433" tIns="45716" rIns="91433" bIns="45716" rtlCol="0">
                <a:spAutoFit/>
              </a:bodyPr>
              <a:lstStyle/>
              <a:p>
                <a:pPr algn="r" fontAlgn="b">
                  <a:defRPr/>
                </a:pPr>
                <a:r>
                  <a:rPr lang="en-US" sz="1050" i="1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ad27</a:t>
                </a:r>
                <a:r>
                  <a:rPr lang="en-US" sz="1050" baseline="-5000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-366</a:t>
                </a:r>
                <a:endParaRPr lang="en-US" sz="1050" baseline="-5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3525675" y="1352128"/>
                <a:ext cx="899758" cy="261602"/>
              </a:xfrm>
              <a:prstGeom prst="rect">
                <a:avLst/>
              </a:prstGeom>
              <a:noFill/>
            </p:spPr>
            <p:txBody>
              <a:bodyPr wrap="square" lIns="91433" tIns="45716" rIns="91433" bIns="45716" rtlCol="0">
                <a:spAutoFit/>
              </a:bodyPr>
              <a:lstStyle/>
              <a:p>
                <a:pPr algn="ctr"/>
                <a:r>
                  <a:rPr lang="en-US" sz="1050" dirty="0" smtClea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008%</a:t>
                </a:r>
                <a:endParaRPr lang="en-US" sz="10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4501633" y="1352128"/>
                <a:ext cx="861589" cy="261602"/>
              </a:xfrm>
              <a:prstGeom prst="rect">
                <a:avLst/>
              </a:prstGeom>
              <a:noFill/>
            </p:spPr>
            <p:txBody>
              <a:bodyPr wrap="square" lIns="91433" tIns="45716" rIns="91433" bIns="45716" rtlCol="0">
                <a:spAutoFit/>
              </a:bodyPr>
              <a:lstStyle/>
              <a:p>
                <a:pPr algn="ctr"/>
                <a:r>
                  <a:rPr lang="en-US" sz="1050" dirty="0" smtClea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016%</a:t>
                </a:r>
                <a:endParaRPr lang="en-US" sz="10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2819400" y="1107230"/>
                <a:ext cx="2286000" cy="261602"/>
              </a:xfrm>
              <a:prstGeom prst="rect">
                <a:avLst/>
              </a:prstGeom>
              <a:noFill/>
            </p:spPr>
            <p:txBody>
              <a:bodyPr wrap="square" lIns="91433" tIns="45716" rIns="91433" bIns="45716" rtlCol="0">
                <a:spAutoFit/>
              </a:bodyPr>
              <a:lstStyle/>
              <a:p>
                <a:pPr algn="ctr"/>
                <a:r>
                  <a:rPr lang="en-US" sz="105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MS</a:t>
                </a:r>
              </a:p>
            </p:txBody>
          </p:sp>
          <p:sp>
            <p:nvSpPr>
              <p:cNvPr id="42" name="Right Bracket 41"/>
              <p:cNvSpPr/>
              <p:nvPr/>
            </p:nvSpPr>
            <p:spPr>
              <a:xfrm rot="5400000" flipH="1" flipV="1">
                <a:off x="3943091" y="144691"/>
                <a:ext cx="62843" cy="2452858"/>
              </a:xfrm>
              <a:prstGeom prst="rightBracket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lIns="91433" tIns="45716" rIns="91433" bIns="45716" rtlCol="0" anchor="ctr"/>
              <a:lstStyle/>
              <a:p>
                <a:pPr algn="ctr"/>
                <a:endParaRPr lang="en-US" sz="1600">
                  <a:solidFill>
                    <a:prstClr val="black"/>
                  </a:solidFill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3352800" y="2461419"/>
                <a:ext cx="1204796" cy="261602"/>
              </a:xfrm>
              <a:prstGeom prst="rect">
                <a:avLst/>
              </a:prstGeom>
              <a:noFill/>
            </p:spPr>
            <p:txBody>
              <a:bodyPr wrap="square" lIns="91433" tIns="45716" rIns="91433" bIns="45716" rtlCol="0">
                <a:spAutoFit/>
              </a:bodyPr>
              <a:lstStyle/>
              <a:p>
                <a:pPr algn="ctr"/>
                <a:r>
                  <a:rPr lang="en-US" altLang="ko-KR" sz="1100" i="1" dirty="0" smtClea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ad27</a:t>
                </a:r>
                <a:r>
                  <a:rPr lang="el-GR" sz="1100" i="1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endParaRPr lang="en-US" sz="1100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2567707" y="1352128"/>
                <a:ext cx="785093" cy="261602"/>
              </a:xfrm>
              <a:prstGeom prst="rect">
                <a:avLst/>
              </a:prstGeom>
              <a:noFill/>
            </p:spPr>
            <p:txBody>
              <a:bodyPr wrap="square" lIns="91433" tIns="45716" rIns="91433" bIns="45716" rtlCol="0">
                <a:spAutoFit/>
              </a:bodyPr>
              <a:lstStyle/>
              <a:p>
                <a:pPr algn="ctr"/>
                <a:r>
                  <a:rPr lang="en-US" sz="1050" dirty="0" smtClean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one</a:t>
                </a:r>
                <a:endParaRPr lang="en-US" sz="105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45" name="Picture 2" descr="G:\HuongDropbox\Dropbox\Dissertation\rad27 C deletion\0.004.bmp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64680" y="1567841"/>
                <a:ext cx="970707" cy="91098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6" name="Picture 3" descr="G:\HuongDropbox\Dropbox\Dissertation\rad27 C deletion\0.008.bmp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65233" y="1567840"/>
                <a:ext cx="950800" cy="91098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7" name="Picture 4" descr="G:\HuongDropbox\Dropbox\Dissertation\rad27 C deletion\SD.bmp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93422" y="1567840"/>
                <a:ext cx="935578" cy="91098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48" name="TextBox 47"/>
              <p:cNvSpPr txBox="1"/>
              <p:nvPr/>
            </p:nvSpPr>
            <p:spPr>
              <a:xfrm>
                <a:off x="1434965" y="2235068"/>
                <a:ext cx="1051745" cy="261602"/>
              </a:xfrm>
              <a:prstGeom prst="rect">
                <a:avLst/>
              </a:prstGeom>
              <a:noFill/>
            </p:spPr>
            <p:txBody>
              <a:bodyPr wrap="square" lIns="91433" tIns="45716" rIns="91433" bIns="45716" rtlCol="0">
                <a:spAutoFit/>
              </a:bodyPr>
              <a:lstStyle/>
              <a:p>
                <a:pPr algn="r" fontAlgn="b">
                  <a:defRPr/>
                </a:pPr>
                <a:r>
                  <a:rPr lang="en-US" sz="1050" i="1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ad27</a:t>
                </a:r>
                <a:r>
                  <a:rPr lang="en-US" sz="1050" baseline="-5000" dirty="0" smtClean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-317</a:t>
                </a:r>
                <a:endParaRPr lang="en-US" sz="1050" baseline="-5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" name="TextBox 6"/>
            <p:cNvSpPr txBox="1"/>
            <p:nvPr/>
          </p:nvSpPr>
          <p:spPr>
            <a:xfrm>
              <a:off x="1219200" y="2385219"/>
              <a:ext cx="407470" cy="461657"/>
            </a:xfrm>
            <a:prstGeom prst="rect">
              <a:avLst/>
            </a:prstGeom>
            <a:noFill/>
          </p:spPr>
          <p:txBody>
            <a:bodyPr wrap="none" lIns="91433" tIns="45716" rIns="91433" bIns="45716" rtlCol="0">
              <a:spAutoFit/>
            </a:bodyPr>
            <a:lstStyle/>
            <a:p>
              <a:r>
                <a:rPr lang="en-US" altLang="ko-KR" sz="2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2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28600" y="5738019"/>
              <a:ext cx="6096000" cy="21236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S6. Deletion of C-terminus of Rad27 renders cells sensitive to MMS.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A) A schematic illustration of the two deletion Rad27 mutants devoid of the motif (indicated as gray and solid boxes) required to bind Mus81-Mms4. The numbers are positions of amino acids in Rad27. (B) Complementation of the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MS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nsitivity of </a:t>
              </a:r>
              <a:r>
                <a:rPr lang="en-US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d27</a:t>
              </a:r>
              <a:r>
                <a:rPr lang="el-GR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as performed with two </a:t>
              </a:r>
              <a:r>
                <a:rPr lang="en-US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d27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utant alleles that were defective in binding Mus81-Mms4. The </a:t>
              </a:r>
              <a:r>
                <a:rPr lang="en-US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d27</a:t>
              </a:r>
              <a:r>
                <a:rPr lang="el-GR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strain (YPH499, </a:t>
              </a:r>
              <a:r>
                <a:rPr lang="en-US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D27</a:t>
              </a:r>
              <a:r>
                <a:rPr lang="el-GR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::LEU3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 was transformed with an empty vector (pRS424) or vectors containing </a:t>
              </a:r>
              <a:r>
                <a:rPr lang="en-US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D27, rad27</a:t>
              </a:r>
              <a:r>
                <a:rPr lang="en-US" sz="1200" baseline="-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-366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and </a:t>
              </a:r>
              <a:r>
                <a:rPr lang="en-US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d27</a:t>
              </a:r>
              <a:r>
                <a:rPr lang="en-US" sz="1200" baseline="-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-317</a:t>
              </a:r>
              <a:r>
                <a:rPr lang="en-US" sz="1200" i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riven by the ADH1 promoter. (C)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nalysis of protein expressions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in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% SDS-PAGE. The membrane was stained with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onceau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S for loading control (bottom). The expression of Rad27 derivatives was confirmed by western blotting using anti-FLAG monoclonal antibodies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lang="ko-KR" altLang="ko-K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just"/>
              <a:endParaRPr lang="ko-KR" altLang="ko-K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888403" y="1337886"/>
              <a:ext cx="357776" cy="212795"/>
            </a:xfrm>
            <a:prstGeom prst="rect">
              <a:avLst/>
            </a:prstGeom>
            <a:noFill/>
          </p:spPr>
          <p:txBody>
            <a:bodyPr wrap="none" lIns="91433" tIns="45716" rIns="91433" bIns="45716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82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514316" y="1337886"/>
              <a:ext cx="242360" cy="212795"/>
            </a:xfrm>
            <a:prstGeom prst="rect">
              <a:avLst/>
            </a:prstGeom>
            <a:noFill/>
          </p:spPr>
          <p:txBody>
            <a:bodyPr wrap="none" lIns="91433" tIns="45716" rIns="91433" bIns="45716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1" name="모서리가 둥근 직사각형 55"/>
            <p:cNvSpPr/>
            <p:nvPr/>
          </p:nvSpPr>
          <p:spPr bwMode="auto">
            <a:xfrm>
              <a:off x="2638484" y="1508395"/>
              <a:ext cx="2390716" cy="94825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  <a:effectLst>
              <a:outerShdw blurRad="76200" dist="12700" dir="8100000" sy="-23000" kx="800400" algn="br" rotWithShape="0">
                <a:prstClr val="black">
                  <a:alpha val="20000"/>
                </a:prstClr>
              </a:outerShdw>
            </a:effectLst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lIns="91433" tIns="45716" rIns="91433" bIns="45716" anchor="ctr"/>
            <a:lstStyle/>
            <a:p>
              <a:pPr algn="ctr"/>
              <a:endParaRPr lang="en-US" sz="800" b="1" dirty="0">
                <a:solidFill>
                  <a:schemeClr val="tx1"/>
                </a:solidFill>
                <a:latin typeface="Trebuchet MS" pitchFamily="34" charset="0"/>
                <a:cs typeface="Arial" pitchFamily="34" charset="0"/>
              </a:endParaRP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4439189" y="1507259"/>
              <a:ext cx="164789" cy="9539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91433" tIns="45716" rIns="91433" bIns="45716" rtlCol="0" anchor="ctr"/>
            <a:lstStyle/>
            <a:p>
              <a:pPr algn="ctr"/>
              <a:endParaRPr lang="en-US" sz="1400" dirty="0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4864411" y="1513126"/>
              <a:ext cx="164789" cy="89978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91433" tIns="45716" rIns="91433" bIns="45716" rtlCol="0" anchor="ctr"/>
            <a:lstStyle/>
            <a:p>
              <a:pPr algn="ctr"/>
              <a:endParaRPr lang="en-US" sz="140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649972" y="1337886"/>
              <a:ext cx="357776" cy="212795"/>
            </a:xfrm>
            <a:prstGeom prst="rect">
              <a:avLst/>
            </a:prstGeom>
            <a:noFill/>
          </p:spPr>
          <p:txBody>
            <a:bodyPr wrap="none" lIns="91433" tIns="45716" rIns="91433" bIns="45716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7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229484" y="1337886"/>
              <a:ext cx="357776" cy="212795"/>
            </a:xfrm>
            <a:prstGeom prst="rect">
              <a:avLst/>
            </a:prstGeom>
            <a:noFill/>
          </p:spPr>
          <p:txBody>
            <a:bodyPr wrap="none" lIns="91433" tIns="45716" rIns="91433" bIns="45716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8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455855" y="1337886"/>
              <a:ext cx="357776" cy="212795"/>
            </a:xfrm>
            <a:prstGeom prst="rect">
              <a:avLst/>
            </a:prstGeom>
            <a:noFill/>
          </p:spPr>
          <p:txBody>
            <a:bodyPr wrap="none" lIns="91433" tIns="45716" rIns="91433" bIns="45716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34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ight Brace 16"/>
            <p:cNvSpPr/>
            <p:nvPr/>
          </p:nvSpPr>
          <p:spPr>
            <a:xfrm rot="16200000">
              <a:off x="4484098" y="1262650"/>
              <a:ext cx="65552" cy="164789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Right Brace 17"/>
            <p:cNvSpPr/>
            <p:nvPr/>
          </p:nvSpPr>
          <p:spPr>
            <a:xfrm rot="16200000">
              <a:off x="4914029" y="1262650"/>
              <a:ext cx="65552" cy="164789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962400" y="1013619"/>
              <a:ext cx="1524000" cy="338546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wo separate motifs required to bind Mus81-Mms4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모서리가 둥근 직사각형 55"/>
            <p:cNvSpPr/>
            <p:nvPr/>
          </p:nvSpPr>
          <p:spPr bwMode="auto">
            <a:xfrm>
              <a:off x="2638484" y="2010932"/>
              <a:ext cx="1795996" cy="94825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  <a:effectLst>
              <a:outerShdw blurRad="76200" dist="12700" dir="8100000" sy="-23000" kx="800400" algn="br" rotWithShape="0">
                <a:prstClr val="black">
                  <a:alpha val="20000"/>
                </a:prstClr>
              </a:outerShdw>
            </a:effectLst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lIns="91433" tIns="45716" rIns="91433" bIns="45716" anchor="ctr"/>
            <a:lstStyle/>
            <a:p>
              <a:pPr algn="ctr"/>
              <a:endParaRPr lang="en-US" sz="800" baseline="-5000" dirty="0">
                <a:solidFill>
                  <a:srgbClr val="000000"/>
                </a:solidFill>
                <a:latin typeface="Trebuchet MS" panose="020B0603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1981200" y="1429133"/>
              <a:ext cx="48177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ctr"/>
              <a:r>
                <a:rPr lang="en-US" sz="800" b="1" dirty="0">
                  <a:solidFill>
                    <a:prstClr val="black"/>
                  </a:solidFill>
                  <a:latin typeface="Trebuchet MS" pitchFamily="34" charset="0"/>
                  <a:cs typeface="Arial" pitchFamily="34" charset="0"/>
                </a:rPr>
                <a:t>Rad27</a:t>
              </a:r>
            </a:p>
          </p:txBody>
        </p:sp>
        <p:sp>
          <p:nvSpPr>
            <p:cNvPr id="22" name="Rectangle 21"/>
            <p:cNvSpPr/>
            <p:nvPr/>
          </p:nvSpPr>
          <p:spPr>
            <a:xfrm>
              <a:off x="1986009" y="1943967"/>
              <a:ext cx="64953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ctr"/>
              <a:r>
                <a:rPr lang="en-US" sz="800" b="1" dirty="0" smtClean="0">
                  <a:solidFill>
                    <a:prstClr val="black"/>
                  </a:solidFill>
                  <a:latin typeface="Trebuchet MS" panose="020B0603020202020204" pitchFamily="34" charset="0"/>
                  <a:cs typeface="Arial" pitchFamily="34" charset="0"/>
                </a:rPr>
                <a:t>Rad27</a:t>
              </a:r>
              <a:r>
                <a:rPr lang="en-US" sz="800" baseline="-5000" dirty="0" smtClean="0">
                  <a:solidFill>
                    <a:srgbClr val="000000"/>
                  </a:solidFill>
                  <a:latin typeface="Trebuchet MS" panose="020B0603020202020204" pitchFamily="34" charset="0"/>
                  <a:cs typeface="Arial" panose="020B0604020202020204" pitchFamily="34" charset="0"/>
                </a:rPr>
                <a:t>1-317</a:t>
              </a:r>
              <a:endParaRPr lang="en-US" sz="800" baseline="-5000" dirty="0">
                <a:solidFill>
                  <a:srgbClr val="000000"/>
                </a:solidFill>
                <a:latin typeface="Trebuchet MS" panose="020B0603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Rectangle 22"/>
            <p:cNvSpPr/>
            <p:nvPr/>
          </p:nvSpPr>
          <p:spPr>
            <a:xfrm>
              <a:off x="1986009" y="1699419"/>
              <a:ext cx="64953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ctr"/>
              <a:r>
                <a:rPr lang="en-US" sz="800" b="1" dirty="0" smtClean="0">
                  <a:solidFill>
                    <a:prstClr val="black"/>
                  </a:solidFill>
                  <a:latin typeface="Trebuchet MS" panose="020B0603020202020204" pitchFamily="34" charset="0"/>
                  <a:cs typeface="Arial" pitchFamily="34" charset="0"/>
                </a:rPr>
                <a:t>Rad27</a:t>
              </a:r>
              <a:r>
                <a:rPr lang="en-US" sz="800" baseline="-5000" dirty="0" smtClean="0">
                  <a:solidFill>
                    <a:srgbClr val="000000"/>
                  </a:solidFill>
                  <a:latin typeface="Trebuchet MS" panose="020B0603020202020204" pitchFamily="34" charset="0"/>
                  <a:cs typeface="Arial" panose="020B0604020202020204" pitchFamily="34" charset="0"/>
                </a:rPr>
                <a:t>1-366</a:t>
              </a:r>
              <a:endParaRPr lang="en-US" sz="800" baseline="-5000" dirty="0">
                <a:solidFill>
                  <a:srgbClr val="000000"/>
                </a:solidFill>
                <a:latin typeface="Trebuchet MS" panose="020B0603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4" name="Group 23"/>
            <p:cNvGrpSpPr/>
            <p:nvPr/>
          </p:nvGrpSpPr>
          <p:grpSpPr>
            <a:xfrm>
              <a:off x="2638484" y="1753518"/>
              <a:ext cx="2225949" cy="95394"/>
              <a:chOff x="2638484" y="1999680"/>
              <a:chExt cx="2225949" cy="95394"/>
            </a:xfrm>
          </p:grpSpPr>
          <p:sp>
            <p:nvSpPr>
              <p:cNvPr id="34" name="모서리가 둥근 직사각형 55"/>
              <p:cNvSpPr/>
              <p:nvPr/>
            </p:nvSpPr>
            <p:spPr bwMode="auto">
              <a:xfrm>
                <a:off x="2638484" y="2000249"/>
                <a:ext cx="2225949" cy="94825"/>
              </a:xfrm>
              <a:prstGeom prst="roundRect">
                <a:avLst/>
              </a:prstGeom>
              <a:solidFill>
                <a:schemeClr val="bg1">
                  <a:lumMod val="75000"/>
                </a:schemeClr>
              </a:solidFill>
              <a:ln w="6350">
                <a:solidFill>
                  <a:schemeClr val="tx1"/>
                </a:solidFill>
              </a:ln>
              <a:effectLst>
                <a:outerShdw blurRad="76200" dist="12700" dir="8100000" sy="-23000" kx="800400" algn="br" rotWithShape="0">
                  <a:prstClr val="black">
                    <a:alpha val="20000"/>
                  </a:prstClr>
                </a:outerShdw>
              </a:effectLst>
            </p:spPr>
            <p:style>
              <a:lnRef idx="0">
                <a:schemeClr val="accent4"/>
              </a:lnRef>
              <a:fillRef idx="3">
                <a:schemeClr val="accent4"/>
              </a:fillRef>
              <a:effectRef idx="3">
                <a:schemeClr val="accent4"/>
              </a:effectRef>
              <a:fontRef idx="minor">
                <a:schemeClr val="lt1"/>
              </a:fontRef>
            </p:style>
            <p:txBody>
              <a:bodyPr lIns="91433" tIns="45716" rIns="91433" bIns="45716" anchor="ctr"/>
              <a:lstStyle/>
              <a:p>
                <a:pPr algn="ctr"/>
                <a:endParaRPr lang="en-US" sz="800" baseline="-5000" dirty="0">
                  <a:solidFill>
                    <a:srgbClr val="000000"/>
                  </a:solidFill>
                  <a:latin typeface="Trebuchet MS" panose="020B0603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4439189" y="1999680"/>
                <a:ext cx="164789" cy="95393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9525"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lIns="91433" tIns="45716" rIns="91433" bIns="45716" rtlCol="0" anchor="ctr"/>
              <a:lstStyle/>
              <a:p>
                <a:pPr algn="ctr"/>
                <a:endParaRPr lang="en-US" sz="1400" dirty="0"/>
              </a:p>
            </p:txBody>
          </p:sp>
        </p:grpSp>
        <p:sp>
          <p:nvSpPr>
            <p:cNvPr id="25" name="TextBox 24"/>
            <p:cNvSpPr txBox="1"/>
            <p:nvPr/>
          </p:nvSpPr>
          <p:spPr>
            <a:xfrm rot="17696422">
              <a:off x="2668768" y="4497869"/>
              <a:ext cx="858706" cy="215436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altLang="ko-KR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ad27</a:t>
              </a:r>
              <a:endParaRPr lang="en-US" altLang="ko-KR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 rot="17696422">
              <a:off x="2921011" y="4570136"/>
              <a:ext cx="699310" cy="215436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fontAlgn="b">
                <a:defRPr/>
              </a:pPr>
              <a:r>
                <a:rPr lang="en-US" sz="800" i="1" spc="-5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ad27</a:t>
              </a:r>
              <a:r>
                <a:rPr lang="en-US" sz="80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-366</a:t>
              </a:r>
              <a:endParaRPr lang="en-US" sz="800" spc="-50" baseline="-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 rot="17696422">
              <a:off x="3099018" y="4575088"/>
              <a:ext cx="688386" cy="215436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fontAlgn="b">
                <a:defRPr/>
              </a:pPr>
              <a:r>
                <a:rPr lang="en-US" sz="800" i="1" spc="-5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ad27</a:t>
              </a:r>
              <a:r>
                <a:rPr lang="en-US" sz="80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-317</a:t>
              </a:r>
              <a:endParaRPr lang="en-US" sz="800" spc="-50" baseline="-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429000" y="4962000"/>
              <a:ext cx="723232" cy="215444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l-GR" sz="8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α</a:t>
              </a:r>
              <a:r>
                <a:rPr lang="en-US" sz="800" dirty="0" smtClean="0">
                  <a:latin typeface="Arial" panose="020B0604020202020204" pitchFamily="34" charset="0"/>
                  <a:ea typeface="Cambria Math"/>
                  <a:cs typeface="Arial" panose="020B0604020202020204" pitchFamily="34" charset="0"/>
                </a:rPr>
                <a:t>-FLAG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429000" y="5249613"/>
              <a:ext cx="996433" cy="215444"/>
            </a:xfrm>
            <a:prstGeom prst="rect">
              <a:avLst/>
            </a:prstGeom>
            <a:noFill/>
            <a:effectLst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ading control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183327" y="4361962"/>
              <a:ext cx="407470" cy="461657"/>
            </a:xfrm>
            <a:prstGeom prst="rect">
              <a:avLst/>
            </a:prstGeom>
            <a:noFill/>
          </p:spPr>
          <p:txBody>
            <a:bodyPr wrap="none" lIns="91433" tIns="45716" rIns="91433" bIns="45716" rtlCol="0">
              <a:spAutoFit/>
            </a:bodyPr>
            <a:lstStyle/>
            <a:p>
              <a:r>
                <a:rPr lang="en-US" altLang="ko-KR" sz="24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ko-KR" altLang="en-US" sz="2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1" name="Picture 2" descr="C:\Documents and Settings\Thanh\My Documents\Dropbox\Dissertation\rad27 C deletion\00002.bmp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283" t="53291" r="14948" b="23355"/>
            <a:stretch/>
          </p:blipFill>
          <p:spPr bwMode="auto">
            <a:xfrm>
              <a:off x="2698253" y="5193646"/>
              <a:ext cx="753612" cy="32737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2" name="Picture 3" descr="C:\Documents and Settings\Thanh\My Documents\Dropbox\Dissertation\rad27 C deletion\Western.bmp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8919"/>
            <a:stretch/>
          </p:blipFill>
          <p:spPr bwMode="auto">
            <a:xfrm>
              <a:off x="2698253" y="4961999"/>
              <a:ext cx="753410" cy="21544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3" name="TextBox 32"/>
            <p:cNvSpPr txBox="1"/>
            <p:nvPr/>
          </p:nvSpPr>
          <p:spPr>
            <a:xfrm rot="17696422">
              <a:off x="2484346" y="4496860"/>
              <a:ext cx="858706" cy="215436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altLang="ko-KR" sz="8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mpty vector</a:t>
              </a:r>
              <a:endParaRPr lang="en-US" altLang="ko-KR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760678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Group 48"/>
          <p:cNvGrpSpPr/>
          <p:nvPr/>
        </p:nvGrpSpPr>
        <p:grpSpPr>
          <a:xfrm>
            <a:off x="1670749" y="828953"/>
            <a:ext cx="5943600" cy="6553200"/>
            <a:chOff x="331225" y="828953"/>
            <a:chExt cx="5943600" cy="6553200"/>
          </a:xfrm>
        </p:grpSpPr>
        <p:graphicFrame>
          <p:nvGraphicFramePr>
            <p:cNvPr id="50" name="Chart 4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28754206"/>
                </p:ext>
              </p:extLst>
            </p:nvPr>
          </p:nvGraphicFramePr>
          <p:xfrm>
            <a:off x="1265662" y="3134318"/>
            <a:ext cx="4495799" cy="27257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1" name="TextBox 50"/>
            <p:cNvSpPr txBox="1"/>
            <p:nvPr/>
          </p:nvSpPr>
          <p:spPr>
            <a:xfrm>
              <a:off x="3704062" y="4208736"/>
              <a:ext cx="2239538" cy="246213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lvl="0"/>
              <a:r>
                <a:rPr lang="en-US" sz="1000" spc="-5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00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26</a:t>
              </a:r>
              <a:r>
                <a:rPr lang="en-US" sz="1000" spc="-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–</a:t>
              </a:r>
              <a:r>
                <a:rPr lang="en-US" sz="1000" spc="-5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ms4</a:t>
              </a:r>
              <a:r>
                <a:rPr lang="el-GR" sz="100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N </a:t>
              </a:r>
              <a:r>
                <a:rPr lang="en-US" sz="1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Slx1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–</a:t>
              </a:r>
              <a:r>
                <a:rPr lang="en-US" sz="1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lx4</a:t>
              </a:r>
              <a:endParaRPr lang="en-US" sz="1000" spc="-50" baseline="-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3902924" y="4809043"/>
              <a:ext cx="1447800" cy="246213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us81–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ms4</a:t>
              </a:r>
              <a:r>
                <a:rPr lang="el-GR" sz="1000" spc="-50" baseline="-5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spc="-50" baseline="-5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3902924" y="5000469"/>
              <a:ext cx="1608667" cy="246213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lvl="0"/>
              <a:r>
                <a:rPr lang="en-US" sz="1000" spc="-5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00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26</a:t>
              </a:r>
              <a:r>
                <a:rPr lang="en-US" sz="1000" spc="-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–</a:t>
              </a:r>
              <a:r>
                <a:rPr lang="en-US" sz="1000" spc="-5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ms4</a:t>
              </a:r>
              <a:r>
                <a:rPr lang="el-GR" sz="100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spc="-5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N</a:t>
              </a:r>
              <a:endParaRPr lang="en-US" sz="1000" spc="-50" baseline="-5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141"/>
            <p:cNvSpPr txBox="1"/>
            <p:nvPr/>
          </p:nvSpPr>
          <p:spPr>
            <a:xfrm>
              <a:off x="3704062" y="3998240"/>
              <a:ext cx="1960679" cy="246213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us81–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ms4</a:t>
              </a:r>
              <a:r>
                <a:rPr lang="el-GR" sz="100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N </a:t>
              </a:r>
              <a:r>
                <a:rPr lang="en-US" sz="1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Slx1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–</a:t>
              </a:r>
              <a:r>
                <a:rPr lang="en-US" sz="1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lx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5" name="Straight Arrow Connector 54"/>
            <p:cNvCxnSpPr/>
            <p:nvPr/>
          </p:nvCxnSpPr>
          <p:spPr>
            <a:xfrm flipH="1">
              <a:off x="3734942" y="4946751"/>
              <a:ext cx="228600" cy="26709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/>
              <a:tailEnd type="stealth" w="med" len="lg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/>
            <p:cNvSpPr txBox="1"/>
            <p:nvPr/>
          </p:nvSpPr>
          <p:spPr>
            <a:xfrm>
              <a:off x="331225" y="6181824"/>
              <a:ext cx="5943600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S7. Slx1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–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lx4 stimulates endonuclease activity of the Mus81</a:t>
              </a:r>
              <a:r>
                <a:rPr lang="el-GR" sz="1200" b="1" baseline="-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b="1" baseline="-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-26 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mplex as efficiently as 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wild-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ype Mus81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.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A) A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ime-course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xperiment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was performed with Mus81–Mms4</a:t>
              </a:r>
              <a:r>
                <a:rPr lang="el-GR" sz="12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N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and Mus81</a:t>
              </a:r>
              <a:r>
                <a:rPr lang="en-US" sz="12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21-26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–Mms4</a:t>
              </a:r>
              <a:r>
                <a:rPr lang="en-US" sz="12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40N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5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fmol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each) in the presence or absence of Slx1–Slx4 (25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fmol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.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iquots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of the reaction mixtures were withdrawn at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, 30 and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0 min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f time point.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(B) The amounts of cleavage products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btained in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) were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lotted against 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he incubation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ime. 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768738" y="3114953"/>
              <a:ext cx="407470" cy="461657"/>
            </a:xfrm>
            <a:prstGeom prst="rect">
              <a:avLst/>
            </a:prstGeom>
            <a:noFill/>
          </p:spPr>
          <p:txBody>
            <a:bodyPr wrap="none" lIns="91433" tIns="45716" rIns="91433" bIns="45716" rtlCol="0">
              <a:spAutoFit/>
            </a:bodyPr>
            <a:lstStyle/>
            <a:p>
              <a:r>
                <a:rPr lang="en-US" altLang="ko-KR" sz="24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2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732865" y="828953"/>
              <a:ext cx="407470" cy="461657"/>
            </a:xfrm>
            <a:prstGeom prst="rect">
              <a:avLst/>
            </a:prstGeom>
            <a:noFill/>
          </p:spPr>
          <p:txBody>
            <a:bodyPr wrap="none" lIns="91433" tIns="45716" rIns="91433" bIns="45716" rtlCol="0">
              <a:spAutoFit/>
            </a:bodyPr>
            <a:lstStyle/>
            <a:p>
              <a:r>
                <a:rPr lang="en-US" altLang="ko-KR" sz="24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2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9" name="Picture 2" descr="E:\20141231\D21-26 stimulated by Slx1-Slx4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94951" y="1873527"/>
              <a:ext cx="3112107" cy="67961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60" name="Group 59"/>
            <p:cNvGrpSpPr/>
            <p:nvPr/>
          </p:nvGrpSpPr>
          <p:grpSpPr>
            <a:xfrm>
              <a:off x="1693986" y="1925355"/>
              <a:ext cx="381587" cy="282602"/>
              <a:chOff x="601663" y="5181600"/>
              <a:chExt cx="509634" cy="363878"/>
            </a:xfrm>
          </p:grpSpPr>
          <p:grpSp>
            <p:nvGrpSpPr>
              <p:cNvPr id="133" name="Group 132"/>
              <p:cNvGrpSpPr/>
              <p:nvPr/>
            </p:nvGrpSpPr>
            <p:grpSpPr>
              <a:xfrm>
                <a:off x="734653" y="5257800"/>
                <a:ext cx="376644" cy="247355"/>
                <a:chOff x="115431" y="5413366"/>
                <a:chExt cx="765498" cy="606434"/>
              </a:xfrm>
            </p:grpSpPr>
            <p:cxnSp>
              <p:nvCxnSpPr>
                <p:cNvPr id="136" name="Straight Connector 135"/>
                <p:cNvCxnSpPr/>
                <p:nvPr/>
              </p:nvCxnSpPr>
              <p:spPr>
                <a:xfrm>
                  <a:off x="119448" y="5643282"/>
                  <a:ext cx="431415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7" name="Straight Connector 136"/>
                <p:cNvCxnSpPr/>
                <p:nvPr/>
              </p:nvCxnSpPr>
              <p:spPr>
                <a:xfrm>
                  <a:off x="115431" y="5795682"/>
                  <a:ext cx="431415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8" name="Straight Connector 137"/>
                <p:cNvCxnSpPr/>
                <p:nvPr/>
              </p:nvCxnSpPr>
              <p:spPr>
                <a:xfrm>
                  <a:off x="540788" y="5791200"/>
                  <a:ext cx="296203" cy="22860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9" name="Straight Connector 138"/>
                <p:cNvCxnSpPr/>
                <p:nvPr/>
              </p:nvCxnSpPr>
              <p:spPr>
                <a:xfrm flipV="1">
                  <a:off x="541401" y="5413366"/>
                  <a:ext cx="339528" cy="22860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0" name="Straight Connector 139"/>
                <p:cNvCxnSpPr/>
                <p:nvPr/>
              </p:nvCxnSpPr>
              <p:spPr>
                <a:xfrm>
                  <a:off x="636450" y="5742946"/>
                  <a:ext cx="244479" cy="186152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34" name="Straight Arrow Connector 133"/>
              <p:cNvCxnSpPr/>
              <p:nvPr/>
            </p:nvCxnSpPr>
            <p:spPr>
              <a:xfrm>
                <a:off x="917331" y="5181600"/>
                <a:ext cx="0" cy="15771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5" name="TextBox 134"/>
              <p:cNvSpPr txBox="1"/>
              <p:nvPr/>
            </p:nvSpPr>
            <p:spPr>
              <a:xfrm>
                <a:off x="601663" y="5228444"/>
                <a:ext cx="127028" cy="317034"/>
              </a:xfrm>
              <a:prstGeom prst="rect">
                <a:avLst/>
              </a:prstGeom>
              <a:noFill/>
              <a:ln w="19050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61" name="Group 60"/>
            <p:cNvGrpSpPr/>
            <p:nvPr/>
          </p:nvGrpSpPr>
          <p:grpSpPr>
            <a:xfrm>
              <a:off x="1693989" y="2290952"/>
              <a:ext cx="384443" cy="246221"/>
              <a:chOff x="548897" y="5755692"/>
              <a:chExt cx="566214" cy="317033"/>
            </a:xfrm>
          </p:grpSpPr>
          <p:cxnSp>
            <p:nvCxnSpPr>
              <p:cNvPr id="129" name="Straight Connector 128"/>
              <p:cNvCxnSpPr/>
              <p:nvPr/>
            </p:nvCxnSpPr>
            <p:spPr>
              <a:xfrm>
                <a:off x="685800" y="5943600"/>
                <a:ext cx="42931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Straight Connector 129"/>
              <p:cNvCxnSpPr/>
              <p:nvPr/>
            </p:nvCxnSpPr>
            <p:spPr>
              <a:xfrm>
                <a:off x="688188" y="5867400"/>
                <a:ext cx="18248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Straight Connector 130"/>
              <p:cNvCxnSpPr/>
              <p:nvPr/>
            </p:nvCxnSpPr>
            <p:spPr>
              <a:xfrm>
                <a:off x="928812" y="5867400"/>
                <a:ext cx="18248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2" name="TextBox 131"/>
              <p:cNvSpPr txBox="1"/>
              <p:nvPr/>
            </p:nvSpPr>
            <p:spPr>
              <a:xfrm>
                <a:off x="548897" y="5755692"/>
                <a:ext cx="127030" cy="317033"/>
              </a:xfrm>
              <a:prstGeom prst="rect">
                <a:avLst/>
              </a:prstGeom>
              <a:noFill/>
              <a:ln w="19050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sp>
          <p:nvSpPr>
            <p:cNvPr id="62" name="TextBox 61"/>
            <p:cNvSpPr txBox="1"/>
            <p:nvPr/>
          </p:nvSpPr>
          <p:spPr>
            <a:xfrm>
              <a:off x="1367188" y="1958143"/>
              <a:ext cx="410292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’F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1306239" y="2566282"/>
              <a:ext cx="874426" cy="261602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Lane</a:t>
              </a: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2485465" y="1039940"/>
              <a:ext cx="1297767" cy="246213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n-US" sz="1000" spc="-60" dirty="0">
                  <a:latin typeface="Arial" panose="020B0604020202020204" pitchFamily="34" charset="0"/>
                  <a:cs typeface="Arial" panose="020B0604020202020204" pitchFamily="34" charset="0"/>
                </a:rPr>
                <a:t>–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ms4</a:t>
              </a:r>
              <a:r>
                <a:rPr lang="el-GR" sz="100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N</a:t>
              </a:r>
              <a:endParaRPr lang="en-US" sz="1000" baseline="-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3696469" y="1039940"/>
              <a:ext cx="1680952" cy="246213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 fontAlgn="b">
                <a:defRPr/>
              </a:pPr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81</a:t>
              </a:r>
              <a:r>
                <a:rPr lang="el-GR" sz="100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baseline="-5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1-26</a:t>
              </a:r>
              <a:r>
                <a:rPr lang="en-US" sz="1000" spc="-6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–</a:t>
              </a:r>
              <a:r>
                <a:rPr lang="en-US" sz="1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ms4</a:t>
              </a:r>
              <a:r>
                <a:rPr lang="el-GR" sz="1000" baseline="-5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000" baseline="-5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N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681443" y="1587252"/>
              <a:ext cx="1499221" cy="276991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lx1</a:t>
              </a:r>
              <a:r>
                <a:rPr lang="en-US" sz="1200" spc="-60" dirty="0">
                  <a:latin typeface="Arial" panose="020B0604020202020204" pitchFamily="34" charset="0"/>
                  <a:cs typeface="Arial" panose="020B0604020202020204" pitchFamily="34" charset="0"/>
                </a:rPr>
                <a:t>–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lx4 (25 </a:t>
              </a:r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fmol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1117525" y="1365562"/>
              <a:ext cx="1063139" cy="276991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(min)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2104465" y="2576855"/>
              <a:ext cx="186934" cy="253908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2276132" y="2576855"/>
              <a:ext cx="186934" cy="253908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2447799" y="2576855"/>
              <a:ext cx="186934" cy="253908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2619466" y="2576855"/>
              <a:ext cx="186934" cy="253908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2791133" y="2576855"/>
              <a:ext cx="186934" cy="253908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2962800" y="2576855"/>
              <a:ext cx="186934" cy="253908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3134467" y="2576855"/>
              <a:ext cx="186934" cy="253908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3306134" y="2576855"/>
              <a:ext cx="186934" cy="253908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3477801" y="2576855"/>
              <a:ext cx="186934" cy="253908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3538388" y="2576855"/>
              <a:ext cx="377114" cy="253908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3723753" y="2576855"/>
              <a:ext cx="347123" cy="253908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3879127" y="2576855"/>
              <a:ext cx="360533" cy="253908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4047911" y="2576855"/>
              <a:ext cx="391450" cy="253908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4247612" y="2576855"/>
              <a:ext cx="352166" cy="253908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4408029" y="2576855"/>
              <a:ext cx="347123" cy="253908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4563403" y="2576855"/>
              <a:ext cx="360533" cy="253908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4732187" y="2576855"/>
              <a:ext cx="391450" cy="253908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4931885" y="2576855"/>
              <a:ext cx="352166" cy="253908"/>
            </a:xfrm>
            <a:prstGeom prst="rect">
              <a:avLst/>
            </a:prstGeom>
            <a:noFill/>
          </p:spPr>
          <p:txBody>
            <a:bodyPr wrap="square" lIns="91433" tIns="45716" rIns="91433" bIns="45716" rtlCol="0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cxnSp>
          <p:nvCxnSpPr>
            <p:cNvPr id="86" name="Straight Connector 85"/>
            <p:cNvCxnSpPr/>
            <p:nvPr/>
          </p:nvCxnSpPr>
          <p:spPr>
            <a:xfrm>
              <a:off x="2184661" y="1739638"/>
              <a:ext cx="71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7" name="Group 86"/>
            <p:cNvGrpSpPr/>
            <p:nvPr/>
          </p:nvGrpSpPr>
          <p:grpSpPr>
            <a:xfrm>
              <a:off x="2354317" y="1702471"/>
              <a:ext cx="71667" cy="74337"/>
              <a:chOff x="3158560" y="1855022"/>
              <a:chExt cx="95716" cy="95716"/>
            </a:xfrm>
          </p:grpSpPr>
          <p:cxnSp>
            <p:nvCxnSpPr>
              <p:cNvPr id="127" name="Straight Connector 126"/>
              <p:cNvCxnSpPr/>
              <p:nvPr/>
            </p:nvCxnSpPr>
            <p:spPr>
              <a:xfrm>
                <a:off x="3158560" y="1902880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Straight Connector 127"/>
              <p:cNvCxnSpPr/>
              <p:nvPr/>
            </p:nvCxnSpPr>
            <p:spPr>
              <a:xfrm rot="16200000">
                <a:off x="3158560" y="1902880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88" name="Straight Connector 87"/>
            <p:cNvCxnSpPr/>
            <p:nvPr/>
          </p:nvCxnSpPr>
          <p:spPr>
            <a:xfrm>
              <a:off x="2523973" y="1739638"/>
              <a:ext cx="71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Connector 88"/>
            <p:cNvCxnSpPr/>
            <p:nvPr/>
          </p:nvCxnSpPr>
          <p:spPr>
            <a:xfrm>
              <a:off x="2693629" y="1739638"/>
              <a:ext cx="71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Connector 89"/>
            <p:cNvCxnSpPr/>
            <p:nvPr/>
          </p:nvCxnSpPr>
          <p:spPr>
            <a:xfrm>
              <a:off x="2863285" y="1739638"/>
              <a:ext cx="71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/>
            <p:cNvCxnSpPr/>
            <p:nvPr/>
          </p:nvCxnSpPr>
          <p:spPr>
            <a:xfrm>
              <a:off x="3032941" y="1739638"/>
              <a:ext cx="71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2" name="Group 91"/>
            <p:cNvGrpSpPr/>
            <p:nvPr/>
          </p:nvGrpSpPr>
          <p:grpSpPr>
            <a:xfrm>
              <a:off x="3202597" y="1702471"/>
              <a:ext cx="71667" cy="74337"/>
              <a:chOff x="5191527" y="1855022"/>
              <a:chExt cx="95716" cy="95716"/>
            </a:xfrm>
          </p:grpSpPr>
          <p:cxnSp>
            <p:nvCxnSpPr>
              <p:cNvPr id="125" name="Straight Connector 124"/>
              <p:cNvCxnSpPr/>
              <p:nvPr/>
            </p:nvCxnSpPr>
            <p:spPr>
              <a:xfrm>
                <a:off x="5191527" y="1902880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Straight Connector 125"/>
              <p:cNvCxnSpPr/>
              <p:nvPr/>
            </p:nvCxnSpPr>
            <p:spPr>
              <a:xfrm rot="16200000">
                <a:off x="5191527" y="1902880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3" name="Group 92"/>
            <p:cNvGrpSpPr/>
            <p:nvPr/>
          </p:nvGrpSpPr>
          <p:grpSpPr>
            <a:xfrm>
              <a:off x="3372253" y="1702471"/>
              <a:ext cx="71667" cy="74337"/>
              <a:chOff x="5419427" y="1855022"/>
              <a:chExt cx="95716" cy="95716"/>
            </a:xfrm>
          </p:grpSpPr>
          <p:cxnSp>
            <p:nvCxnSpPr>
              <p:cNvPr id="123" name="Straight Connector 122"/>
              <p:cNvCxnSpPr/>
              <p:nvPr/>
            </p:nvCxnSpPr>
            <p:spPr>
              <a:xfrm>
                <a:off x="5419427" y="1902880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Straight Connector 123"/>
              <p:cNvCxnSpPr/>
              <p:nvPr/>
            </p:nvCxnSpPr>
            <p:spPr>
              <a:xfrm rot="16200000">
                <a:off x="5419427" y="1902880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4" name="Group 93"/>
            <p:cNvGrpSpPr/>
            <p:nvPr/>
          </p:nvGrpSpPr>
          <p:grpSpPr>
            <a:xfrm>
              <a:off x="3541909" y="1702471"/>
              <a:ext cx="71667" cy="74337"/>
              <a:chOff x="5647327" y="1855022"/>
              <a:chExt cx="95716" cy="95716"/>
            </a:xfrm>
          </p:grpSpPr>
          <p:cxnSp>
            <p:nvCxnSpPr>
              <p:cNvPr id="121" name="Straight Connector 120"/>
              <p:cNvCxnSpPr/>
              <p:nvPr/>
            </p:nvCxnSpPr>
            <p:spPr>
              <a:xfrm>
                <a:off x="5647327" y="1902880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Straight Connector 121"/>
              <p:cNvCxnSpPr/>
              <p:nvPr/>
            </p:nvCxnSpPr>
            <p:spPr>
              <a:xfrm rot="16200000">
                <a:off x="5647327" y="1902880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5" name="Group 94"/>
            <p:cNvGrpSpPr/>
            <p:nvPr/>
          </p:nvGrpSpPr>
          <p:grpSpPr>
            <a:xfrm>
              <a:off x="3711565" y="1702471"/>
              <a:ext cx="71667" cy="74337"/>
              <a:chOff x="5881650" y="1855022"/>
              <a:chExt cx="95716" cy="95716"/>
            </a:xfrm>
          </p:grpSpPr>
          <p:cxnSp>
            <p:nvCxnSpPr>
              <p:cNvPr id="119" name="Straight Connector 118"/>
              <p:cNvCxnSpPr/>
              <p:nvPr/>
            </p:nvCxnSpPr>
            <p:spPr>
              <a:xfrm>
                <a:off x="5881650" y="1902880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Straight Connector 119"/>
              <p:cNvCxnSpPr/>
              <p:nvPr/>
            </p:nvCxnSpPr>
            <p:spPr>
              <a:xfrm rot="16200000">
                <a:off x="5881650" y="1902880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6" name="Group 95"/>
            <p:cNvGrpSpPr/>
            <p:nvPr/>
          </p:nvGrpSpPr>
          <p:grpSpPr>
            <a:xfrm>
              <a:off x="4559845" y="1702471"/>
              <a:ext cx="71667" cy="74337"/>
              <a:chOff x="7951044" y="1855022"/>
              <a:chExt cx="95716" cy="95716"/>
            </a:xfrm>
          </p:grpSpPr>
          <p:cxnSp>
            <p:nvCxnSpPr>
              <p:cNvPr id="117" name="Straight Connector 116"/>
              <p:cNvCxnSpPr/>
              <p:nvPr/>
            </p:nvCxnSpPr>
            <p:spPr>
              <a:xfrm>
                <a:off x="7951044" y="1902880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Straight Connector 117"/>
              <p:cNvCxnSpPr/>
              <p:nvPr/>
            </p:nvCxnSpPr>
            <p:spPr>
              <a:xfrm rot="16200000">
                <a:off x="7951044" y="1902880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7" name="Group 96"/>
            <p:cNvGrpSpPr/>
            <p:nvPr/>
          </p:nvGrpSpPr>
          <p:grpSpPr>
            <a:xfrm>
              <a:off x="5068819" y="1702471"/>
              <a:ext cx="71667" cy="74337"/>
              <a:chOff x="8588829" y="1855022"/>
              <a:chExt cx="95716" cy="95716"/>
            </a:xfrm>
          </p:grpSpPr>
          <p:cxnSp>
            <p:nvCxnSpPr>
              <p:cNvPr id="115" name="Straight Connector 114"/>
              <p:cNvCxnSpPr/>
              <p:nvPr/>
            </p:nvCxnSpPr>
            <p:spPr>
              <a:xfrm>
                <a:off x="8588829" y="1902880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Straight Connector 115"/>
              <p:cNvCxnSpPr/>
              <p:nvPr/>
            </p:nvCxnSpPr>
            <p:spPr>
              <a:xfrm rot="16200000">
                <a:off x="8588829" y="1902880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8" name="Group 97"/>
            <p:cNvGrpSpPr/>
            <p:nvPr/>
          </p:nvGrpSpPr>
          <p:grpSpPr>
            <a:xfrm>
              <a:off x="4729501" y="1702471"/>
              <a:ext cx="71667" cy="74337"/>
              <a:chOff x="8143634" y="1855022"/>
              <a:chExt cx="95716" cy="95716"/>
            </a:xfrm>
          </p:grpSpPr>
          <p:cxnSp>
            <p:nvCxnSpPr>
              <p:cNvPr id="113" name="Straight Connector 112"/>
              <p:cNvCxnSpPr/>
              <p:nvPr/>
            </p:nvCxnSpPr>
            <p:spPr>
              <a:xfrm>
                <a:off x="8143634" y="1902880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Straight Connector 113"/>
              <p:cNvCxnSpPr/>
              <p:nvPr/>
            </p:nvCxnSpPr>
            <p:spPr>
              <a:xfrm rot="16200000">
                <a:off x="8143634" y="1902880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9" name="Group 98"/>
            <p:cNvGrpSpPr/>
            <p:nvPr/>
          </p:nvGrpSpPr>
          <p:grpSpPr>
            <a:xfrm>
              <a:off x="4899157" y="1702471"/>
              <a:ext cx="71667" cy="74337"/>
              <a:chOff x="8378596" y="1855022"/>
              <a:chExt cx="95716" cy="95716"/>
            </a:xfrm>
          </p:grpSpPr>
          <p:cxnSp>
            <p:nvCxnSpPr>
              <p:cNvPr id="111" name="Straight Connector 110"/>
              <p:cNvCxnSpPr/>
              <p:nvPr/>
            </p:nvCxnSpPr>
            <p:spPr>
              <a:xfrm>
                <a:off x="8378596" y="1902880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Straight Connector 111"/>
              <p:cNvCxnSpPr/>
              <p:nvPr/>
            </p:nvCxnSpPr>
            <p:spPr>
              <a:xfrm rot="16200000">
                <a:off x="8378596" y="1902880"/>
                <a:ext cx="9571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0" name="Straight Connector 99"/>
            <p:cNvCxnSpPr/>
            <p:nvPr/>
          </p:nvCxnSpPr>
          <p:spPr>
            <a:xfrm>
              <a:off x="3881221" y="1739638"/>
              <a:ext cx="71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Connector 100"/>
            <p:cNvCxnSpPr/>
            <p:nvPr/>
          </p:nvCxnSpPr>
          <p:spPr>
            <a:xfrm>
              <a:off x="4050877" y="1739638"/>
              <a:ext cx="71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/>
            <p:cNvCxnSpPr/>
            <p:nvPr/>
          </p:nvCxnSpPr>
          <p:spPr>
            <a:xfrm>
              <a:off x="4220533" y="1739638"/>
              <a:ext cx="71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102"/>
            <p:cNvCxnSpPr/>
            <p:nvPr/>
          </p:nvCxnSpPr>
          <p:spPr>
            <a:xfrm>
              <a:off x="4390189" y="1739638"/>
              <a:ext cx="71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AutoShape 20"/>
            <p:cNvSpPr>
              <a:spLocks noChangeArrowheads="1"/>
            </p:cNvSpPr>
            <p:nvPr/>
          </p:nvSpPr>
          <p:spPr bwMode="auto">
            <a:xfrm flipH="1">
              <a:off x="2549009" y="1451366"/>
              <a:ext cx="567578" cy="102378"/>
            </a:xfrm>
            <a:prstGeom prst="rtTriangle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lIns="91433" tIns="45716" rIns="91433" bIns="45716" anchor="ctr"/>
            <a:lstStyle/>
            <a:p>
              <a:endParaRPr lang="en-US"/>
            </a:p>
          </p:txBody>
        </p:sp>
        <p:sp>
          <p:nvSpPr>
            <p:cNvPr id="105" name="AutoShape 20"/>
            <p:cNvSpPr>
              <a:spLocks noChangeArrowheads="1"/>
            </p:cNvSpPr>
            <p:nvPr/>
          </p:nvSpPr>
          <p:spPr bwMode="auto">
            <a:xfrm flipH="1">
              <a:off x="3225266" y="1451366"/>
              <a:ext cx="567578" cy="102378"/>
            </a:xfrm>
            <a:prstGeom prst="rtTriangle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lIns="91433" tIns="45716" rIns="91433" bIns="45716" anchor="ctr"/>
            <a:lstStyle/>
            <a:p>
              <a:endParaRPr lang="en-US"/>
            </a:p>
          </p:txBody>
        </p:sp>
        <p:sp>
          <p:nvSpPr>
            <p:cNvPr id="106" name="AutoShape 20"/>
            <p:cNvSpPr>
              <a:spLocks noChangeArrowheads="1"/>
            </p:cNvSpPr>
            <p:nvPr/>
          </p:nvSpPr>
          <p:spPr bwMode="auto">
            <a:xfrm flipH="1">
              <a:off x="3899087" y="1451366"/>
              <a:ext cx="567578" cy="102378"/>
            </a:xfrm>
            <a:prstGeom prst="rtTriangle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lIns="91433" tIns="45716" rIns="91433" bIns="45716" anchor="ctr"/>
            <a:lstStyle/>
            <a:p>
              <a:endParaRPr lang="en-US"/>
            </a:p>
          </p:txBody>
        </p:sp>
        <p:sp>
          <p:nvSpPr>
            <p:cNvPr id="107" name="AutoShape 20"/>
            <p:cNvSpPr>
              <a:spLocks noChangeArrowheads="1"/>
            </p:cNvSpPr>
            <p:nvPr/>
          </p:nvSpPr>
          <p:spPr bwMode="auto">
            <a:xfrm flipH="1">
              <a:off x="4592873" y="1451366"/>
              <a:ext cx="567578" cy="102378"/>
            </a:xfrm>
            <a:prstGeom prst="rtTriangle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lIns="91433" tIns="45716" rIns="91433" bIns="45716" anchor="ctr"/>
            <a:lstStyle/>
            <a:p>
              <a:endParaRPr lang="en-US"/>
            </a:p>
          </p:txBody>
        </p:sp>
        <p:sp>
          <p:nvSpPr>
            <p:cNvPr id="108" name="Left Bracket 107"/>
            <p:cNvSpPr/>
            <p:nvPr/>
          </p:nvSpPr>
          <p:spPr>
            <a:xfrm rot="5400000" flipV="1">
              <a:off x="3132033" y="659062"/>
              <a:ext cx="35507" cy="1319108"/>
            </a:xfrm>
            <a:prstGeom prst="leftBracket">
              <a:avLst/>
            </a:prstGeom>
            <a:ln w="15875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lIns="91433" tIns="45716" rIns="91433" bIns="45716" rtlCol="0" anchor="ctr"/>
            <a:lstStyle/>
            <a:p>
              <a:pPr algn="ctr"/>
              <a:endParaRPr lang="en-US"/>
            </a:p>
          </p:txBody>
        </p:sp>
        <p:sp>
          <p:nvSpPr>
            <p:cNvPr id="109" name="Left Bracket 108"/>
            <p:cNvSpPr/>
            <p:nvPr/>
          </p:nvSpPr>
          <p:spPr>
            <a:xfrm rot="5400000" flipV="1">
              <a:off x="4512780" y="650484"/>
              <a:ext cx="35507" cy="1336263"/>
            </a:xfrm>
            <a:prstGeom prst="leftBracket">
              <a:avLst/>
            </a:prstGeom>
            <a:ln w="15875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lIns="91433" tIns="45716" rIns="91433" bIns="45716" rtlCol="0" anchor="ctr"/>
            <a:lstStyle/>
            <a:p>
              <a:pPr algn="ctr"/>
              <a:endParaRPr lang="en-US"/>
            </a:p>
          </p:txBody>
        </p:sp>
        <p:cxnSp>
          <p:nvCxnSpPr>
            <p:cNvPr id="110" name="Straight Arrow Connector 109"/>
            <p:cNvCxnSpPr/>
            <p:nvPr/>
          </p:nvCxnSpPr>
          <p:spPr>
            <a:xfrm flipH="1" flipV="1">
              <a:off x="3734942" y="5019953"/>
              <a:ext cx="228600" cy="76201"/>
            </a:xfrm>
            <a:prstGeom prst="straightConnector1">
              <a:avLst/>
            </a:prstGeom>
            <a:ln w="3175" cap="flat">
              <a:solidFill>
                <a:schemeClr val="tx1"/>
              </a:solidFill>
              <a:headEnd type="none"/>
              <a:tailEnd type="stealth" w="med" len="lg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7320713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190</Words>
  <Application>Microsoft Office PowerPoint</Application>
  <PresentationFormat>Custom</PresentationFormat>
  <Paragraphs>305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KAIS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anh</dc:creator>
  <cp:lastModifiedBy>Thanh</cp:lastModifiedBy>
  <cp:revision>4</cp:revision>
  <dcterms:created xsi:type="dcterms:W3CDTF">2015-01-21T01:35:28Z</dcterms:created>
  <dcterms:modified xsi:type="dcterms:W3CDTF">2015-01-21T01:44:30Z</dcterms:modified>
</cp:coreProperties>
</file>